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3" r:id="rId2"/>
  </p:sldIdLst>
  <p:sldSz cx="6492875" cy="841216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045">
          <p15:clr>
            <a:srgbClr val="A4A3A4"/>
          </p15:clr>
        </p15:guide>
        <p15:guide id="3" orient="horz" pos="68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2EBE5FB-309E-45D5-8034-D862F06526E4}" v="2" dt="2022-12-09T06:05:36.98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43" autoAdjust="0"/>
    <p:restoredTop sz="96081" autoAdjust="0"/>
  </p:normalViewPr>
  <p:slideViewPr>
    <p:cSldViewPr>
      <p:cViewPr varScale="1">
        <p:scale>
          <a:sx n="63" d="100"/>
          <a:sy n="63" d="100"/>
        </p:scale>
        <p:origin x="2506" y="77"/>
      </p:cViewPr>
      <p:guideLst>
        <p:guide pos="2045"/>
        <p:guide orient="horz" pos="68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o" userId="b11a5121-062d-4360-8951-d081ad96d999" providerId="ADAL" clId="{9F3DCE2B-CD69-4735-8D75-F97BD501C620}"/>
    <pc:docChg chg="undo redo custSel delSld modSld">
      <pc:chgData name="Go" userId="b11a5121-062d-4360-8951-d081ad96d999" providerId="ADAL" clId="{9F3DCE2B-CD69-4735-8D75-F97BD501C620}" dt="2022-10-06T03:01:28.049" v="365" actId="1035"/>
      <pc:docMkLst>
        <pc:docMk/>
      </pc:docMkLst>
      <pc:sldChg chg="addSp delSp modSp mod">
        <pc:chgData name="Go" userId="b11a5121-062d-4360-8951-d081ad96d999" providerId="ADAL" clId="{9F3DCE2B-CD69-4735-8D75-F97BD501C620}" dt="2022-10-06T01:59:05.555" v="40" actId="1035"/>
        <pc:sldMkLst>
          <pc:docMk/>
          <pc:sldMk cId="765565405" sldId="295"/>
        </pc:sldMkLst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5" creationId="{A13A7755-482B-DB79-B7FA-774EDD0CF951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6" creationId="{D51863D8-455B-EC0F-71CB-5FDB543079E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7" creationId="{9AD3C06D-AD2A-06FC-BE68-B49D85C3C270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8" creationId="{0451ED29-33C0-93F8-7A36-FA45EAFD881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0" creationId="{13C8E1A1-5815-DA4D-8E86-1F21026E355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3" creationId="{8BBE0DCD-5716-2704-9454-472A9944543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5" creationId="{3958EEFB-0F3C-661B-D83D-665E60B1FFC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6" creationId="{DFED24C3-182C-8E23-946D-496948D6DAC0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7" creationId="{CA3E831C-A33B-43D2-4F89-C1F7CD8DD0F3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8" creationId="{C1D5D536-8CBB-3EDB-A7A2-5D4B65174D4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9" creationId="{7BEEB265-4B51-6C6C-35D4-DDC52F490EC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81" creationId="{3AF757E8-4AE4-91BF-3E89-1C195E53A14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14" creationId="{EF596959-60D3-4521-DE7A-48D803BF3B4D}"/>
          </ac:spMkLst>
        </pc:spChg>
        <pc:spChg chg="mod">
          <ac:chgData name="Go" userId="b11a5121-062d-4360-8951-d081ad96d999" providerId="ADAL" clId="{9F3DCE2B-CD69-4735-8D75-F97BD501C620}" dt="2022-10-06T01:59:00.819" v="39" actId="1035"/>
          <ac:spMkLst>
            <pc:docMk/>
            <pc:sldMk cId="765565405" sldId="295"/>
            <ac:spMk id="216" creationId="{D657EAB7-2F22-372F-9161-BC037AAB4596}"/>
          </ac:spMkLst>
        </pc:spChg>
        <pc:spChg chg="mod">
          <ac:chgData name="Go" userId="b11a5121-062d-4360-8951-d081ad96d999" providerId="ADAL" clId="{9F3DCE2B-CD69-4735-8D75-F97BD501C620}" dt="2022-10-06T01:58:57.487" v="36" actId="1035"/>
          <ac:spMkLst>
            <pc:docMk/>
            <pc:sldMk cId="765565405" sldId="295"/>
            <ac:spMk id="218" creationId="{DEF0CF26-0463-2340-281E-4E244F51EE6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24" creationId="{496BC65B-71E2-B748-5735-2F5B94283B9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27" creationId="{08B8E35D-A3C5-891E-C395-16525445E0F6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29" creationId="{C0E28091-6E1D-3F5D-B88E-B2A6DD29E0F4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31" creationId="{04F20118-ABCF-DE51-B90D-76C4364A5290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49" creationId="{2882A209-37C6-C544-F7FA-06B6F9367A5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0" creationId="{ACD10E03-4C8C-F276-636D-6243D531551C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1" creationId="{1017BC00-01DE-61D9-21A2-3D40BC47FF34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2" creationId="{3B01E9EB-DEFC-7FE9-A5F0-ADD2FCEAECB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3" creationId="{A1BD4D14-C8EF-62A2-EB85-FE16D10AF276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4" creationId="{C609FA06-A566-4E80-A9F9-8EEDAD7EA1EE}"/>
          </ac:spMkLst>
        </pc:s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5" creationId="{AD8DB468-048F-B9FC-6CFF-C0488CA069F1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8" creationId="{1AB48F4C-6B99-087F-F438-3FD82BD25946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9" creationId="{7A847D17-1ACF-D55D-13C8-86539824C271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31" creationId="{8176E087-5509-EB8F-312F-9CE869835A67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25" creationId="{EC15710E-7CE9-A2A5-77EF-8A1B923D8D58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58" creationId="{88CF5590-DD0D-0456-695B-C7F320C4D46D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68" creationId="{71E89F71-02F2-647A-FBAF-2276502E671F}"/>
          </ac:grpSpMkLst>
        </pc:grpChg>
        <pc:graphicFrameChg chg="add del mod">
          <ac:chgData name="Go" userId="b11a5121-062d-4360-8951-d081ad96d999" providerId="ADAL" clId="{9F3DCE2B-CD69-4735-8D75-F97BD501C620}" dt="2022-10-06T01:57:36.085" v="8"/>
          <ac:graphicFrameMkLst>
            <pc:docMk/>
            <pc:sldMk cId="765565405" sldId="295"/>
            <ac:graphicFrameMk id="2" creationId="{73622A94-0173-6612-EE8E-82144F55ED2C}"/>
          </ac:graphicFrameMkLst>
        </pc:graphicFrameChg>
        <pc:graphicFrameChg chg="mod">
          <ac:chgData name="Go" userId="b11a5121-062d-4360-8951-d081ad96d999" providerId="ADAL" clId="{9F3DCE2B-CD69-4735-8D75-F97BD501C620}" dt="2022-10-06T01:58:06.317" v="16"/>
          <ac:graphicFrameMkLst>
            <pc:docMk/>
            <pc:sldMk cId="765565405" sldId="295"/>
            <ac:graphicFrameMk id="257" creationId="{93C7C028-D7E1-E394-069E-29D1113A0275}"/>
          </ac:graphicFrameMkLst>
        </pc:graphicFrameChg>
        <pc:picChg chg="add mod modCrop">
          <ac:chgData name="Go" userId="b11a5121-062d-4360-8951-d081ad96d999" providerId="ADAL" clId="{9F3DCE2B-CD69-4735-8D75-F97BD501C620}" dt="2022-10-06T01:59:05.555" v="40" actId="1035"/>
          <ac:picMkLst>
            <pc:docMk/>
            <pc:sldMk cId="765565405" sldId="295"/>
            <ac:picMk id="10" creationId="{A3549F28-64D7-EB92-998C-4E26A68827E2}"/>
          </ac:picMkLst>
        </pc:picChg>
        <pc:picChg chg="del mod">
          <ac:chgData name="Go" userId="b11a5121-062d-4360-8951-d081ad96d999" providerId="ADAL" clId="{9F3DCE2B-CD69-4735-8D75-F97BD501C620}" dt="2022-10-06T01:58:42.303" v="25" actId="478"/>
          <ac:picMkLst>
            <pc:docMk/>
            <pc:sldMk cId="765565405" sldId="295"/>
            <ac:picMk id="262" creationId="{A92ABF3D-C883-625D-933E-47CC786B689E}"/>
          </ac:picMkLst>
        </pc:picChg>
        <pc:picChg chg="del mod">
          <ac:chgData name="Go" userId="b11a5121-062d-4360-8951-d081ad96d999" providerId="ADAL" clId="{9F3DCE2B-CD69-4735-8D75-F97BD501C620}" dt="2022-10-06T01:58:43.479" v="26" actId="478"/>
          <ac:picMkLst>
            <pc:docMk/>
            <pc:sldMk cId="765565405" sldId="295"/>
            <ac:picMk id="263" creationId="{EBAFD2EB-5626-2B49-9723-8A5BAC7693A1}"/>
          </ac:picMkLst>
        </pc:picChg>
        <pc:picChg chg="del mod">
          <ac:chgData name="Go" userId="b11a5121-062d-4360-8951-d081ad96d999" providerId="ADAL" clId="{9F3DCE2B-CD69-4735-8D75-F97BD501C620}" dt="2022-10-06T01:58:44.701" v="27" actId="478"/>
          <ac:picMkLst>
            <pc:docMk/>
            <pc:sldMk cId="765565405" sldId="295"/>
            <ac:picMk id="264" creationId="{8652B5E2-4623-CA66-805E-616B7FA3FF24}"/>
          </ac:picMkLst>
        </pc:picChg>
      </pc:sldChg>
      <pc:sldChg chg="del">
        <pc:chgData name="Go" userId="b11a5121-062d-4360-8951-d081ad96d999" providerId="ADAL" clId="{9F3DCE2B-CD69-4735-8D75-F97BD501C620}" dt="2022-10-06T01:27:14.763" v="0" actId="47"/>
        <pc:sldMkLst>
          <pc:docMk/>
          <pc:sldMk cId="2177906614" sldId="300"/>
        </pc:sldMkLst>
      </pc:sldChg>
      <pc:sldChg chg="addSp delSp modSp mod">
        <pc:chgData name="Go" userId="b11a5121-062d-4360-8951-d081ad96d999" providerId="ADAL" clId="{9F3DCE2B-CD69-4735-8D75-F97BD501C620}" dt="2022-10-06T03:01:28.049" v="365" actId="1035"/>
        <pc:sldMkLst>
          <pc:docMk/>
          <pc:sldMk cId="3299870256" sldId="301"/>
        </pc:sldMkLst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12" creationId="{A7DA65A8-9C18-44D5-8A91-8C50381BEF9D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16" creationId="{2D415CC3-EC50-47BD-9C07-95599E264991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36" creationId="{0ABDE28E-4F18-7EA1-324E-0C46208B542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4" creationId="{089D6C4B-E85D-1CD3-914B-2088CDFD16BB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61" creationId="{5141CB8A-7B8E-6254-DBB4-D32013666423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63" creationId="{C2DEC8A3-11BC-D720-0DA0-92E3857A969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4" creationId="{9F007954-0AAD-3205-735A-B9A54442C770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5" creationId="{515CE48F-1CC6-72F9-4350-E9508E72096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6" creationId="{7448F8AD-C4F0-4AA1-98CB-C813BC9B24D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7" creationId="{B3A138A0-A275-7353-FE03-EC2EFA9DC93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8" creationId="{2CDF2CD0-379D-D6FC-2C99-2932958E9A5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76" creationId="{74E5028F-A99A-AA28-7FDC-A26AA484CD2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4" creationId="{837F1CCF-F169-1CFB-7F9B-402401FD2EE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5" creationId="{ECDDBD90-6215-8E50-4FF9-A25F1931545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6" creationId="{E2524BC4-E63F-BA5E-F6B8-AA15C24401AC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7" creationId="{449EA4CF-2036-F01A-EDEE-4CF90C93DED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8" creationId="{BA00C4AC-2A75-732C-667D-BC15171D6C0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9" creationId="{FFF62C9B-5DEA-D3C7-C3CE-99A61B19D567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94" creationId="{F56C1CE8-089D-C261-8DF8-C11DFF669F6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95" creationId="{3248A607-9A53-1219-2078-5B2467583ED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98" creationId="{E58C1058-FD72-2F7B-528C-68026EC1AEB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06" creationId="{C61B6210-8D97-7703-4BFD-05CF3757588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07" creationId="{A8BCDEF0-1932-D050-7EA4-6D4982CCD0B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1" creationId="{6238CB2F-65B3-6DAB-3A9F-573FDC5657A4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2" creationId="{E9C1FCEA-6490-E01F-C27D-DC03ED1AF9B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3" creationId="{3A35C103-3B66-069D-BFFA-FEF04477F7F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4" creationId="{81ABC751-DDFA-1FD8-FFF3-CA82D5193F6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6" creationId="{44B7E7F0-E894-2277-9541-01E126F3AC6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7" creationId="{E2AC9109-AE40-1616-97A4-F9388B59D5D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8" creationId="{8BCFE8D6-B1DA-1CE4-64E1-56169C4D7EB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0" creationId="{EDB01C96-6BB2-78ED-E253-EE7A72186D0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2" creationId="{56C5CEE4-9BE2-803A-12E1-E95FE066836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4" creationId="{D0F35713-6707-76B8-B2CA-E131E5AEEC5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6" creationId="{2D35C4E2-2DB7-0322-089D-ADFA59447EA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7" creationId="{8A76B3BE-6305-3092-D6E1-5320853AEDB0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171" creationId="{5103E0C0-A43F-D0E9-26C3-CFD997322F2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215" creationId="{131802D4-FD62-DC83-FE86-405BECC0C5AA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218" creationId="{F3298815-9305-CB10-9853-8B2AF8F8156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234" creationId="{C151D2B4-1E4C-80C5-7FBD-15CFB819C12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236" creationId="{B309F41F-5305-547C-2F54-2F496AA42D6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237" creationId="{89D1BCF2-D4AC-8C3F-17A1-9C25E61AACD4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295" creationId="{7E9BA595-48EE-AD01-7067-1703D560FBA6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03" creationId="{56F6A622-9BDD-3332-828E-C876E4560FE0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09" creationId="{59BF9AEA-DF00-F9B3-5F98-B7501CB22315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0" creationId="{1EF5F240-AEF8-72E9-3C23-CEA138F85505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1" creationId="{B8EF6791-1158-4708-9A41-CD908898F733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2" creationId="{C9089F88-A7E2-5192-3F75-580721F351E0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3" creationId="{94B3687A-97A1-8162-DA02-5A08EB9BA277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4" creationId="{5DAC7207-6117-B06A-89BC-088ABA7B6A05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5" creationId="{5D88F820-8544-2545-70B6-0BDC1A5C5C1E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6" creationId="{AF751193-0DF9-5599-55EE-F3E02CCEAA68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7" creationId="{AF1BA0F4-20EC-226C-B2A1-722E87497F17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1" creationId="{B48E4DE0-D0C2-B224-D68D-CB7F847EFBE1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2" creationId="{0CF15B6C-3EB2-F776-FBC5-FC00A990B539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4" creationId="{460DEB48-76D4-95E0-407D-DDA21DDCBA5F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5" creationId="{3779F03F-3B36-8DA2-E323-D4E5CF787794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48" creationId="{2A461E41-4216-804B-0458-33A2868184CA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4" creationId="{C806C188-7867-D5B4-150F-4F77934B8ECB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5" creationId="{22380C95-4B15-1A66-81BF-353DE139D1E1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6" creationId="{05DF12E6-6425-A279-8DF6-B401F100E7E4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7" creationId="{EB0679B9-FB9D-D1A9-8665-BD7FA0EB5622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65" creationId="{836643C2-CA20-7104-1C79-E65775AADB79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66" creationId="{5F7E0991-BECC-20EF-901D-EAB2B04864D8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68" creationId="{40317649-68F2-CA88-178D-C47C5142B84F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81" creationId="{5126D9D2-1907-A43F-5821-94A44A8E930C}"/>
          </ac:spMkLst>
        </pc:spChg>
        <pc:spChg chg="mod topLvl">
          <ac:chgData name="Go" userId="b11a5121-062d-4360-8951-d081ad96d999" providerId="ADAL" clId="{9F3DCE2B-CD69-4735-8D75-F97BD501C620}" dt="2022-10-06T02:41:12.703" v="356" actId="1076"/>
          <ac:spMkLst>
            <pc:docMk/>
            <pc:sldMk cId="3299870256" sldId="301"/>
            <ac:spMk id="383" creationId="{61A85EF3-E6C7-95D6-BA84-F36035F58FA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86" creationId="{A2558EC1-8F79-87E0-9F0A-99507D5576B2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04" creationId="{02ECC1BC-F39A-F87F-9CAA-AAC3D74418F5}"/>
          </ac:spMkLst>
        </pc:spChg>
        <pc:spChg chg="mod topLvl">
          <ac:chgData name="Go" userId="b11a5121-062d-4360-8951-d081ad96d999" providerId="ADAL" clId="{9F3DCE2B-CD69-4735-8D75-F97BD501C620}" dt="2022-10-06T02:40:53.751" v="349" actId="1076"/>
          <ac:spMkLst>
            <pc:docMk/>
            <pc:sldMk cId="3299870256" sldId="301"/>
            <ac:spMk id="405" creationId="{C923D1E9-D5B0-0DF4-CBD0-3D3506D36739}"/>
          </ac:spMkLst>
        </pc:spChg>
        <pc:spChg chg="mod topLvl">
          <ac:chgData name="Go" userId="b11a5121-062d-4360-8951-d081ad96d999" providerId="ADAL" clId="{9F3DCE2B-CD69-4735-8D75-F97BD501C620}" dt="2022-10-06T02:41:01.432" v="354" actId="1037"/>
          <ac:spMkLst>
            <pc:docMk/>
            <pc:sldMk cId="3299870256" sldId="301"/>
            <ac:spMk id="406" creationId="{0803A274-7185-EFF4-5AF0-E12E2D8EFEA3}"/>
          </ac:spMkLst>
        </pc:spChg>
        <pc:spChg chg="mod topLvl">
          <ac:chgData name="Go" userId="b11a5121-062d-4360-8951-d081ad96d999" providerId="ADAL" clId="{9F3DCE2B-CD69-4735-8D75-F97BD501C620}" dt="2022-10-06T02:41:07.288" v="355" actId="1076"/>
          <ac:spMkLst>
            <pc:docMk/>
            <pc:sldMk cId="3299870256" sldId="301"/>
            <ac:spMk id="408" creationId="{AB7599AF-4951-AA93-87B7-6A93798964A9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452" creationId="{2136A444-A366-651A-8DD2-6AF9265DE357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55" creationId="{4DA4660F-ABBE-E1BD-5B04-62B5A75AF21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56" creationId="{86E53E75-99F4-B1E6-B573-52DB085C453C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60" creationId="{5A29D108-29F5-7C8C-D1AF-996AF7E677CC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65" creationId="{ED225DD9-8CCA-9A76-EC30-5DA9B34FB8D4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66" creationId="{FE81A49E-D7DF-8994-E47D-A7017A9CFAE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68" creationId="{E95DC29B-B5FD-B227-3FFC-1E3502018B6C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69" creationId="{D5A042FA-7D32-E9B3-3B81-23AD2D95A59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0" creationId="{DD6F5203-AECB-944C-E662-8247BA40D12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1" creationId="{87640FCD-6B71-365A-85C7-2D643B964364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2" creationId="{B8E3CB13-DBD7-FE2B-BF3B-A4EAEC7673D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3" creationId="{02E05548-012B-5367-9DFB-97F6A11A488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4" creationId="{C2F53A96-9F30-3C1A-CB69-52256E765E1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5" creationId="{4744D8DF-930C-3B5B-09F9-A94276C8D9B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6" creationId="{3911E389-1D35-72CE-BC08-5E50583D7DC3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7" creationId="{7EEB1084-1002-B0C4-1E1C-D92645DB60E7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8" creationId="{A7F7CE73-E775-3967-291E-40028BF042A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9" creationId="{8EAA0873-B598-5BE3-8342-51E8F6DF1A8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0" creationId="{CC82C95F-5C71-C27D-4206-E11F5EB5B9F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1" creationId="{60BADF61-66FA-FD1F-153D-F3F36D85C5E3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2" creationId="{DF1886F2-5957-1B28-30F3-2CD8D284277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3" creationId="{12A17A62-16A9-6466-4779-40330CF1DE0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4" creationId="{9087FF59-69FE-7709-3CE9-A9F5DB483B5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5" creationId="{17E6B6D2-622D-92E6-B57F-FA64CF50E6B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6" creationId="{5D193B9A-953C-1C54-DAEE-2F2FE396431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7" creationId="{38E7CFA7-3C01-32E1-2485-C481865A24F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8" creationId="{72C442C6-B6C5-A390-2AF4-1B5317F3FC0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9" creationId="{58847D3E-458C-7434-18F2-7DEC6FF5708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0" creationId="{DE2EACE1-B1D4-A17C-19F9-AD910B5A439C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1" creationId="{9524A231-081B-5229-0CE3-B73A72EED83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2" creationId="{B326FC93-01BC-D9EE-4496-123A9C9CA7A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3" creationId="{F37444E6-F551-0343-6775-CCD99B22E61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01" creationId="{8C6D8F70-58C2-6378-C678-38A073D3669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02" creationId="{9874BC1F-FB66-C56E-C54A-4A3D12C6C61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03" creationId="{3B8BF806-70E7-E9DB-EEAC-637882EB2953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11" creationId="{11039C50-FDC1-40E3-088C-9894CAB1FB0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13" creationId="{AB451B77-BD36-9D5E-3A42-ADC85C4A274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14" creationId="{27D74B33-A501-EFCF-CFC0-D5FF6947670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21" creationId="{20C542BB-E9AE-126F-C06F-2E3D1E9B051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23" creationId="{F343F3E4-96B9-E3F1-B27B-E6D7CEE54E7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24" creationId="{0A7AAEA6-6BAB-0BDC-F388-EFCAF18976CA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526" creationId="{7150DCAB-0E6C-B67D-824B-2033EDAB459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2" creationId="{A657FCEA-4FF8-EBB9-EA2E-5DE85F99CD4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3" creationId="{268130D2-72A5-6320-96B4-4CEC51FC0D9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4" creationId="{190E084B-4D3B-EE22-4F06-58112F5111B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5" creationId="{3821EC33-988D-5E7A-366D-8526840CF9CB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566" creationId="{F84D33E0-D75B-E5DD-90F3-F58810190783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567" creationId="{0674B0C4-69D0-6BA3-FBC1-6938931A39E6}"/>
          </ac:spMkLst>
        </pc:spChg>
        <pc:spChg chg="add mod">
          <ac:chgData name="Go" userId="b11a5121-062d-4360-8951-d081ad96d999" providerId="ADAL" clId="{9F3DCE2B-CD69-4735-8D75-F97BD501C620}" dt="2022-10-06T02:26:51.843" v="140" actId="14100"/>
          <ac:spMkLst>
            <pc:docMk/>
            <pc:sldMk cId="3299870256" sldId="301"/>
            <ac:spMk id="569" creationId="{7FEE8F95-0A39-7126-223C-C6EF2690BC96}"/>
          </ac:spMkLst>
        </pc:spChg>
        <pc:spChg chg="add mod">
          <ac:chgData name="Go" userId="b11a5121-062d-4360-8951-d081ad96d999" providerId="ADAL" clId="{9F3DCE2B-CD69-4735-8D75-F97BD501C620}" dt="2022-10-06T02:27:03.098" v="143" actId="6549"/>
          <ac:spMkLst>
            <pc:docMk/>
            <pc:sldMk cId="3299870256" sldId="301"/>
            <ac:spMk id="570" creationId="{59DE02A7-C0DC-0479-0D80-A0B880F649FC}"/>
          </ac:spMkLst>
        </pc:spChg>
        <pc:spChg chg="add mod">
          <ac:chgData name="Go" userId="b11a5121-062d-4360-8951-d081ad96d999" providerId="ADAL" clId="{9F3DCE2B-CD69-4735-8D75-F97BD501C620}" dt="2022-10-06T02:26:55.376" v="141"/>
          <ac:spMkLst>
            <pc:docMk/>
            <pc:sldMk cId="3299870256" sldId="301"/>
            <ac:spMk id="571" creationId="{B5FECC4F-4C4A-CF55-3697-F1285BD8FDC6}"/>
          </ac:spMkLst>
        </pc:spChg>
        <pc:spChg chg="add mod">
          <ac:chgData name="Go" userId="b11a5121-062d-4360-8951-d081ad96d999" providerId="ADAL" clId="{9F3DCE2B-CD69-4735-8D75-F97BD501C620}" dt="2022-10-06T02:26:46.155" v="138" actId="14100"/>
          <ac:spMkLst>
            <pc:docMk/>
            <pc:sldMk cId="3299870256" sldId="301"/>
            <ac:spMk id="572" creationId="{A0827BB1-6801-B6D2-2367-75A2600B37A0}"/>
          </ac:spMkLst>
        </pc:spChg>
        <pc:spChg chg="mod topLvl">
          <ac:chgData name="Go" userId="b11a5121-062d-4360-8951-d081ad96d999" providerId="ADAL" clId="{9F3DCE2B-CD69-4735-8D75-F97BD501C620}" dt="2022-10-06T02:39:08.977" v="300" actId="164"/>
          <ac:spMkLst>
            <pc:docMk/>
            <pc:sldMk cId="3299870256" sldId="301"/>
            <ac:spMk id="576" creationId="{B3051111-6CD4-B04F-9F5B-F260D6C89BD5}"/>
          </ac:spMkLst>
        </pc:spChg>
        <pc:spChg chg="mod topLvl">
          <ac:chgData name="Go" userId="b11a5121-062d-4360-8951-d081ad96d999" providerId="ADAL" clId="{9F3DCE2B-CD69-4735-8D75-F97BD501C620}" dt="2022-10-06T02:39:08.977" v="300" actId="164"/>
          <ac:spMkLst>
            <pc:docMk/>
            <pc:sldMk cId="3299870256" sldId="301"/>
            <ac:spMk id="577" creationId="{291D8301-F5B4-C87F-E0CE-35783993D7FC}"/>
          </ac:spMkLst>
        </pc:spChg>
        <pc:spChg chg="mod topLvl">
          <ac:chgData name="Go" userId="b11a5121-062d-4360-8951-d081ad96d999" providerId="ADAL" clId="{9F3DCE2B-CD69-4735-8D75-F97BD501C620}" dt="2022-10-06T02:39:12.753" v="301" actId="164"/>
          <ac:spMkLst>
            <pc:docMk/>
            <pc:sldMk cId="3299870256" sldId="301"/>
            <ac:spMk id="578" creationId="{39F090BB-F7CE-9A2D-DB70-190E68C5EB83}"/>
          </ac:spMkLst>
        </pc:spChg>
        <pc:spChg chg="mod topLvl">
          <ac:chgData name="Go" userId="b11a5121-062d-4360-8951-d081ad96d999" providerId="ADAL" clId="{9F3DCE2B-CD69-4735-8D75-F97BD501C620}" dt="2022-10-06T02:39:12.753" v="301" actId="164"/>
          <ac:spMkLst>
            <pc:docMk/>
            <pc:sldMk cId="3299870256" sldId="301"/>
            <ac:spMk id="579" creationId="{0F2B4379-20AA-5B82-9C7E-6CD3C418FAD9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580" creationId="{7792413A-1C5F-F801-4015-D5F0C3EBE6AD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586" creationId="{205EBF96-3975-9EBB-82BF-524229ADCA5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0" creationId="{AA06D570-6CA8-78A8-4078-0DCECA1A2914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1" creationId="{DAF03CD4-6585-0520-B5E5-596E496FC8D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2" creationId="{68E2104F-A94A-2856-1246-CD9535F3C81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3" creationId="{73CD0F0F-1DC2-2D06-FBAB-0AD204A2C89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4" creationId="{7AC4DDB0-14D2-7C48-BB54-FD55593DF77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5" creationId="{A38E2007-370C-1F1D-947C-193A8785E42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6" creationId="{D90BAA66-82BF-AB0E-F44E-A3693776677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19" creationId="{449E51EC-10A4-27BD-9A52-B3764E537BC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1" creationId="{CD1F8E55-9517-768F-F486-09E3E8CD212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2" creationId="{34E3AA86-8CB3-AEFE-8E81-B5D67BC7EA6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3" creationId="{8C025F04-1C7C-D904-4E2F-58041B5E43F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4" creationId="{056594E1-727B-F8A1-7873-ACB7CE51EE0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5" creationId="{2DEC7FC4-B77B-41B9-39FB-F34AC4A598D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629" creationId="{F9EE2836-7AC4-31A7-0E13-A86BEF57BE09}"/>
          </ac:spMkLst>
        </pc:s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3" creationId="{3A15472C-E09F-4095-A18E-A09C1E12E157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" creationId="{2D984CF2-E6E5-BE37-045A-A523D153C1F2}"/>
          </ac:grpSpMkLst>
        </pc:grpChg>
        <pc:grpChg chg="mod topLvl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" creationId="{1388BBF7-D2F6-5B7B-E265-EEFCCE948918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9" creationId="{6DD48C8D-2E56-FC23-39A6-9849EF8614D1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0" creationId="{22BC352B-0776-C75B-AFCE-B2F4DA4B02D1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3" creationId="{1E099AC9-B6D4-462F-43ED-2B932B9309F3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4" creationId="{9F868A2D-1438-4051-AF94-B48BE5A5D4A5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5" creationId="{EB21658D-98D4-B8CE-DB71-377C482A4C78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8" creationId="{6AEEC1AF-D955-9805-31DF-521E0F8EECF7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9" creationId="{DCFDA3C9-95DA-84E5-B03B-630323BBD700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20" creationId="{E21F8CEC-E83B-F070-D777-299FA4EAFA32}"/>
          </ac:grpSpMkLst>
        </pc:grpChg>
        <pc:grpChg chg="del">
          <ac:chgData name="Go" userId="b11a5121-062d-4360-8951-d081ad96d999" providerId="ADAL" clId="{9F3DCE2B-CD69-4735-8D75-F97BD501C620}" dt="2022-10-06T02:19:21.711" v="86" actId="478"/>
          <ac:grpSpMkLst>
            <pc:docMk/>
            <pc:sldMk cId="3299870256" sldId="301"/>
            <ac:grpSpMk id="21" creationId="{4C4BFF3F-907D-5187-7CB9-14A7EFEEED2A}"/>
          </ac:grpSpMkLst>
        </pc:grpChg>
        <pc:grpChg chg="del mod topLvl">
          <ac:chgData name="Go" userId="b11a5121-062d-4360-8951-d081ad96d999" providerId="ADAL" clId="{9F3DCE2B-CD69-4735-8D75-F97BD501C620}" dt="2022-10-06T02:25:01.107" v="115" actId="165"/>
          <ac:grpSpMkLst>
            <pc:docMk/>
            <pc:sldMk cId="3299870256" sldId="301"/>
            <ac:grpSpMk id="26" creationId="{0BA1BCA1-5FC4-0C49-C14F-40FB8ED755B9}"/>
          </ac:grpSpMkLst>
        </pc:grpChg>
        <pc:grpChg chg="del mod topLvl">
          <ac:chgData name="Go" userId="b11a5121-062d-4360-8951-d081ad96d999" providerId="ADAL" clId="{9F3DCE2B-CD69-4735-8D75-F97BD501C620}" dt="2022-10-06T02:25:05.203" v="116" actId="478"/>
          <ac:grpSpMkLst>
            <pc:docMk/>
            <pc:sldMk cId="3299870256" sldId="301"/>
            <ac:grpSpMk id="32" creationId="{C5C02679-FE29-E5DC-3B04-0FEEB2230AC0}"/>
          </ac:grpSpMkLst>
        </pc:grpChg>
        <pc:grpChg chg="del mod">
          <ac:chgData name="Go" userId="b11a5121-062d-4360-8951-d081ad96d999" providerId="ADAL" clId="{9F3DCE2B-CD69-4735-8D75-F97BD501C620}" dt="2022-10-06T02:24:54.472" v="114" actId="165"/>
          <ac:grpSpMkLst>
            <pc:docMk/>
            <pc:sldMk cId="3299870256" sldId="301"/>
            <ac:grpSpMk id="33" creationId="{F87A5B70-5377-48A3-675A-7BB159218FC4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35" creationId="{3B5D5338-4068-0B8B-9A3F-750DB95A2FDC}"/>
          </ac:grpSpMkLst>
        </pc:grpChg>
        <pc:grpChg chg="del mod topLvl">
          <ac:chgData name="Go" userId="b11a5121-062d-4360-8951-d081ad96d999" providerId="ADAL" clId="{9F3DCE2B-CD69-4735-8D75-F97BD501C620}" dt="2022-10-06T02:27:09.450" v="144" actId="165"/>
          <ac:grpSpMkLst>
            <pc:docMk/>
            <pc:sldMk cId="3299870256" sldId="301"/>
            <ac:grpSpMk id="37" creationId="{C9AA53E6-8F5E-1970-A858-EA458C600559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2" creationId="{B7ABF30E-0DAA-79EC-3373-2A1384ED35EE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5" creationId="{CA2DC73B-0DCA-BD1A-690E-97E31DECD1A1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6" creationId="{D1FC1DCA-D234-F33B-B943-D3EC23252ADD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8" creationId="{9FBB999A-C9A9-63E3-4497-9E82FE676455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9" creationId="{229C6446-E3E8-E694-9D74-5E2F97B0E3BC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0" creationId="{2494B6E0-8512-E611-C1B9-FB4744D3EE43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4" creationId="{E0F5D351-A7F5-BEAB-DA1C-80547F9DD3E0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58" creationId="{50A49278-9C09-11F2-7571-2FABA095C600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9" creationId="{6C9199C7-9E8F-87D8-5B0D-213EBCB0BABD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2" creationId="{C8E36A41-226C-3052-0ADB-0BB617BAD256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29" creationId="{89124929-017B-F717-C116-73761B755524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0" creationId="{2B0E73FB-59F0-E7D2-0310-1FD156327979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1" creationId="{5EA6E0E4-6A72-08B5-0EB1-47721D704954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5" creationId="{A265201B-D5B5-EEB9-D592-E9EF89CB9301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6" creationId="{660071C4-AF1A-F11A-7193-C5071E39C7E7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7" creationId="{6ED48973-95E0-357D-AC36-20D3666319FF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8" creationId="{C1E8B024-5731-5476-C6B6-95AA4CAD3B03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265" creationId="{58D7A5F3-D98F-4285-EE18-1B7425AB048A}"/>
          </ac:grpSpMkLst>
        </pc:grpChg>
        <pc:grpChg chg="del mod topLvl">
          <ac:chgData name="Go" userId="b11a5121-062d-4360-8951-d081ad96d999" providerId="ADAL" clId="{9F3DCE2B-CD69-4735-8D75-F97BD501C620}" dt="2022-10-06T02:27:18.765" v="147" actId="478"/>
          <ac:grpSpMkLst>
            <pc:docMk/>
            <pc:sldMk cId="3299870256" sldId="301"/>
            <ac:grpSpMk id="294" creationId="{16B64ABB-AAB7-D70E-E2F1-5D23EAEE781C}"/>
          </ac:grpSpMkLst>
        </pc:grpChg>
        <pc:grpChg chg="del mod topLvl">
          <ac:chgData name="Go" userId="b11a5121-062d-4360-8951-d081ad96d999" providerId="ADAL" clId="{9F3DCE2B-CD69-4735-8D75-F97BD501C620}" dt="2022-10-06T02:27:12.746" v="146" actId="478"/>
          <ac:grpSpMkLst>
            <pc:docMk/>
            <pc:sldMk cId="3299870256" sldId="301"/>
            <ac:grpSpMk id="340" creationId="{6978A1B5-46A4-5B6A-79C9-71083DA3C80C}"/>
          </ac:grpSpMkLst>
        </pc:grpChg>
        <pc:grpChg chg="del mod topLvl">
          <ac:chgData name="Go" userId="b11a5121-062d-4360-8951-d081ad96d999" providerId="ADAL" clId="{9F3DCE2B-CD69-4735-8D75-F97BD501C620}" dt="2022-10-06T02:25:06.866" v="117" actId="478"/>
          <ac:grpSpMkLst>
            <pc:docMk/>
            <pc:sldMk cId="3299870256" sldId="301"/>
            <ac:grpSpMk id="353" creationId="{FD21445C-3153-DE45-74B6-F1410920582C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53" creationId="{5BAB4F1C-9B77-0EE4-3B0E-C89DF28CDA19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54" creationId="{9A5D5962-E869-7093-4002-36410AA5D696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64" creationId="{17C21720-62CF-2EB6-2C65-7D0429926D99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68" creationId="{706C3840-D8CA-33D8-4500-9CF9E3C9CD63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73" creationId="{FBA6C53D-B473-F3A3-9284-0CA75D11F752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74" creationId="{09B9E57B-C211-879A-4E02-D57C8D7370D5}"/>
          </ac:grpSpMkLst>
        </pc:grpChg>
        <pc:grpChg chg="add del mod">
          <ac:chgData name="Go" userId="b11a5121-062d-4360-8951-d081ad96d999" providerId="ADAL" clId="{9F3DCE2B-CD69-4735-8D75-F97BD501C620}" dt="2022-10-06T02:38:58.369" v="299" actId="165"/>
          <ac:grpSpMkLst>
            <pc:docMk/>
            <pc:sldMk cId="3299870256" sldId="301"/>
            <ac:grpSpMk id="575" creationId="{B920F064-3CFB-215B-A207-B4908F644B6C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81" creationId="{4E21338A-FC59-5D0F-6590-E5BBA4062FCA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82" creationId="{8285CAB0-3863-6BEB-31C1-2CA27C7772CF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09" creationId="{5933C05E-F357-C1AA-C0E5-AB0366B3323F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0" creationId="{9E51DE33-5F23-372E-E897-B37F4B9D38B7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1" creationId="{B5383931-008B-27A4-8551-928741CA87C8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2" creationId="{AA7BD866-A642-E072-CB03-E6EC90E03463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3" creationId="{384C9D67-922B-5FE4-F5BE-2EDEE970B4F6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4" creationId="{2A68A7DF-F9C9-5046-85AB-EC2E5E9C691E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5" creationId="{B51C6E7A-1939-D71C-0980-ADDC1E6F759A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6" creationId="{A235A10B-0046-850D-E367-6FAB78643C13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7" creationId="{479189AC-07BA-8F0E-3FB2-7C45473B6F09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8" creationId="{E1536666-8D1C-1255-C1E9-4C42CCAEDEF8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639" creationId="{1DE898C2-E809-2B55-CF57-DE7A01B03F65}"/>
          </ac:grpSpMkLst>
        </pc:grpChg>
        <pc:graphicFrameChg chg="add mod ord">
          <ac:chgData name="Go" userId="b11a5121-062d-4360-8951-d081ad96d999" providerId="ADAL" clId="{9F3DCE2B-CD69-4735-8D75-F97BD501C620}" dt="2022-10-06T03:01:28.049" v="365" actId="1035"/>
          <ac:graphicFrameMkLst>
            <pc:docMk/>
            <pc:sldMk cId="3299870256" sldId="301"/>
            <ac:graphicFrameMk id="2" creationId="{1AD00D3D-FBDC-C399-AE11-A003C5D2BB23}"/>
          </ac:graphicFrameMkLst>
        </pc:graphicFrameChg>
        <pc:graphicFrameChg chg="mod">
          <ac:chgData name="Go" userId="b11a5121-062d-4360-8951-d081ad96d999" providerId="ADAL" clId="{9F3DCE2B-CD69-4735-8D75-F97BD501C620}" dt="2022-10-06T02:35:20.501" v="220"/>
          <ac:graphicFrameMkLst>
            <pc:docMk/>
            <pc:sldMk cId="3299870256" sldId="301"/>
            <ac:graphicFrameMk id="7" creationId="{29619FA3-5320-80AE-05A1-1DFE07FA76AF}"/>
          </ac:graphicFrameMkLst>
        </pc:graphicFrameChg>
        <pc:graphicFrameChg chg="mod">
          <ac:chgData name="Go" userId="b11a5121-062d-4360-8951-d081ad96d999" providerId="ADAL" clId="{9F3DCE2B-CD69-4735-8D75-F97BD501C620}" dt="2022-10-06T03:01:28.049" v="365" actId="1035"/>
          <ac:graphicFrameMkLst>
            <pc:docMk/>
            <pc:sldMk cId="3299870256" sldId="301"/>
            <ac:graphicFrameMk id="39" creationId="{A19956A4-38A4-0919-E076-3ECBAC5CB58A}"/>
          </ac:graphicFrameMkLst>
        </pc:graphicFrameChg>
        <pc:graphicFrameChg chg="del mod topLvl">
          <ac:chgData name="Go" userId="b11a5121-062d-4360-8951-d081ad96d999" providerId="ADAL" clId="{9F3DCE2B-CD69-4735-8D75-F97BD501C620}" dt="2022-10-06T02:25:47.036" v="126" actId="478"/>
          <ac:graphicFrameMkLst>
            <pc:docMk/>
            <pc:sldMk cId="3299870256" sldId="301"/>
            <ac:graphicFrameMk id="214" creationId="{3A7A70EC-40DB-875B-87FC-ADBA3AA62B73}"/>
          </ac:graphicFrameMkLst>
        </pc:graphicFrameChg>
        <pc:picChg chg="del topLvl">
          <ac:chgData name="Go" userId="b11a5121-062d-4360-8951-d081ad96d999" providerId="ADAL" clId="{9F3DCE2B-CD69-4735-8D75-F97BD501C620}" dt="2022-10-06T02:19:21.711" v="86" actId="478"/>
          <ac:picMkLst>
            <pc:docMk/>
            <pc:sldMk cId="3299870256" sldId="301"/>
            <ac:picMk id="267" creationId="{56C78E99-E031-09B9-7725-4188B39EFF2C}"/>
          </ac:picMkLst>
        </pc:picChg>
      </pc:sldChg>
    </pc:docChg>
  </pc:docChgLst>
  <pc:docChgLst>
    <pc:chgData name="Go" userId="b11a5121-062d-4360-8951-d081ad96d999" providerId="ADAL" clId="{52F29124-2773-4FC9-A15B-0DFCA3E9DA52}"/>
    <pc:docChg chg="undo custSel modSld">
      <pc:chgData name="Go" userId="b11a5121-062d-4360-8951-d081ad96d999" providerId="ADAL" clId="{52F29124-2773-4FC9-A15B-0DFCA3E9DA52}" dt="2022-10-13T06:03:31.608" v="99" actId="6549"/>
      <pc:docMkLst>
        <pc:docMk/>
      </pc:docMkLst>
      <pc:sldChg chg="addSp delSp modSp mod">
        <pc:chgData name="Go" userId="b11a5121-062d-4360-8951-d081ad96d999" providerId="ADAL" clId="{52F29124-2773-4FC9-A15B-0DFCA3E9DA52}" dt="2022-10-13T06:03:31.608" v="99" actId="6549"/>
        <pc:sldMkLst>
          <pc:docMk/>
          <pc:sldMk cId="4198847848" sldId="289"/>
        </pc:sldMkLst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6" creationId="{1371575E-03FE-EE70-76FF-FA71A80DCB10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12" creationId="{862C96C3-B678-4FDB-79C7-BD9FF90DBB5B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14" creationId="{46907438-93BD-1BB7-73D0-42587FA78A56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15" creationId="{330CE62C-3F93-475E-1991-04687F7380DF}"/>
          </ac:spMkLst>
        </pc:spChg>
        <pc:spChg chg="mod">
          <ac:chgData name="Go" userId="b11a5121-062d-4360-8951-d081ad96d999" providerId="ADAL" clId="{52F29124-2773-4FC9-A15B-0DFCA3E9DA52}" dt="2022-10-13T06:03:13.558" v="89"/>
          <ac:spMkLst>
            <pc:docMk/>
            <pc:sldMk cId="4198847848" sldId="289"/>
            <ac:spMk id="19" creationId="{7D68F769-E8DD-44CF-A4E5-1312488851B5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0" creationId="{1E5638A1-D88D-1784-8C3B-1B8361927869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2" creationId="{36E91FB9-4892-1F8E-353E-FF9EB925FD47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3" creationId="{8F56171D-F7BE-E561-DC43-A9B6735F84A4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5" creationId="{68F4F58B-8832-9843-D9CE-23AFF4B8F241}"/>
          </ac:spMkLst>
        </pc:spChg>
        <pc:spChg chg="del mod topLvl">
          <ac:chgData name="Go" userId="b11a5121-062d-4360-8951-d081ad96d999" providerId="ADAL" clId="{52F29124-2773-4FC9-A15B-0DFCA3E9DA52}" dt="2022-10-13T06:02:23.728" v="69" actId="478"/>
          <ac:spMkLst>
            <pc:docMk/>
            <pc:sldMk cId="4198847848" sldId="289"/>
            <ac:spMk id="26" creationId="{C7291577-3B2B-CF92-110E-2F3C3AF1C20E}"/>
          </ac:spMkLst>
        </pc:spChg>
        <pc:spChg chg="mod topLvl">
          <ac:chgData name="Go" userId="b11a5121-062d-4360-8951-d081ad96d999" providerId="ADAL" clId="{52F29124-2773-4FC9-A15B-0DFCA3E9DA52}" dt="2022-10-13T06:02:18.358" v="68" actId="164"/>
          <ac:spMkLst>
            <pc:docMk/>
            <pc:sldMk cId="4198847848" sldId="289"/>
            <ac:spMk id="29" creationId="{0859BD14-4FA4-0795-E0EB-5AAE01B9CCD5}"/>
          </ac:spMkLst>
        </pc:spChg>
        <pc:spChg chg="mod">
          <ac:chgData name="Go" userId="b11a5121-062d-4360-8951-d081ad96d999" providerId="ADAL" clId="{52F29124-2773-4FC9-A15B-0DFCA3E9DA52}" dt="2022-10-13T06:02:43.058" v="77" actId="14100"/>
          <ac:spMkLst>
            <pc:docMk/>
            <pc:sldMk cId="4198847848" sldId="289"/>
            <ac:spMk id="30" creationId="{FC148F42-5523-6278-2C5F-3B069D4677E0}"/>
          </ac:spMkLst>
        </pc:spChg>
        <pc:spChg chg="mod">
          <ac:chgData name="Go" userId="b11a5121-062d-4360-8951-d081ad96d999" providerId="ADAL" clId="{52F29124-2773-4FC9-A15B-0DFCA3E9DA52}" dt="2022-10-13T06:02:40.849" v="76" actId="14100"/>
          <ac:spMkLst>
            <pc:docMk/>
            <pc:sldMk cId="4198847848" sldId="289"/>
            <ac:spMk id="31" creationId="{4B0C0D4E-C485-800D-136E-3B5190E9C0AF}"/>
          </ac:spMkLst>
        </pc:spChg>
        <pc:spChg chg="mod">
          <ac:chgData name="Go" userId="b11a5121-062d-4360-8951-d081ad96d999" providerId="ADAL" clId="{52F29124-2773-4FC9-A15B-0DFCA3E9DA52}" dt="2022-10-13T06:02:02.488" v="65" actId="165"/>
          <ac:spMkLst>
            <pc:docMk/>
            <pc:sldMk cId="4198847848" sldId="289"/>
            <ac:spMk id="33" creationId="{2C118948-231F-1F9D-09C3-4B4F5BA9B6A0}"/>
          </ac:spMkLst>
        </pc:spChg>
        <pc:spChg chg="mod">
          <ac:chgData name="Go" userId="b11a5121-062d-4360-8951-d081ad96d999" providerId="ADAL" clId="{52F29124-2773-4FC9-A15B-0DFCA3E9DA52}" dt="2022-10-13T06:02:28.228" v="70" actId="14100"/>
          <ac:spMkLst>
            <pc:docMk/>
            <pc:sldMk cId="4198847848" sldId="289"/>
            <ac:spMk id="34" creationId="{830A266A-048F-1F68-B3E0-F65F808C7741}"/>
          </ac:spMkLst>
        </pc:spChg>
        <pc:spChg chg="mod">
          <ac:chgData name="Go" userId="b11a5121-062d-4360-8951-d081ad96d999" providerId="ADAL" clId="{52F29124-2773-4FC9-A15B-0DFCA3E9DA52}" dt="2022-10-13T06:02:29.898" v="71" actId="14100"/>
          <ac:spMkLst>
            <pc:docMk/>
            <pc:sldMk cId="4198847848" sldId="289"/>
            <ac:spMk id="35" creationId="{5400C05B-D17B-E886-3BA9-7F75EDADED5E}"/>
          </ac:spMkLst>
        </pc:spChg>
        <pc:spChg chg="mod">
          <ac:chgData name="Go" userId="b11a5121-062d-4360-8951-d081ad96d999" providerId="ADAL" clId="{52F29124-2773-4FC9-A15B-0DFCA3E9DA52}" dt="2022-10-13T06:02:02.488" v="65" actId="165"/>
          <ac:spMkLst>
            <pc:docMk/>
            <pc:sldMk cId="4198847848" sldId="289"/>
            <ac:spMk id="36" creationId="{7FF9410D-73F7-EB65-E0FF-E2112266A595}"/>
          </ac:spMkLst>
        </pc:spChg>
        <pc:spChg chg="add del mod">
          <ac:chgData name="Go" userId="b11a5121-062d-4360-8951-d081ad96d999" providerId="ADAL" clId="{52F29124-2773-4FC9-A15B-0DFCA3E9DA52}" dt="2022-10-13T06:01:32.518" v="56"/>
          <ac:spMkLst>
            <pc:docMk/>
            <pc:sldMk cId="4198847848" sldId="289"/>
            <ac:spMk id="37" creationId="{E1C7FEAE-40E1-AD62-FABA-24EF613FC5BB}"/>
          </ac:spMkLst>
        </pc:spChg>
        <pc:spChg chg="mod">
          <ac:chgData name="Go" userId="b11a5121-062d-4360-8951-d081ad96d999" providerId="ADAL" clId="{52F29124-2773-4FC9-A15B-0DFCA3E9DA52}" dt="2022-10-13T06:03:03.298" v="84" actId="20577"/>
          <ac:spMkLst>
            <pc:docMk/>
            <pc:sldMk cId="4198847848" sldId="289"/>
            <ac:spMk id="56" creationId="{591B5E2C-071D-1FA3-516C-A23252F4EAE0}"/>
          </ac:spMkLst>
        </pc:spChg>
        <pc:spChg chg="add mod">
          <ac:chgData name="Go" userId="b11a5121-062d-4360-8951-d081ad96d999" providerId="ADAL" clId="{52F29124-2773-4FC9-A15B-0DFCA3E9DA52}" dt="2022-10-13T06:03:31.608" v="99" actId="6549"/>
          <ac:spMkLst>
            <pc:docMk/>
            <pc:sldMk cId="4198847848" sldId="289"/>
            <ac:spMk id="59" creationId="{638D4131-CD65-E2A2-5377-7594633FFA79}"/>
          </ac:spMkLst>
        </pc:spChg>
        <pc:spChg chg="mod">
          <ac:chgData name="Go" userId="b11a5121-062d-4360-8951-d081ad96d999" providerId="ADAL" clId="{52F29124-2773-4FC9-A15B-0DFCA3E9DA52}" dt="2022-10-13T06:03:16.368" v="94"/>
          <ac:spMkLst>
            <pc:docMk/>
            <pc:sldMk cId="4198847848" sldId="289"/>
            <ac:spMk id="69" creationId="{ECFCF99C-38AB-4DC4-A277-DFC8A3B1ECDF}"/>
          </ac:spMkLst>
        </pc:spChg>
        <pc:spChg chg="ord">
          <ac:chgData name="Go" userId="b11a5121-062d-4360-8951-d081ad96d999" providerId="ADAL" clId="{52F29124-2773-4FC9-A15B-0DFCA3E9DA52}" dt="2022-10-13T06:01:39.228" v="57" actId="167"/>
          <ac:spMkLst>
            <pc:docMk/>
            <pc:sldMk cId="4198847848" sldId="289"/>
            <ac:spMk id="74" creationId="{EA64EB29-ADCA-73ED-7718-2E8F06FCEFA9}"/>
          </ac:spMkLst>
        </pc:spChg>
        <pc:grpChg chg="mod">
          <ac:chgData name="Go" userId="b11a5121-062d-4360-8951-d081ad96d999" providerId="ADAL" clId="{52F29124-2773-4FC9-A15B-0DFCA3E9DA52}" dt="2022-10-13T05:48:39.978" v="43" actId="1038"/>
          <ac:grpSpMkLst>
            <pc:docMk/>
            <pc:sldMk cId="4198847848" sldId="289"/>
            <ac:grpSpMk id="2" creationId="{B2FD1FFB-4E78-0C3D-A641-8046DE08B520}"/>
          </ac:grpSpMkLst>
        </pc:grpChg>
        <pc:grpChg chg="add del mod">
          <ac:chgData name="Go" userId="b11a5121-062d-4360-8951-d081ad96d999" providerId="ADAL" clId="{52F29124-2773-4FC9-A15B-0DFCA3E9DA52}" dt="2022-10-13T05:59:26.328" v="49" actId="165"/>
          <ac:grpSpMkLst>
            <pc:docMk/>
            <pc:sldMk cId="4198847848" sldId="289"/>
            <ac:grpSpMk id="3" creationId="{9FCC5441-2205-C08C-6D50-7D141B324DC7}"/>
          </ac:grpSpMkLst>
        </pc:grpChg>
        <pc:grpChg chg="del mod topLvl">
          <ac:chgData name="Go" userId="b11a5121-062d-4360-8951-d081ad96d999" providerId="ADAL" clId="{52F29124-2773-4FC9-A15B-0DFCA3E9DA52}" dt="2022-10-13T06:02:02.488" v="65" actId="165"/>
          <ac:grpSpMkLst>
            <pc:docMk/>
            <pc:sldMk cId="4198847848" sldId="289"/>
            <ac:grpSpMk id="8" creationId="{24E21BA2-1B5B-917F-B506-20D2BE47DF70}"/>
          </ac:grpSpMkLst>
        </pc:grpChg>
        <pc:grpChg chg="mod topLvl">
          <ac:chgData name="Go" userId="b11a5121-062d-4360-8951-d081ad96d999" providerId="ADAL" clId="{52F29124-2773-4FC9-A15B-0DFCA3E9DA52}" dt="2022-10-13T06:02:02.488" v="65" actId="165"/>
          <ac:grpSpMkLst>
            <pc:docMk/>
            <pc:sldMk cId="4198847848" sldId="289"/>
            <ac:grpSpMk id="27" creationId="{075889E4-E48A-F0E3-C5D2-CEC000F97771}"/>
          </ac:grpSpMkLst>
        </pc:grpChg>
        <pc:grpChg chg="mod topLvl">
          <ac:chgData name="Go" userId="b11a5121-062d-4360-8951-d081ad96d999" providerId="ADAL" clId="{52F29124-2773-4FC9-A15B-0DFCA3E9DA52}" dt="2022-10-13T06:02:33.718" v="73" actId="14100"/>
          <ac:grpSpMkLst>
            <pc:docMk/>
            <pc:sldMk cId="4198847848" sldId="289"/>
            <ac:grpSpMk id="28" creationId="{B2BC3338-3EEF-6A44-68D8-885DD23C1818}"/>
          </ac:grpSpMkLst>
        </pc:grpChg>
        <pc:grpChg chg="add mod">
          <ac:chgData name="Go" userId="b11a5121-062d-4360-8951-d081ad96d999" providerId="ADAL" clId="{52F29124-2773-4FC9-A15B-0DFCA3E9DA52}" dt="2022-10-13T06:02:58.198" v="80" actId="554"/>
          <ac:grpSpMkLst>
            <pc:docMk/>
            <pc:sldMk cId="4198847848" sldId="289"/>
            <ac:grpSpMk id="45" creationId="{2DFEA9BC-4E4D-469F-F722-637BB01AF58C}"/>
          </ac:grpSpMkLst>
        </pc:grpChg>
        <pc:grpChg chg="add mod">
          <ac:chgData name="Go" userId="b11a5121-062d-4360-8951-d081ad96d999" providerId="ADAL" clId="{52F29124-2773-4FC9-A15B-0DFCA3E9DA52}" dt="2022-10-13T06:02:58.198" v="80" actId="554"/>
          <ac:grpSpMkLst>
            <pc:docMk/>
            <pc:sldMk cId="4198847848" sldId="289"/>
            <ac:grpSpMk id="55" creationId="{26809872-AEDA-55C9-D4EF-8B78CEE05A9F}"/>
          </ac:grpSpMkLst>
        </pc:grp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4" creationId="{C61A9ACD-A35E-CABF-DC0F-DFC3FE911A68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5" creationId="{D529FFCD-96DD-2085-D658-05BE8822553F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7" creationId="{570C03D4-9885-1DE9-A161-07890068A4F9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0" creationId="{47239B5B-AE66-30F7-4FE8-F032BB78F5AE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3" creationId="{6384335C-79AE-8172-D5DF-7529DDE9B744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6" creationId="{4A4092D2-96F2-FA8F-E9AB-2569B80AAA70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7" creationId="{C2F012C9-F323-36DA-07F4-CEA68E0FBAF6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24" creationId="{7158A9C9-E5E3-F9F3-6597-D9E12877E31C}"/>
          </ac:picMkLst>
        </pc:picChg>
        <pc:cxnChg chg="add mod">
          <ac:chgData name="Go" userId="b11a5121-062d-4360-8951-d081ad96d999" providerId="ADAL" clId="{52F29124-2773-4FC9-A15B-0DFCA3E9DA52}" dt="2022-10-13T06:02:18.358" v="68" actId="164"/>
          <ac:cxnSpMkLst>
            <pc:docMk/>
            <pc:sldMk cId="4198847848" sldId="289"/>
            <ac:cxnSpMk id="38" creationId="{5BD417B4-8375-6009-ED5A-2BFA8E28E7E7}"/>
          </ac:cxnSpMkLst>
        </pc:cxnChg>
        <pc:cxnChg chg="mod">
          <ac:chgData name="Go" userId="b11a5121-062d-4360-8951-d081ad96d999" providerId="ADAL" clId="{52F29124-2773-4FC9-A15B-0DFCA3E9DA52}" dt="2022-10-13T06:02:49.548" v="78"/>
          <ac:cxnSpMkLst>
            <pc:docMk/>
            <pc:sldMk cId="4198847848" sldId="289"/>
            <ac:cxnSpMk id="58" creationId="{1E81D1DD-D381-72F3-3ABE-D9D10DA53938}"/>
          </ac:cxnSpMkLst>
        </pc:cxnChg>
      </pc:sldChg>
      <pc:sldChg chg="modSp mod">
        <pc:chgData name="Go" userId="b11a5121-062d-4360-8951-d081ad96d999" providerId="ADAL" clId="{52F29124-2773-4FC9-A15B-0DFCA3E9DA52}" dt="2022-10-13T05:48:18.939" v="12" actId="1038"/>
        <pc:sldMkLst>
          <pc:docMk/>
          <pc:sldMk cId="2231304746" sldId="299"/>
        </pc:sldMkLst>
        <pc:spChg chg="mod">
          <ac:chgData name="Go" userId="b11a5121-062d-4360-8951-d081ad96d999" providerId="ADAL" clId="{52F29124-2773-4FC9-A15B-0DFCA3E9DA52}" dt="2022-10-13T05:48:18.939" v="12" actId="1038"/>
          <ac:spMkLst>
            <pc:docMk/>
            <pc:sldMk cId="2231304746" sldId="299"/>
            <ac:spMk id="26" creationId="{B24D405F-2229-B7DC-EC12-925F30D0A658}"/>
          </ac:spMkLst>
        </pc:spChg>
        <pc:spChg chg="mod">
          <ac:chgData name="Go" userId="b11a5121-062d-4360-8951-d081ad96d999" providerId="ADAL" clId="{52F29124-2773-4FC9-A15B-0DFCA3E9DA52}" dt="2022-10-13T05:48:18.939" v="12" actId="1038"/>
          <ac:spMkLst>
            <pc:docMk/>
            <pc:sldMk cId="2231304746" sldId="299"/>
            <ac:spMk id="27" creationId="{B42E50CF-C6BD-ED37-FE05-0B55412D9AD3}"/>
          </ac:spMkLst>
        </pc:spChg>
        <pc:grpChg chg="mod">
          <ac:chgData name="Go" userId="b11a5121-062d-4360-8951-d081ad96d999" providerId="ADAL" clId="{52F29124-2773-4FC9-A15B-0DFCA3E9DA52}" dt="2022-10-13T05:48:18.939" v="12" actId="1038"/>
          <ac:grpSpMkLst>
            <pc:docMk/>
            <pc:sldMk cId="2231304746" sldId="299"/>
            <ac:grpSpMk id="4" creationId="{27BA6C3D-7A59-89EB-3682-D8BCAA78894E}"/>
          </ac:grpSpMkLst>
        </pc:grpChg>
      </pc:sldChg>
    </pc:docChg>
  </pc:docChgLst>
  <pc:docChgLst>
    <pc:chgData name="Go" userId="b11a5121-062d-4360-8951-d081ad96d999" providerId="ADAL" clId="{F4BB04B8-C649-4010-9750-C8B716E69BA6}"/>
    <pc:docChg chg="delSld">
      <pc:chgData name="Go" userId="b11a5121-062d-4360-8951-d081ad96d999" providerId="ADAL" clId="{F4BB04B8-C649-4010-9750-C8B716E69BA6}" dt="2022-10-15T03:33:53.975" v="1" actId="47"/>
      <pc:docMkLst>
        <pc:docMk/>
      </pc:docMkLst>
      <pc:sldChg chg="del">
        <pc:chgData name="Go" userId="b11a5121-062d-4360-8951-d081ad96d999" providerId="ADAL" clId="{F4BB04B8-C649-4010-9750-C8B716E69BA6}" dt="2022-10-15T03:33:51.738" v="0" actId="47"/>
        <pc:sldMkLst>
          <pc:docMk/>
          <pc:sldMk cId="1094954127" sldId="284"/>
        </pc:sldMkLst>
      </pc:sldChg>
      <pc:sldChg chg="del">
        <pc:chgData name="Go" userId="b11a5121-062d-4360-8951-d081ad96d999" providerId="ADAL" clId="{F4BB04B8-C649-4010-9750-C8B716E69BA6}" dt="2022-10-15T03:33:53.975" v="1" actId="47"/>
        <pc:sldMkLst>
          <pc:docMk/>
          <pc:sldMk cId="4198847848" sldId="289"/>
        </pc:sldMkLst>
      </pc:sldChg>
      <pc:sldChg chg="del">
        <pc:chgData name="Go" userId="b11a5121-062d-4360-8951-d081ad96d999" providerId="ADAL" clId="{F4BB04B8-C649-4010-9750-C8B716E69BA6}" dt="2022-10-15T03:33:51.738" v="0" actId="47"/>
        <pc:sldMkLst>
          <pc:docMk/>
          <pc:sldMk cId="765565405" sldId="295"/>
        </pc:sldMkLst>
      </pc:sldChg>
      <pc:sldChg chg="del">
        <pc:chgData name="Go" userId="b11a5121-062d-4360-8951-d081ad96d999" providerId="ADAL" clId="{F4BB04B8-C649-4010-9750-C8B716E69BA6}" dt="2022-10-15T03:33:51.738" v="0" actId="47"/>
        <pc:sldMkLst>
          <pc:docMk/>
          <pc:sldMk cId="970619779" sldId="297"/>
        </pc:sldMkLst>
      </pc:sldChg>
      <pc:sldChg chg="del">
        <pc:chgData name="Go" userId="b11a5121-062d-4360-8951-d081ad96d999" providerId="ADAL" clId="{F4BB04B8-C649-4010-9750-C8B716E69BA6}" dt="2022-10-15T03:33:51.738" v="0" actId="47"/>
        <pc:sldMkLst>
          <pc:docMk/>
          <pc:sldMk cId="2231304746" sldId="299"/>
        </pc:sldMkLst>
      </pc:sldChg>
      <pc:sldChg chg="del">
        <pc:chgData name="Go" userId="b11a5121-062d-4360-8951-d081ad96d999" providerId="ADAL" clId="{F4BB04B8-C649-4010-9750-C8B716E69BA6}" dt="2022-10-15T03:33:51.738" v="0" actId="47"/>
        <pc:sldMkLst>
          <pc:docMk/>
          <pc:sldMk cId="3299870256" sldId="301"/>
        </pc:sldMkLst>
      </pc:sldChg>
      <pc:sldChg chg="del">
        <pc:chgData name="Go" userId="b11a5121-062d-4360-8951-d081ad96d999" providerId="ADAL" clId="{F4BB04B8-C649-4010-9750-C8B716E69BA6}" dt="2022-10-15T03:33:51.738" v="0" actId="47"/>
        <pc:sldMkLst>
          <pc:docMk/>
          <pc:sldMk cId="2069005311" sldId="302"/>
        </pc:sldMkLst>
      </pc:sldChg>
    </pc:docChg>
  </pc:docChgLst>
  <pc:docChgLst>
    <pc:chgData name="Go" userId="b11a5121-062d-4360-8951-d081ad96d999" providerId="ADAL" clId="{92EBE5FB-309E-45D5-8034-D862F06526E4}"/>
    <pc:docChg chg="modSld">
      <pc:chgData name="Go" userId="b11a5121-062d-4360-8951-d081ad96d999" providerId="ADAL" clId="{92EBE5FB-309E-45D5-8034-D862F06526E4}" dt="2022-12-09T06:05:36.987" v="4"/>
      <pc:docMkLst>
        <pc:docMk/>
      </pc:docMkLst>
      <pc:sldChg chg="modSp mod">
        <pc:chgData name="Go" userId="b11a5121-062d-4360-8951-d081ad96d999" providerId="ADAL" clId="{92EBE5FB-309E-45D5-8034-D862F06526E4}" dt="2022-12-09T06:05:36.987" v="4"/>
        <pc:sldMkLst>
          <pc:docMk/>
          <pc:sldMk cId="1909606739" sldId="303"/>
        </pc:sldMkLst>
        <pc:spChg chg="mod">
          <ac:chgData name="Go" userId="b11a5121-062d-4360-8951-d081ad96d999" providerId="ADAL" clId="{92EBE5FB-309E-45D5-8034-D862F06526E4}" dt="2022-12-09T06:05:36.987" v="4"/>
          <ac:spMkLst>
            <pc:docMk/>
            <pc:sldMk cId="1909606739" sldId="303"/>
            <ac:spMk id="23" creationId="{8F56171D-F7BE-E561-DC43-A9B6735F84A4}"/>
          </ac:spMkLst>
        </pc:spChg>
      </pc:sldChg>
    </pc:docChg>
  </pc:docChgLst>
  <pc:docChgLst>
    <pc:chgData name="Go" userId="b11a5121-062d-4360-8951-d081ad96d999" providerId="ADAL" clId="{A37B11FE-7E2B-4B71-9282-AB38B86228CA}"/>
    <pc:docChg chg="undo redo custSel addSld modSld sldOrd">
      <pc:chgData name="Go" userId="b11a5121-062d-4360-8951-d081ad96d999" providerId="ADAL" clId="{A37B11FE-7E2B-4B71-9282-AB38B86228CA}" dt="2022-10-15T01:48:08.111" v="1521" actId="555"/>
      <pc:docMkLst>
        <pc:docMk/>
      </pc:docMkLst>
      <pc:sldChg chg="modSp mod">
        <pc:chgData name="Go" userId="b11a5121-062d-4360-8951-d081ad96d999" providerId="ADAL" clId="{A37B11FE-7E2B-4B71-9282-AB38B86228CA}" dt="2022-10-15T01:46:26.953" v="1491" actId="20577"/>
        <pc:sldMkLst>
          <pc:docMk/>
          <pc:sldMk cId="1094954127" sldId="284"/>
        </pc:sldMkLst>
        <pc:spChg chg="mod">
          <ac:chgData name="Go" userId="b11a5121-062d-4360-8951-d081ad96d999" providerId="ADAL" clId="{A37B11FE-7E2B-4B71-9282-AB38B86228CA}" dt="2022-10-15T01:46:12.230" v="1482" actId="20577"/>
          <ac:spMkLst>
            <pc:docMk/>
            <pc:sldMk cId="1094954127" sldId="284"/>
            <ac:spMk id="347" creationId="{7E39A75D-38B4-D5AD-98A4-4AE965473059}"/>
          </ac:spMkLst>
        </pc:spChg>
        <pc:spChg chg="mod">
          <ac:chgData name="Go" userId="b11a5121-062d-4360-8951-d081ad96d999" providerId="ADAL" clId="{A37B11FE-7E2B-4B71-9282-AB38B86228CA}" dt="2022-10-15T01:46:17.881" v="1485" actId="20577"/>
          <ac:spMkLst>
            <pc:docMk/>
            <pc:sldMk cId="1094954127" sldId="284"/>
            <ac:spMk id="359" creationId="{C8E420D2-28A1-5437-B38E-6D212B142507}"/>
          </ac:spMkLst>
        </pc:spChg>
        <pc:spChg chg="mod">
          <ac:chgData name="Go" userId="b11a5121-062d-4360-8951-d081ad96d999" providerId="ADAL" clId="{A37B11FE-7E2B-4B71-9282-AB38B86228CA}" dt="2022-10-15T01:46:23.467" v="1488" actId="20577"/>
          <ac:spMkLst>
            <pc:docMk/>
            <pc:sldMk cId="1094954127" sldId="284"/>
            <ac:spMk id="371" creationId="{38316EC8-82FB-7105-7E65-4D366D5DC41F}"/>
          </ac:spMkLst>
        </pc:spChg>
        <pc:spChg chg="mod">
          <ac:chgData name="Go" userId="b11a5121-062d-4360-8951-d081ad96d999" providerId="ADAL" clId="{A37B11FE-7E2B-4B71-9282-AB38B86228CA}" dt="2022-10-15T01:46:26.953" v="1491" actId="20577"/>
          <ac:spMkLst>
            <pc:docMk/>
            <pc:sldMk cId="1094954127" sldId="284"/>
            <ac:spMk id="455" creationId="{1B83A5B9-24D0-604A-B889-D87FC290C02C}"/>
          </ac:spMkLst>
        </pc:spChg>
      </pc:sldChg>
      <pc:sldChg chg="delSp modSp mod">
        <pc:chgData name="Go" userId="b11a5121-062d-4360-8951-d081ad96d999" providerId="ADAL" clId="{A37B11FE-7E2B-4B71-9282-AB38B86228CA}" dt="2022-10-15T01:48:08.111" v="1521" actId="555"/>
        <pc:sldMkLst>
          <pc:docMk/>
          <pc:sldMk cId="4198847848" sldId="289"/>
        </pc:sldMkLst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6" creationId="{1371575E-03FE-EE70-76FF-FA71A80DCB10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12" creationId="{862C96C3-B678-4FDB-79C7-BD9FF90DBB5B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14" creationId="{46907438-93BD-1BB7-73D0-42587FA78A56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15" creationId="{330CE62C-3F93-475E-1991-04687F7380DF}"/>
          </ac:spMkLst>
        </pc:spChg>
        <pc:spChg chg="mod">
          <ac:chgData name="Go" userId="b11a5121-062d-4360-8951-d081ad96d999" providerId="ADAL" clId="{A37B11FE-7E2B-4B71-9282-AB38B86228CA}" dt="2022-10-13T20:38:46.290" v="1118" actId="20577"/>
          <ac:spMkLst>
            <pc:docMk/>
            <pc:sldMk cId="4198847848" sldId="289"/>
            <ac:spMk id="19" creationId="{7D68F769-E8DD-44CF-A4E5-1312488851B5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0" creationId="{1E5638A1-D88D-1784-8C3B-1B8361927869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2" creationId="{36E91FB9-4892-1F8E-353E-FF9EB925FD47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3" creationId="{8F56171D-F7BE-E561-DC43-A9B6735F84A4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5" creationId="{68F4F58B-8832-9843-D9CE-23AFF4B8F241}"/>
          </ac:spMkLst>
        </pc:spChg>
        <pc:spChg chg="mod">
          <ac:chgData name="Go" userId="b11a5121-062d-4360-8951-d081ad96d999" providerId="ADAL" clId="{A37B11FE-7E2B-4B71-9282-AB38B86228CA}" dt="2022-10-13T20:38:31.029" v="1085" actId="20577"/>
          <ac:spMkLst>
            <pc:docMk/>
            <pc:sldMk cId="4198847848" sldId="289"/>
            <ac:spMk id="44" creationId="{4EBA0680-77E2-2ABD-9B13-E3E33B2FEBA0}"/>
          </ac:spMkLst>
        </pc:spChg>
        <pc:spChg chg="mod">
          <ac:chgData name="Go" userId="b11a5121-062d-4360-8951-d081ad96d999" providerId="ADAL" clId="{A37B11FE-7E2B-4B71-9282-AB38B86228CA}" dt="2022-10-15T01:48:08.111" v="1521" actId="555"/>
          <ac:spMkLst>
            <pc:docMk/>
            <pc:sldMk cId="4198847848" sldId="289"/>
            <ac:spMk id="52" creationId="{9870C4CC-D847-B4A6-B69D-EA5358FC56E3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59" creationId="{638D4131-CD65-E2A2-5377-7594633FFA79}"/>
          </ac:spMkLst>
        </pc:spChg>
        <pc:spChg chg="mod">
          <ac:chgData name="Go" userId="b11a5121-062d-4360-8951-d081ad96d999" providerId="ADAL" clId="{A37B11FE-7E2B-4B71-9282-AB38B86228CA}" dt="2022-10-13T20:38:48.726" v="1120" actId="20577"/>
          <ac:spMkLst>
            <pc:docMk/>
            <pc:sldMk cId="4198847848" sldId="289"/>
            <ac:spMk id="69" creationId="{ECFCF99C-38AB-4DC4-A277-DFC8A3B1ECDF}"/>
          </ac:spMkLst>
        </pc:spChg>
        <pc:spChg chg="mod">
          <ac:chgData name="Go" userId="b11a5121-062d-4360-8951-d081ad96d999" providerId="ADAL" clId="{A37B11FE-7E2B-4B71-9282-AB38B86228CA}" dt="2022-10-15T01:48:08.111" v="1521" actId="555"/>
          <ac:spMkLst>
            <pc:docMk/>
            <pc:sldMk cId="4198847848" sldId="289"/>
            <ac:spMk id="77" creationId="{33C1C1D7-4480-E59E-7619-2126CC1A36FF}"/>
          </ac:spMkLst>
        </pc:spChg>
        <pc:spChg chg="mod">
          <ac:chgData name="Go" userId="b11a5121-062d-4360-8951-d081ad96d999" providerId="ADAL" clId="{A37B11FE-7E2B-4B71-9282-AB38B86228CA}" dt="2022-10-15T01:48:08.111" v="1521" actId="555"/>
          <ac:spMkLst>
            <pc:docMk/>
            <pc:sldMk cId="4198847848" sldId="289"/>
            <ac:spMk id="79" creationId="{E0309F23-C5EE-0A6E-0543-BF3AE2E1E50B}"/>
          </ac:spMkLst>
        </pc:spChg>
        <pc:grpChg chg="mod">
          <ac:chgData name="Go" userId="b11a5121-062d-4360-8951-d081ad96d999" providerId="ADAL" clId="{A37B11FE-7E2B-4B71-9282-AB38B86228CA}" dt="2022-10-13T20:38:42.614" v="1116" actId="1037"/>
          <ac:grpSpMkLst>
            <pc:docMk/>
            <pc:sldMk cId="4198847848" sldId="289"/>
            <ac:grpSpMk id="2" creationId="{B2FD1FFB-4E78-0C3D-A641-8046DE08B520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27" creationId="{075889E4-E48A-F0E3-C5D2-CEC000F97771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28" creationId="{B2BC3338-3EEF-6A44-68D8-885DD23C1818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45" creationId="{2DFEA9BC-4E4D-469F-F722-637BB01AF58C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55" creationId="{26809872-AEDA-55C9-D4EF-8B78CEE05A9F}"/>
          </ac:grpSpMkLst>
        </pc:grp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4" creationId="{C61A9ACD-A35E-CABF-DC0F-DFC3FE911A68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5" creationId="{D529FFCD-96DD-2085-D658-05BE8822553F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7" creationId="{570C03D4-9885-1DE9-A161-07890068A4F9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0" creationId="{47239B5B-AE66-30F7-4FE8-F032BB78F5AE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3" creationId="{6384335C-79AE-8172-D5DF-7529DDE9B744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6" creationId="{4A4092D2-96F2-FA8F-E9AB-2569B80AAA70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7" creationId="{C2F012C9-F323-36DA-07F4-CEA68E0FBAF6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24" creationId="{7158A9C9-E5E3-F9F3-6597-D9E12877E31C}"/>
          </ac:picMkLst>
        </pc:picChg>
      </pc:sldChg>
      <pc:sldChg chg="addSp delSp modSp mod">
        <pc:chgData name="Go" userId="b11a5121-062d-4360-8951-d081ad96d999" providerId="ADAL" clId="{A37B11FE-7E2B-4B71-9282-AB38B86228CA}" dt="2022-10-14T01:53:43.823" v="1347" actId="478"/>
        <pc:sldMkLst>
          <pc:docMk/>
          <pc:sldMk cId="765565405" sldId="295"/>
        </pc:sldMkLst>
        <pc:spChg chg="add del mod">
          <ac:chgData name="Go" userId="b11a5121-062d-4360-8951-d081ad96d999" providerId="ADAL" clId="{A37B11FE-7E2B-4B71-9282-AB38B86228CA}" dt="2022-10-13T20:39:51.738" v="1124" actId="478"/>
          <ac:spMkLst>
            <pc:docMk/>
            <pc:sldMk cId="765565405" sldId="295"/>
            <ac:spMk id="2" creationId="{7288BBF4-1537-B43B-BB42-DA412F0CAAEB}"/>
          </ac:spMkLst>
        </pc:spChg>
        <pc:spChg chg="del">
          <ac:chgData name="Go" userId="b11a5121-062d-4360-8951-d081ad96d999" providerId="ADAL" clId="{A37B11FE-7E2B-4B71-9282-AB38B86228CA}" dt="2022-10-13T20:39:37.685" v="1122" actId="478"/>
          <ac:spMkLst>
            <pc:docMk/>
            <pc:sldMk cId="765565405" sldId="295"/>
            <ac:spMk id="6" creationId="{47B992C5-C82F-9A33-E06F-0CF2A4077CC8}"/>
          </ac:spMkLst>
        </pc:spChg>
        <pc:spChg chg="del">
          <ac:chgData name="Go" userId="b11a5121-062d-4360-8951-d081ad96d999" providerId="ADAL" clId="{A37B11FE-7E2B-4B71-9282-AB38B86228CA}" dt="2022-10-13T20:40:53.102" v="1133" actId="478"/>
          <ac:spMkLst>
            <pc:docMk/>
            <pc:sldMk cId="765565405" sldId="295"/>
            <ac:spMk id="32" creationId="{01000DD1-93DA-1423-F7E5-5A48E9CC7F42}"/>
          </ac:spMkLst>
        </pc:spChg>
        <pc:spChg chg="add mod">
          <ac:chgData name="Go" userId="b11a5121-062d-4360-8951-d081ad96d999" providerId="ADAL" clId="{A37B11FE-7E2B-4B71-9282-AB38B86228CA}" dt="2022-10-13T20:42:07.095" v="1155" actId="1036"/>
          <ac:spMkLst>
            <pc:docMk/>
            <pc:sldMk cId="765565405" sldId="295"/>
            <ac:spMk id="36" creationId="{F245A393-AA8C-8E50-A7C0-9BBDD069179F}"/>
          </ac:spMkLst>
        </pc:spChg>
        <pc:spChg chg="add mod">
          <ac:chgData name="Go" userId="b11a5121-062d-4360-8951-d081ad96d999" providerId="ADAL" clId="{A37B11FE-7E2B-4B71-9282-AB38B86228CA}" dt="2022-10-13T20:41:15.141" v="1141" actId="1076"/>
          <ac:spMkLst>
            <pc:docMk/>
            <pc:sldMk cId="765565405" sldId="295"/>
            <ac:spMk id="37" creationId="{660F6457-F508-AE06-1A3B-E3DBC117B738}"/>
          </ac:spMkLst>
        </pc:spChg>
        <pc:picChg chg="add del mod">
          <ac:chgData name="Go" userId="b11a5121-062d-4360-8951-d081ad96d999" providerId="ADAL" clId="{A37B11FE-7E2B-4B71-9282-AB38B86228CA}" dt="2022-10-14T01:53:43.823" v="1347" actId="478"/>
          <ac:picMkLst>
            <pc:docMk/>
            <pc:sldMk cId="765565405" sldId="295"/>
            <ac:picMk id="40" creationId="{5DDE6FC3-ECFB-5D45-AE89-4D8A04E171F8}"/>
          </ac:picMkLst>
        </pc:picChg>
        <pc:cxnChg chg="add del mod">
          <ac:chgData name="Go" userId="b11a5121-062d-4360-8951-d081ad96d999" providerId="ADAL" clId="{A37B11FE-7E2B-4B71-9282-AB38B86228CA}" dt="2022-10-13T20:40:54.620" v="1134" actId="478"/>
          <ac:cxnSpMkLst>
            <pc:docMk/>
            <pc:sldMk cId="765565405" sldId="295"/>
            <ac:cxnSpMk id="35" creationId="{D3EAD5EB-A2A1-BD4B-748C-6AD789159238}"/>
          </ac:cxnSpMkLst>
        </pc:cxnChg>
      </pc:sldChg>
      <pc:sldChg chg="modSp mod">
        <pc:chgData name="Go" userId="b11a5121-062d-4360-8951-d081ad96d999" providerId="ADAL" clId="{A37B11FE-7E2B-4B71-9282-AB38B86228CA}" dt="2022-10-15T01:47:01.280" v="1505" actId="20577"/>
        <pc:sldMkLst>
          <pc:docMk/>
          <pc:sldMk cId="970619779" sldId="297"/>
        </pc:sldMkLst>
        <pc:spChg chg="mod">
          <ac:chgData name="Go" userId="b11a5121-062d-4360-8951-d081ad96d999" providerId="ADAL" clId="{A37B11FE-7E2B-4B71-9282-AB38B86228CA}" dt="2022-10-15T01:46:40.900" v="1494" actId="20577"/>
          <ac:spMkLst>
            <pc:docMk/>
            <pc:sldMk cId="970619779" sldId="297"/>
            <ac:spMk id="1113" creationId="{39F2BCD9-900F-01E9-1717-5DA5F4D4C967}"/>
          </ac:spMkLst>
        </pc:spChg>
        <pc:spChg chg="mod">
          <ac:chgData name="Go" userId="b11a5121-062d-4360-8951-d081ad96d999" providerId="ADAL" clId="{A37B11FE-7E2B-4B71-9282-AB38B86228CA}" dt="2022-10-15T01:46:56.153" v="1502" actId="13926"/>
          <ac:spMkLst>
            <pc:docMk/>
            <pc:sldMk cId="970619779" sldId="297"/>
            <ac:spMk id="1185" creationId="{D9F5002C-825F-FC50-D3F7-F7E1E66A74B0}"/>
          </ac:spMkLst>
        </pc:spChg>
        <pc:spChg chg="mod">
          <ac:chgData name="Go" userId="b11a5121-062d-4360-8951-d081ad96d999" providerId="ADAL" clId="{A37B11FE-7E2B-4B71-9282-AB38B86228CA}" dt="2022-10-15T01:47:01.280" v="1505" actId="20577"/>
          <ac:spMkLst>
            <pc:docMk/>
            <pc:sldMk cId="970619779" sldId="297"/>
            <ac:spMk id="1221" creationId="{596C9DE2-9098-44CD-FA87-981A8ED98497}"/>
          </ac:spMkLst>
        </pc:spChg>
      </pc:sldChg>
      <pc:sldChg chg="addSp delSp modSp mod">
        <pc:chgData name="Go" userId="b11a5121-062d-4360-8951-d081ad96d999" providerId="ADAL" clId="{A37B11FE-7E2B-4B71-9282-AB38B86228CA}" dt="2022-10-15T01:45:25.502" v="1479" actId="20577"/>
        <pc:sldMkLst>
          <pc:docMk/>
          <pc:sldMk cId="3299870256" sldId="301"/>
        </pc:sldMkLst>
        <pc:spChg chg="mod">
          <ac:chgData name="Go" userId="b11a5121-062d-4360-8951-d081ad96d999" providerId="ADAL" clId="{A37B11FE-7E2B-4B71-9282-AB38B86228CA}" dt="2022-10-14T00:57:19.778" v="1193" actId="554"/>
          <ac:spMkLst>
            <pc:docMk/>
            <pc:sldMk cId="3299870256" sldId="301"/>
            <ac:spMk id="12" creationId="{A7DA65A8-9C18-44D5-8A91-8C50381BEF9D}"/>
          </ac:spMkLst>
        </pc:spChg>
        <pc:spChg chg="mod">
          <ac:chgData name="Go" userId="b11a5121-062d-4360-8951-d081ad96d999" providerId="ADAL" clId="{A37B11FE-7E2B-4B71-9282-AB38B86228CA}" dt="2022-10-13T20:32:44.234" v="1046" actId="1035"/>
          <ac:spMkLst>
            <pc:docMk/>
            <pc:sldMk cId="3299870256" sldId="301"/>
            <ac:spMk id="16" creationId="{2D415CC3-EC50-47BD-9C07-95599E264991}"/>
          </ac:spMkLst>
        </pc:spChg>
        <pc:spChg chg="add del mod">
          <ac:chgData name="Go" userId="b11a5121-062d-4360-8951-d081ad96d999" providerId="ADAL" clId="{A37B11FE-7E2B-4B71-9282-AB38B86228CA}" dt="2022-10-14T05:28:21.614" v="1473" actId="478"/>
          <ac:spMkLst>
            <pc:docMk/>
            <pc:sldMk cId="3299870256" sldId="301"/>
            <ac:spMk id="21" creationId="{0BCBD50A-D2DE-9423-2FCD-6A2AF9DA2E79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24" creationId="{DE2A6ADC-279B-EB8D-4D1B-8A1449932BC7}"/>
          </ac:spMkLst>
        </pc:spChg>
        <pc:spChg chg="mod topLvl">
          <ac:chgData name="Go" userId="b11a5121-062d-4360-8951-d081ad96d999" providerId="ADAL" clId="{A37B11FE-7E2B-4B71-9282-AB38B86228CA}" dt="2022-10-14T01:36:07.890" v="1310" actId="164"/>
          <ac:spMkLst>
            <pc:docMk/>
            <pc:sldMk cId="3299870256" sldId="301"/>
            <ac:spMk id="37" creationId="{873ABBA6-F404-2931-A177-FA14A024DAE1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4" creationId="{089D6C4B-E85D-1CD3-914B-2088CDFD16BB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63" creationId="{C2DEC8A3-11BC-D720-0DA0-92E3857A969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4" creationId="{9F007954-0AAD-3205-735A-B9A54442C770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5" creationId="{515CE48F-1CC6-72F9-4350-E9508E72096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6" creationId="{7448F8AD-C4F0-4AA1-98CB-C813BC9B24D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7" creationId="{B3A138A0-A275-7353-FE03-EC2EFA9DC93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8" creationId="{2CDF2CD0-379D-D6FC-2C99-2932958E9A5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76" creationId="{74E5028F-A99A-AA28-7FDC-A26AA484CD2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4" creationId="{837F1CCF-F169-1CFB-7F9B-402401FD2EE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5" creationId="{ECDDBD90-6215-8E50-4FF9-A25F1931545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6" creationId="{E2524BC4-E63F-BA5E-F6B8-AA15C24401A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7" creationId="{449EA4CF-2036-F01A-EDEE-4CF90C93DED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8" creationId="{BA00C4AC-2A75-732C-667D-BC15171D6C0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9" creationId="{FFF62C9B-5DEA-D3C7-C3CE-99A61B19D567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94" creationId="{F56C1CE8-089D-C261-8DF8-C11DFF669F6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95" creationId="{3248A607-9A53-1219-2078-5B2467583ED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98" creationId="{E58C1058-FD72-2F7B-528C-68026EC1AEB2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99" creationId="{C89A6AE9-D9E0-46E2-ACDE-19A7EC908815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100" creationId="{F6DAD6F7-1072-4389-B036-7467DC7F1C9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06" creationId="{C61B6210-8D97-7703-4BFD-05CF3757588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07" creationId="{A8BCDEF0-1932-D050-7EA4-6D4982CCD0B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1" creationId="{6238CB2F-65B3-6DAB-3A9F-573FDC5657A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2" creationId="{E9C1FCEA-6490-E01F-C27D-DC03ED1AF9B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3" creationId="{3A35C103-3B66-069D-BFFA-FEF04477F7F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4" creationId="{81ABC751-DDFA-1FD8-FFF3-CA82D5193F6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6" creationId="{44B7E7F0-E894-2277-9541-01E126F3AC6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7" creationId="{E2AC9109-AE40-1616-97A4-F9388B59D5D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8" creationId="{8BCFE8D6-B1DA-1CE4-64E1-56169C4D7EB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0" creationId="{EDB01C96-6BB2-78ED-E253-EE7A72186D0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2" creationId="{56C5CEE4-9BE2-803A-12E1-E95FE066836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4" creationId="{D0F35713-6707-76B8-B2CA-E131E5AEEC5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6" creationId="{2D35C4E2-2DB7-0322-089D-ADFA59447EA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7" creationId="{8A76B3BE-6305-3092-D6E1-5320853AEDB0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132" creationId="{F68DB3C2-4564-74AC-DFC6-43FCC3D3E48B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133" creationId="{AF8279E9-D98F-4C66-2611-E40CEBB01977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134" creationId="{062BBD42-984D-069F-1412-A08C27DAFD2C}"/>
          </ac:spMkLst>
        </pc:spChg>
        <pc:spChg chg="add mod topLvl">
          <ac:chgData name="Go" userId="b11a5121-062d-4360-8951-d081ad96d999" providerId="ADAL" clId="{A37B11FE-7E2B-4B71-9282-AB38B86228CA}" dt="2022-10-14T00:59:52.956" v="1242" actId="554"/>
          <ac:spMkLst>
            <pc:docMk/>
            <pc:sldMk cId="3299870256" sldId="301"/>
            <ac:spMk id="147" creationId="{F8F1AE5A-A214-4AA6-B7F8-28DC4C5193D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1" creationId="{410B34D5-B21B-1370-706A-E83FD2C998DC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2" creationId="{5CA570F2-FD9E-C7C0-BED4-4844B823FFD2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3" creationId="{C8331F8C-B2BF-090A-B61A-EA551E60FF4C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4" creationId="{32C6731D-4C97-B09A-895D-9591540B3CA3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5" creationId="{72FAA0B2-0F23-A665-57A5-DD5AF0F7FDB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6" creationId="{D37F5891-CB3D-0432-66EB-7AACF067DA6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7" creationId="{C5C9552E-F78D-0C3F-9E24-A306C70AD2A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64" creationId="{797590FF-41DB-2D3E-7727-D12E05DA075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65" creationId="{7DAC27D9-CD5C-0A1E-6661-5E581B5CE15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0" creationId="{AD58643F-7E35-7DF6-0A9E-666FB89DA40A}"/>
          </ac:spMkLst>
        </pc:spChg>
        <pc:spChg chg="mod topLvl">
          <ac:chgData name="Go" userId="b11a5121-062d-4360-8951-d081ad96d999" providerId="ADAL" clId="{A37B11FE-7E2B-4B71-9282-AB38B86228CA}" dt="2022-10-13T20:32:44.234" v="1046" actId="1035"/>
          <ac:spMkLst>
            <pc:docMk/>
            <pc:sldMk cId="3299870256" sldId="301"/>
            <ac:spMk id="171" creationId="{5103E0C0-A43F-D0E9-26C3-CFD997322F2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3" creationId="{B1D845A5-3098-D846-9A7C-1E92E624AA05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6" creationId="{30116284-ABB0-05C0-8ECF-05A13F661117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7" creationId="{B04C50BB-6C20-23E9-2C3D-67C921011979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9" creationId="{223152C6-6F3E-4B9C-1FAB-6FE3606B51DA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1" creationId="{050F6027-1DFF-7CE2-01D4-531DFC658F25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3" creationId="{A8ABD308-10EB-1461-E88B-37AA7F48C2C0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5" creationId="{DC094AB9-5000-D2A7-51BE-B2B71B1F027B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7" creationId="{FC66F015-C44C-65B9-1C1F-9266CA083B4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9" creationId="{9F8BD057-798E-C352-0523-F8ED43AB17C1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91" creationId="{F3A5E892-050B-70EB-D2CC-62D5FBF30FDA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4" creationId="{EE94773D-5D9B-1C40-E368-03AF1BD63AFF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6" creationId="{C42C49A1-C07F-4823-E569-91B91B755B49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7" creationId="{1103D0D3-6D6E-40A8-68C4-264398024C3A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8" creationId="{F9EA1132-45A4-2108-6B16-3A0E24232315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9" creationId="{B08E2F55-95F2-B43E-00B2-0C0A0F36AA80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0" creationId="{76EDAA07-94BC-156E-0580-C09DA35F5359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1" creationId="{8740DBA2-4FF4-6B96-159C-2DC0BD0D939F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2" creationId="{E29DD96A-7BA8-0D91-4F6A-96AC9EDC3781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4" creationId="{9CD771A1-8D0D-352A-8060-AD4928AB94D8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6" creationId="{D0FC6218-5698-90CE-F787-8BBA6078919D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8" creationId="{2A7499D1-1E3B-A887-1963-B1383A8CF875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0" creationId="{86EC0BC4-A1E4-CD4A-0F01-A44D291FF2E0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2" creationId="{CEBEB22F-93EF-38BE-DFF4-CC4920E68616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4" creationId="{91A9AE94-577E-8E33-C932-431481F040F2}"/>
          </ac:spMkLst>
        </pc:spChg>
        <pc:spChg chg="mod">
          <ac:chgData name="Go" userId="b11a5121-062d-4360-8951-d081ad96d999" providerId="ADAL" clId="{A37B11FE-7E2B-4B71-9282-AB38B86228CA}" dt="2022-10-13T19:37:49.807" v="278" actId="20577"/>
          <ac:spMkLst>
            <pc:docMk/>
            <pc:sldMk cId="3299870256" sldId="301"/>
            <ac:spMk id="215" creationId="{131802D4-FD62-DC83-FE86-405BECC0C5AA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6" creationId="{6EE8B2C0-C171-F025-FF38-79271C556B5F}"/>
          </ac:spMkLst>
        </pc:spChg>
        <pc:spChg chg="mod topLvl">
          <ac:chgData name="Go" userId="b11a5121-062d-4360-8951-d081ad96d999" providerId="ADAL" clId="{A37B11FE-7E2B-4B71-9282-AB38B86228CA}" dt="2022-10-14T04:48:12.717" v="1469" actId="20577"/>
          <ac:spMkLst>
            <pc:docMk/>
            <pc:sldMk cId="3299870256" sldId="301"/>
            <ac:spMk id="218" creationId="{F3298815-9305-CB10-9853-8B2AF8F81562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19" creationId="{6D8CA97D-F558-BC5F-31A4-DE0F2829044B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0" creationId="{889F0B7B-5A9E-19BE-28A5-B1EBE2A39EC9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1" creationId="{13522CE3-C41C-10C4-F76C-DF37342B9C48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2" creationId="{24D16945-1AFD-F22D-7D89-AB65CCE4FB41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3" creationId="{64BB2A03-9676-EC4E-4315-26C55CFBA8F6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26" creationId="{7EFDD885-E759-5633-16AB-83EBABFD10FA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28" creationId="{EEB83C73-C9F0-F538-9D71-F91A136029BA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31" creationId="{E20DBB86-5321-43D4-CB59-5868ACA36A90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32" creationId="{F80AF707-F9C5-DFF3-4775-E6E60AC6BCA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34" creationId="{C151D2B4-1E4C-80C5-7FBD-15CFB819C126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35" creationId="{E5E79CFE-CF5A-258B-9604-679C5D9AA6A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36" creationId="{B309F41F-5305-547C-2F54-2F496AA42D6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37" creationId="{89D1BCF2-D4AC-8C3F-17A1-9C25E61AACD4}"/>
          </ac:spMkLst>
        </pc:spChg>
        <pc:spChg chg="add mod topLvl">
          <ac:chgData name="Go" userId="b11a5121-062d-4360-8951-d081ad96d999" providerId="ADAL" clId="{A37B11FE-7E2B-4B71-9282-AB38B86228CA}" dt="2022-10-14T02:29:48.593" v="1455" actId="165"/>
          <ac:spMkLst>
            <pc:docMk/>
            <pc:sldMk cId="3299870256" sldId="301"/>
            <ac:spMk id="239" creationId="{55468863-7BBD-8A76-7C95-BCDCE8D16909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2" creationId="{38A457A0-6299-A36D-F9B4-45B52B2DE62B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3" creationId="{EE0326AC-C714-2619-B53B-3301BC652472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5" creationId="{BC9EF48A-F0A0-2C75-14C4-D4F63F70D2BD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7" creationId="{EDD17BF4-DD9A-E43E-C91C-936DA3F1C642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9" creationId="{5B97B126-3602-DBBE-E080-38451E40E469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1" creationId="{324AE1E1-B787-38F6-A0CC-407494CA79A5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3" creationId="{DFE31705-E4C4-DEF6-9035-25B45B8B5F37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5" creationId="{9A070BDD-A588-B11F-531A-59BBB3CEDF13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7" creationId="{AB60716B-3E83-4CBF-FBED-16441BEF0750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68" creationId="{914F3C87-7FCA-419B-1E93-14D6129C080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69" creationId="{8B257F69-AB3F-5C08-4EB2-6F4244C62D7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70" creationId="{DE906DF3-C9AF-1C9B-E116-A6DCDB379890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71" creationId="{0912BD74-E735-9597-BEF9-74C9A57A78A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72" creationId="{4E4E8A32-917C-289D-6F00-1AB3E3E5E713}"/>
          </ac:spMkLst>
        </pc:spChg>
        <pc:spChg chg="mod topLvl">
          <ac:chgData name="Go" userId="b11a5121-062d-4360-8951-d081ad96d999" providerId="ADAL" clId="{A37B11FE-7E2B-4B71-9282-AB38B86228CA}" dt="2022-10-14T04:48:15.954" v="1470" actId="20577"/>
          <ac:spMkLst>
            <pc:docMk/>
            <pc:sldMk cId="3299870256" sldId="301"/>
            <ac:spMk id="273" creationId="{C210E4EB-3C52-AF8D-4A79-5A61361B4082}"/>
          </ac:spMkLst>
        </pc:spChg>
        <pc:spChg chg="mod topLvl">
          <ac:chgData name="Go" userId="b11a5121-062d-4360-8951-d081ad96d999" providerId="ADAL" clId="{A37B11FE-7E2B-4B71-9282-AB38B86228CA}" dt="2022-10-13T19:59:05.306" v="496" actId="164"/>
          <ac:spMkLst>
            <pc:docMk/>
            <pc:sldMk cId="3299870256" sldId="301"/>
            <ac:spMk id="281" creationId="{1369908A-0A01-7976-2954-B5D6EF43679B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3" creationId="{E3F5427E-0639-BBD4-6023-720F1BD74CB1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5" creationId="{4D89257F-ADA3-4D9F-69B3-BE376248B923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7" creationId="{C96BEBA5-198A-60C9-97E3-3D213A1DE43E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9" creationId="{9EF922F4-6E43-7047-6E71-A344DF1A1463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91" creationId="{3E1A0532-51CA-BA86-754F-0B6DB8FB50F5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294" creationId="{677421E6-57E3-4798-6373-C17F5D175D9A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295" creationId="{7E9BA595-48EE-AD01-7067-1703D560FBA6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3" creationId="{7DD169BB-39E6-03F8-84E4-00C88278E47A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5" creationId="{8F842E5A-061E-FBF8-D81A-961C95AE4D98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7" creationId="{1CFD66BD-464B-F4F9-CB0F-827B3F7EAADC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9" creationId="{418769DE-D879-63BB-AE3A-950845F6CDA3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11" creationId="{B5AF5CE1-DAE3-6A69-94E6-9CCBDDB7A4C6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13" creationId="{D1329BDE-346B-4B3C-A2FF-2DDE44C2227B}"/>
          </ac:spMkLst>
        </pc:spChg>
        <pc:spChg chg="del mod topLvl">
          <ac:chgData name="Go" userId="b11a5121-062d-4360-8951-d081ad96d999" providerId="ADAL" clId="{A37B11FE-7E2B-4B71-9282-AB38B86228CA}" dt="2022-10-13T20:15:28.643" v="716" actId="478"/>
          <ac:spMkLst>
            <pc:docMk/>
            <pc:sldMk cId="3299870256" sldId="301"/>
            <ac:spMk id="321" creationId="{7933A066-F9C5-BA68-6D9B-EA66E4D763E3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3" creationId="{56EAB5A6-DA9A-1633-90AF-5C2407E9ACBF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5" creationId="{76F53C94-1C4B-8B2B-3722-4828FDC374B6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7" creationId="{E1A00A2D-5FC7-1B94-AFB9-0F7EA0B0965C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9" creationId="{1B6D271F-8BC9-BF59-3720-402DCE293261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33" creationId="{995AB39E-D048-F3F8-8DC9-3FB4AAE5D86E}"/>
          </ac:spMkLst>
        </pc:spChg>
        <pc:spChg chg="add del mod topLvl">
          <ac:chgData name="Go" userId="b11a5121-062d-4360-8951-d081ad96d999" providerId="ADAL" clId="{A37B11FE-7E2B-4B71-9282-AB38B86228CA}" dt="2022-10-13T20:37:11.999" v="1065" actId="478"/>
          <ac:spMkLst>
            <pc:docMk/>
            <pc:sldMk cId="3299870256" sldId="301"/>
            <ac:spMk id="338" creationId="{F61388DE-78D6-A063-F8E2-2E1EB0C288EB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2" creationId="{5B182495-D05C-96FA-90A6-B181E5093098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3" creationId="{88163E27-4BD9-6721-43BC-FC14157C7427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4" creationId="{3F91C208-2C69-E38B-1897-E6CDBB5D543A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5" creationId="{22FD6676-1D73-9E66-4253-E581101CE7EF}"/>
          </ac:spMkLst>
        </pc:spChg>
        <pc:spChg chg="mod topLvl">
          <ac:chgData name="Go" userId="b11a5121-062d-4360-8951-d081ad96d999" providerId="ADAL" clId="{A37B11FE-7E2B-4B71-9282-AB38B86228CA}" dt="2022-10-14T00:58:30.819" v="1209" actId="1036"/>
          <ac:spMkLst>
            <pc:docMk/>
            <pc:sldMk cId="3299870256" sldId="301"/>
            <ac:spMk id="347" creationId="{8C2F235E-BE56-B400-BDA7-5C1A101B84CD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348" creationId="{2A461E41-4216-804B-0458-33A2868184CA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3" creationId="{1F4CA620-E81E-2F50-4DA7-C796E90AC79E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4" creationId="{67A08CF0-2928-977E-98A5-CFDF5FC048EE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5" creationId="{3B8B14B8-A98A-D94A-537F-D4BA1BD9C84E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6" creationId="{21CA8342-E53C-1399-DB93-98E1343B97D4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7" creationId="{18AC1B22-6F97-05EE-AAF5-FE7524CC6C7F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58" creationId="{ABDBAC41-3AA4-B8E0-2AEA-507E1DAD2F9B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59" creationId="{55D50987-4EE4-E058-8699-52B43934212D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0" creationId="{361DFD0E-6289-4549-33CE-BA74C4A458BC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1" creationId="{7F295788-CB92-F4DB-5157-B691C112E0DA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2" creationId="{B6FE5AD6-2AEF-DDC3-74C7-91BBEA0D846D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3" creationId="{0D339847-D246-EAF2-4A13-5EFEDD0EC755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4" creationId="{A43BB9FD-A784-657A-B34B-0E0533415E32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5" creationId="{03D66B09-C79D-3129-8189-FF4AE8E228E1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366" creationId="{5F7E0991-BECC-20EF-901D-EAB2B04864D8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367" creationId="{1CE6BBD2-914A-B05C-14F0-406EAAD341E0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368" creationId="{40317649-68F2-CA88-178D-C47C5142B84F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9" creationId="{6A0B3758-47AE-CAB8-B244-037548C315ED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0" creationId="{58300AB8-C197-A261-49FD-C1C855DC6A89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1" creationId="{B8CC8457-3C8D-BCAA-998C-4CDCF8725E12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2" creationId="{6B92EA03-FA8A-9F99-5D6F-95A7565A2029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3" creationId="{2789CC9A-BB73-C89F-238A-C7A0AACD5F48}"/>
          </ac:spMkLst>
        </pc:spChg>
        <pc:spChg chg="add mod">
          <ac:chgData name="Go" userId="b11a5121-062d-4360-8951-d081ad96d999" providerId="ADAL" clId="{A37B11FE-7E2B-4B71-9282-AB38B86228CA}" dt="2022-10-14T01:00:36.842" v="1249" actId="1076"/>
          <ac:spMkLst>
            <pc:docMk/>
            <pc:sldMk cId="3299870256" sldId="301"/>
            <ac:spMk id="375" creationId="{D8E59C99-FE38-C093-2603-38F0FAF81006}"/>
          </ac:spMkLst>
        </pc:spChg>
        <pc:spChg chg="add del mod">
          <ac:chgData name="Go" userId="b11a5121-062d-4360-8951-d081ad96d999" providerId="ADAL" clId="{A37B11FE-7E2B-4B71-9282-AB38B86228CA}" dt="2022-10-14T01:33:53.139" v="1290" actId="478"/>
          <ac:spMkLst>
            <pc:docMk/>
            <pc:sldMk cId="3299870256" sldId="301"/>
            <ac:spMk id="376" creationId="{B2628F72-15A4-CC7F-80F0-4C978868CE08}"/>
          </ac:spMkLst>
        </pc:spChg>
        <pc:spChg chg="add del mod">
          <ac:chgData name="Go" userId="b11a5121-062d-4360-8951-d081ad96d999" providerId="ADAL" clId="{A37B11FE-7E2B-4B71-9282-AB38B86228CA}" dt="2022-10-14T02:29:24.684" v="1453" actId="478"/>
          <ac:spMkLst>
            <pc:docMk/>
            <pc:sldMk cId="3299870256" sldId="301"/>
            <ac:spMk id="377" creationId="{5B62DD5F-9DED-CCE0-B537-41C43ABF0433}"/>
          </ac:spMkLst>
        </pc:spChg>
        <pc:spChg chg="mod">
          <ac:chgData name="Go" userId="b11a5121-062d-4360-8951-d081ad96d999" providerId="ADAL" clId="{A37B11FE-7E2B-4B71-9282-AB38B86228CA}" dt="2022-10-13T20:28:51.124" v="1025" actId="1076"/>
          <ac:spMkLst>
            <pc:docMk/>
            <pc:sldMk cId="3299870256" sldId="301"/>
            <ac:spMk id="381" creationId="{5126D9D2-1907-A43F-5821-94A44A8E930C}"/>
          </ac:spMkLst>
        </pc:spChg>
        <pc:spChg chg="mod topLvl">
          <ac:chgData name="Go" userId="b11a5121-062d-4360-8951-d081ad96d999" providerId="ADAL" clId="{A37B11FE-7E2B-4B71-9282-AB38B86228CA}" dt="2022-10-14T04:48:18.557" v="1471" actId="20577"/>
          <ac:spMkLst>
            <pc:docMk/>
            <pc:sldMk cId="3299870256" sldId="301"/>
            <ac:spMk id="386" creationId="{A2558EC1-8F79-87E0-9F0A-99507D5576B2}"/>
          </ac:spMkLst>
        </pc:spChg>
        <pc:spChg chg="add del mod">
          <ac:chgData name="Go" userId="b11a5121-062d-4360-8951-d081ad96d999" providerId="ADAL" clId="{A37B11FE-7E2B-4B71-9282-AB38B86228CA}" dt="2022-10-14T01:35:57.189" v="1304" actId="478"/>
          <ac:spMkLst>
            <pc:docMk/>
            <pc:sldMk cId="3299870256" sldId="301"/>
            <ac:spMk id="387" creationId="{5B255E18-82A7-5851-9AFC-6200480DA9F3}"/>
          </ac:spMkLst>
        </pc:spChg>
        <pc:spChg chg="add mod topLvl">
          <ac:chgData name="Go" userId="b11a5121-062d-4360-8951-d081ad96d999" providerId="ADAL" clId="{A37B11FE-7E2B-4B71-9282-AB38B86228CA}" dt="2022-10-14T01:45:09.381" v="1323" actId="553"/>
          <ac:spMkLst>
            <pc:docMk/>
            <pc:sldMk cId="3299870256" sldId="301"/>
            <ac:spMk id="388" creationId="{0C1977C0-E865-A02A-3AE8-62B202FA0D49}"/>
          </ac:spMkLst>
        </pc:spChg>
        <pc:spChg chg="add del mod">
          <ac:chgData name="Go" userId="b11a5121-062d-4360-8951-d081ad96d999" providerId="ADAL" clId="{A37B11FE-7E2B-4B71-9282-AB38B86228CA}" dt="2022-10-14T05:28:19.845" v="1472" actId="478"/>
          <ac:spMkLst>
            <pc:docMk/>
            <pc:sldMk cId="3299870256" sldId="301"/>
            <ac:spMk id="400" creationId="{11176BA0-D140-7221-C5F0-E0D29AAF7CD4}"/>
          </ac:spMkLst>
        </pc:spChg>
        <pc:spChg chg="add mod">
          <ac:chgData name="Go" userId="b11a5121-062d-4360-8951-d081ad96d999" providerId="ADAL" clId="{A37B11FE-7E2B-4B71-9282-AB38B86228CA}" dt="2022-10-14T02:31:02.987" v="1466" actId="1076"/>
          <ac:spMkLst>
            <pc:docMk/>
            <pc:sldMk cId="3299870256" sldId="301"/>
            <ac:spMk id="401" creationId="{6D03CB62-9395-58D3-20AA-37BEE1BE1AEE}"/>
          </ac:spMkLst>
        </pc:spChg>
        <pc:spChg chg="mod">
          <ac:chgData name="Go" userId="b11a5121-062d-4360-8951-d081ad96d999" providerId="ADAL" clId="{A37B11FE-7E2B-4B71-9282-AB38B86228CA}" dt="2022-10-13T19:42:29.526" v="330" actId="164"/>
          <ac:spMkLst>
            <pc:docMk/>
            <pc:sldMk cId="3299870256" sldId="301"/>
            <ac:spMk id="404" creationId="{02ECC1BC-F39A-F87F-9CAA-AAC3D74418F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55" creationId="{4DA4660F-ABBE-E1BD-5B04-62B5A75AF21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56" creationId="{86E53E75-99F4-B1E6-B573-52DB085C453C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60" creationId="{5A29D108-29F5-7C8C-D1AF-996AF7E677CC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65" creationId="{ED225DD9-8CCA-9A76-EC30-5DA9B34FB8D4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66" creationId="{FE81A49E-D7DF-8994-E47D-A7017A9CFAE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68" creationId="{E95DC29B-B5FD-B227-3FFC-1E3502018B6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69" creationId="{D5A042FA-7D32-E9B3-3B81-23AD2D95A59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0" creationId="{DD6F5203-AECB-944C-E662-8247BA40D12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1" creationId="{87640FCD-6B71-365A-85C7-2D643B96436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2" creationId="{B8E3CB13-DBD7-FE2B-BF3B-A4EAEC7673D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3" creationId="{02E05548-012B-5367-9DFB-97F6A11A488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4" creationId="{C2F53A96-9F30-3C1A-CB69-52256E765E1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5" creationId="{4744D8DF-930C-3B5B-09F9-A94276C8D9B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6" creationId="{3911E389-1D35-72CE-BC08-5E50583D7DC3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7" creationId="{7EEB1084-1002-B0C4-1E1C-D92645DB60E7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8" creationId="{A7F7CE73-E775-3967-291E-40028BF042A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9" creationId="{8EAA0873-B598-5BE3-8342-51E8F6DF1A8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0" creationId="{CC82C95F-5C71-C27D-4206-E11F5EB5B9F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1" creationId="{60BADF61-66FA-FD1F-153D-F3F36D85C5E3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2" creationId="{DF1886F2-5957-1B28-30F3-2CD8D284277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3" creationId="{12A17A62-16A9-6466-4779-40330CF1DE0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4" creationId="{9087FF59-69FE-7709-3CE9-A9F5DB483B5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5" creationId="{17E6B6D2-622D-92E6-B57F-FA64CF50E6B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6" creationId="{5D193B9A-953C-1C54-DAEE-2F2FE396431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7" creationId="{38E7CFA7-3C01-32E1-2485-C481865A24F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8" creationId="{72C442C6-B6C5-A390-2AF4-1B5317F3FC0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9" creationId="{58847D3E-458C-7434-18F2-7DEC6FF5708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0" creationId="{DE2EACE1-B1D4-A17C-19F9-AD910B5A439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1" creationId="{9524A231-081B-5229-0CE3-B73A72EED83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2" creationId="{B326FC93-01BC-D9EE-4496-123A9C9CA7A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3" creationId="{F37444E6-F551-0343-6775-CCD99B22E615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499" creationId="{3E85AFA4-C5F7-DF52-BB9E-66D505EBD67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01" creationId="{8C6D8F70-58C2-6378-C678-38A073D3669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02" creationId="{9874BC1F-FB66-C56E-C54A-4A3D12C6C61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03" creationId="{3B8BF806-70E7-E9DB-EEAC-637882EB2953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504" creationId="{4A085E4F-99C9-9469-54B8-25B756BA807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11" creationId="{11039C50-FDC1-40E3-088C-9894CAB1FB0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13" creationId="{AB451B77-BD36-9D5E-3A42-ADC85C4A274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14" creationId="{27D74B33-A501-EFCF-CFC0-D5FF6947670D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520" creationId="{98230770-BA50-4A07-C329-6CF4E9E4E9F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21" creationId="{20C542BB-E9AE-126F-C06F-2E3D1E9B051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23" creationId="{F343F3E4-96B9-E3F1-B27B-E6D7CEE54E7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24" creationId="{0A7AAEA6-6BAB-0BDC-F388-EFCAF18976CA}"/>
          </ac:spMkLst>
        </pc:spChg>
        <pc:spChg chg="mod">
          <ac:chgData name="Go" userId="b11a5121-062d-4360-8951-d081ad96d999" providerId="ADAL" clId="{A37B11FE-7E2B-4B71-9282-AB38B86228CA}" dt="2022-10-13T20:13:18.935" v="662" actId="1076"/>
          <ac:spMkLst>
            <pc:docMk/>
            <pc:sldMk cId="3299870256" sldId="301"/>
            <ac:spMk id="526" creationId="{7150DCAB-0E6C-B67D-824B-2033EDAB459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2" creationId="{A657FCEA-4FF8-EBB9-EA2E-5DE85F99CD4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3" creationId="{268130D2-72A5-6320-96B4-4CEC51FC0D9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4" creationId="{190E084B-4D3B-EE22-4F06-58112F5111B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5" creationId="{3821EC33-988D-5E7A-366D-8526840CF9CB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580" creationId="{7792413A-1C5F-F801-4015-D5F0C3EBE6AD}"/>
          </ac:spMkLst>
        </pc:spChg>
        <pc:spChg chg="mod topLvl">
          <ac:chgData name="Go" userId="b11a5121-062d-4360-8951-d081ad96d999" providerId="ADAL" clId="{A37B11FE-7E2B-4B71-9282-AB38B86228CA}" dt="2022-10-14T01:36:06.800" v="1309" actId="164"/>
          <ac:spMkLst>
            <pc:docMk/>
            <pc:sldMk cId="3299870256" sldId="301"/>
            <ac:spMk id="585" creationId="{E23D58ED-5C8D-3D42-D41C-1749190240B7}"/>
          </ac:spMkLst>
        </pc:spChg>
        <pc:spChg chg="mod">
          <ac:chgData name="Go" userId="b11a5121-062d-4360-8951-d081ad96d999" providerId="ADAL" clId="{A37B11FE-7E2B-4B71-9282-AB38B86228CA}" dt="2022-10-13T20:12:06.081" v="648" actId="1035"/>
          <ac:spMkLst>
            <pc:docMk/>
            <pc:sldMk cId="3299870256" sldId="301"/>
            <ac:spMk id="586" creationId="{205EBF96-3975-9EBB-82BF-524229ADCA56}"/>
          </ac:spMkLst>
        </pc:spChg>
        <pc:spChg chg="mod topLvl">
          <ac:chgData name="Go" userId="b11a5121-062d-4360-8951-d081ad96d999" providerId="ADAL" clId="{A37B11FE-7E2B-4B71-9282-AB38B86228CA}" dt="2022-10-14T01:36:21.436" v="1316" actId="164"/>
          <ac:spMkLst>
            <pc:docMk/>
            <pc:sldMk cId="3299870256" sldId="301"/>
            <ac:spMk id="588" creationId="{A32DF1B7-4FEE-A5A9-0149-91E988297B3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0" creationId="{AA06D570-6CA8-78A8-4078-0DCECA1A291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1" creationId="{DAF03CD4-6585-0520-B5E5-596E496FC8D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2" creationId="{68E2104F-A94A-2856-1246-CD9535F3C81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3" creationId="{73CD0F0F-1DC2-2D06-FBAB-0AD204A2C89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4" creationId="{7AC4DDB0-14D2-7C48-BB54-FD55593DF77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5" creationId="{A38E2007-370C-1F1D-947C-193A8785E42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6" creationId="{D90BAA66-82BF-AB0E-F44E-A36937766776}"/>
          </ac:spMkLst>
        </pc:spChg>
        <pc:spChg chg="mod topLvl">
          <ac:chgData name="Go" userId="b11a5121-062d-4360-8951-d081ad96d999" providerId="ADAL" clId="{A37B11FE-7E2B-4B71-9282-AB38B86228CA}" dt="2022-10-14T01:45:09.381" v="1323" actId="553"/>
          <ac:spMkLst>
            <pc:docMk/>
            <pc:sldMk cId="3299870256" sldId="301"/>
            <ac:spMk id="597" creationId="{E6292181-C7C6-4CF8-A805-A931E21A76A1}"/>
          </ac:spMkLst>
        </pc:spChg>
        <pc:spChg chg="del mod topLvl">
          <ac:chgData name="Go" userId="b11a5121-062d-4360-8951-d081ad96d999" providerId="ADAL" clId="{A37B11FE-7E2B-4B71-9282-AB38B86228CA}" dt="2022-10-13T20:44:50.671" v="1174" actId="478"/>
          <ac:spMkLst>
            <pc:docMk/>
            <pc:sldMk cId="3299870256" sldId="301"/>
            <ac:spMk id="599" creationId="{E3E9E340-698C-4C41-C51F-F9688B6E4A7B}"/>
          </ac:spMkLst>
        </pc:spChg>
        <pc:spChg chg="mod topLvl">
          <ac:chgData name="Go" userId="b11a5121-062d-4360-8951-d081ad96d999" providerId="ADAL" clId="{A37B11FE-7E2B-4B71-9282-AB38B86228CA}" dt="2022-10-14T01:36:20.178" v="1315" actId="164"/>
          <ac:spMkLst>
            <pc:docMk/>
            <pc:sldMk cId="3299870256" sldId="301"/>
            <ac:spMk id="600" creationId="{25A313C0-ED4F-B2AC-AA3D-FC9850323AB4}"/>
          </ac:spMkLst>
        </pc:spChg>
        <pc:spChg chg="mod topLvl">
          <ac:chgData name="Go" userId="b11a5121-062d-4360-8951-d081ad96d999" providerId="ADAL" clId="{A37B11FE-7E2B-4B71-9282-AB38B86228CA}" dt="2022-10-14T01:36:05.499" v="1308" actId="164"/>
          <ac:spMkLst>
            <pc:docMk/>
            <pc:sldMk cId="3299870256" sldId="301"/>
            <ac:spMk id="601" creationId="{A697E26C-8009-3F24-4E68-358C8DEF8C11}"/>
          </ac:spMkLst>
        </pc:spChg>
        <pc:spChg chg="mod topLvl">
          <ac:chgData name="Go" userId="b11a5121-062d-4360-8951-d081ad96d999" providerId="ADAL" clId="{A37B11FE-7E2B-4B71-9282-AB38B86228CA}" dt="2022-10-14T01:36:14.970" v="1314" actId="164"/>
          <ac:spMkLst>
            <pc:docMk/>
            <pc:sldMk cId="3299870256" sldId="301"/>
            <ac:spMk id="603" creationId="{020F0874-AAB1-362B-9A95-E64C15A3E8FA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04" creationId="{7A9BDA8B-9DBA-9769-D99B-EFE7737C9653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07" creationId="{722E467E-3687-BA7D-239B-1BF6CF2A196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19" creationId="{449E51EC-10A4-27BD-9A52-B3764E537BC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1" creationId="{CD1F8E55-9517-768F-F486-09E3E8CD212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2" creationId="{34E3AA86-8CB3-AEFE-8E81-B5D67BC7EA6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3" creationId="{8C025F04-1C7C-D904-4E2F-58041B5E43F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4" creationId="{056594E1-727B-F8A1-7873-ACB7CE51EE0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5" creationId="{2DEC7FC4-B77B-41B9-39FB-F34AC4A598DE}"/>
          </ac:spMkLst>
        </pc:spChg>
        <pc:spChg chg="mod topLvl">
          <ac:chgData name="Go" userId="b11a5121-062d-4360-8951-d081ad96d999" providerId="ADAL" clId="{A37B11FE-7E2B-4B71-9282-AB38B86228CA}" dt="2022-10-15T01:45:25.502" v="1479" actId="20577"/>
          <ac:spMkLst>
            <pc:docMk/>
            <pc:sldMk cId="3299870256" sldId="301"/>
            <ac:spMk id="627" creationId="{BB631823-0DC3-5C1A-041D-A50258A2A6BF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28" creationId="{31E8D49C-35CD-EDF2-DC82-42A21F575D80}"/>
          </ac:spMkLst>
        </pc:spChg>
        <pc:spChg chg="mod topLvl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9" creationId="{F9EE2836-7AC4-31A7-0E13-A86BEF57BE09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30" creationId="{F103AB24-EC14-CA9C-C4C8-EE62809B3B01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31" creationId="{2D9A61C5-B110-F215-6EE2-F5FA5C51E266}"/>
          </ac:spMkLst>
        </pc:spChg>
        <pc:spChg chg="mod topLvl">
          <ac:chgData name="Go" userId="b11a5121-062d-4360-8951-d081ad96d999" providerId="ADAL" clId="{A37B11FE-7E2B-4B71-9282-AB38B86228CA}" dt="2022-10-15T01:45:21.181" v="1476" actId="20577"/>
          <ac:spMkLst>
            <pc:docMk/>
            <pc:sldMk cId="3299870256" sldId="301"/>
            <ac:spMk id="633" creationId="{54DFD1DA-06A8-DAA2-E105-226D1953D5D8}"/>
          </ac:spMkLst>
        </pc:spChg>
        <pc:grpChg chg="mod topLvl">
          <ac:chgData name="Go" userId="b11a5121-062d-4360-8951-d081ad96d999" providerId="ADAL" clId="{A37B11FE-7E2B-4B71-9282-AB38B86228CA}" dt="2022-10-14T00:58:14.953" v="1205" actId="1037"/>
          <ac:grpSpMkLst>
            <pc:docMk/>
            <pc:sldMk cId="3299870256" sldId="301"/>
            <ac:grpSpMk id="3" creationId="{3A15472C-E09F-4095-A18E-A09C1E12E157}"/>
          </ac:grpSpMkLst>
        </pc:grpChg>
        <pc:grpChg chg="mod">
          <ac:chgData name="Go" userId="b11a5121-062d-4360-8951-d081ad96d999" providerId="ADAL" clId="{A37B11FE-7E2B-4B71-9282-AB38B86228CA}" dt="2022-10-14T00:58:02.932" v="1200" actId="553"/>
          <ac:grpSpMkLst>
            <pc:docMk/>
            <pc:sldMk cId="3299870256" sldId="301"/>
            <ac:grpSpMk id="4" creationId="{2D984CF2-E6E5-BE37-045A-A523D153C1F2}"/>
          </ac:grpSpMkLst>
        </pc:grpChg>
        <pc:grpChg chg="mod topLvl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5" creationId="{1388BBF7-D2F6-5B7B-E265-EEFCCE948918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6" creationId="{EFB1E376-C984-27E2-D7BA-ECC00BD555CB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8" creationId="{88008BFA-7955-448B-7576-35EA5B302522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9" creationId="{6DD48C8D-2E56-FC23-39A6-9849EF8614D1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0" creationId="{22BC352B-0776-C75B-AFCE-B2F4DA4B02D1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3" creationId="{1E099AC9-B6D4-462F-43ED-2B932B9309F3}"/>
          </ac:grpSpMkLst>
        </pc:grpChg>
        <pc:grpChg chg="mod">
          <ac:chgData name="Go" userId="b11a5121-062d-4360-8951-d081ad96d999" providerId="ADAL" clId="{A37B11FE-7E2B-4B71-9282-AB38B86228CA}" dt="2022-10-14T00:58:02.932" v="1200" actId="553"/>
          <ac:grpSpMkLst>
            <pc:docMk/>
            <pc:sldMk cId="3299870256" sldId="301"/>
            <ac:grpSpMk id="14" creationId="{9F868A2D-1438-4051-AF94-B48BE5A5D4A5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5" creationId="{EB21658D-98D4-B8CE-DB71-377C482A4C78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17" creationId="{93C19B69-5A22-1796-D34A-E0CFBF4D2942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8" creationId="{6AEEC1AF-D955-9805-31DF-521E0F8EECF7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9" creationId="{DCFDA3C9-95DA-84E5-B03B-630323BBD700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20" creationId="{E21F8CEC-E83B-F070-D777-299FA4EAFA32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2" creationId="{263E61ED-5421-DE06-B82D-EE1732F3DA77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3" creationId="{65B76B05-D1BD-E06F-2690-D36B4A3C1298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5" creationId="{08034CE4-3BE0-82C9-E197-E68BA40F9FFB}"/>
          </ac:grpSpMkLst>
        </pc:grpChg>
        <pc:grpChg chg="add del mod">
          <ac:chgData name="Go" userId="b11a5121-062d-4360-8951-d081ad96d999" providerId="ADAL" clId="{A37B11FE-7E2B-4B71-9282-AB38B86228CA}" dt="2022-10-13T19:25:12.606" v="201" actId="165"/>
          <ac:grpSpMkLst>
            <pc:docMk/>
            <pc:sldMk cId="3299870256" sldId="301"/>
            <ac:grpSpMk id="26" creationId="{3A610986-9E30-7E86-865F-33685AA918A1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7" creationId="{9722C1A9-94D4-550D-27FD-D9A371E8B1B3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28" creationId="{4C3A9C18-AA41-2261-76B8-6A3AF44FBB04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9" creationId="{A7DDF06A-382C-6CD8-C3E3-BE0952D0724E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30" creationId="{DE657C15-C591-D2D6-7331-C3DA2583BEC7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31" creationId="{1B170842-CD20-41D8-BECA-DB0F71589DFC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34" creationId="{5CBAE8C0-4B65-AE6B-5DF5-74957DC4BC0F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35" creationId="{3B5D5338-4068-0B8B-9A3F-750DB95A2FDC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40" creationId="{DA83DE12-C34C-C77E-7C63-AF20E33CF15F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41" creationId="{5A65F7AC-5AE9-8CE2-C5A0-43547C8A0C96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42" creationId="{B7ABF30E-0DAA-79EC-3373-2A1384ED35EE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5" creationId="{CA2DC73B-0DCA-BD1A-690E-97E31DECD1A1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6" creationId="{D1FC1DCA-D234-F33B-B943-D3EC23252ADD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8" creationId="{9FBB999A-C9A9-63E3-4497-9E82FE676455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49" creationId="{229C6446-E3E8-E694-9D74-5E2F97B0E3BC}"/>
          </ac:grpSpMkLst>
        </pc:grpChg>
        <pc:grpChg chg="mod">
          <ac:chgData name="Go" userId="b11a5121-062d-4360-8951-d081ad96d999" providerId="ADAL" clId="{A37B11FE-7E2B-4B71-9282-AB38B86228CA}" dt="2022-10-13T19:37:57.744" v="281" actId="164"/>
          <ac:grpSpMkLst>
            <pc:docMk/>
            <pc:sldMk cId="3299870256" sldId="301"/>
            <ac:grpSpMk id="50" creationId="{2494B6E0-8512-E611-C1B9-FB4744D3EE43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52" creationId="{48E7B0E3-D283-8BA1-1AFA-8DE42C102D2F}"/>
          </ac:grpSpMkLst>
        </pc:grpChg>
        <pc:grpChg chg="mod topLvl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54" creationId="{E0F5D351-A7F5-BEAB-DA1C-80547F9DD3E0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58" creationId="{50A49278-9C09-11F2-7571-2FABA095C600}"/>
          </ac:grpSpMkLst>
        </pc:grpChg>
        <pc:grpChg chg="mod">
          <ac:chgData name="Go" userId="b11a5121-062d-4360-8951-d081ad96d999" providerId="ADAL" clId="{A37B11FE-7E2B-4B71-9282-AB38B86228CA}" dt="2022-10-13T19:42:29.526" v="330" actId="164"/>
          <ac:grpSpMkLst>
            <pc:docMk/>
            <pc:sldMk cId="3299870256" sldId="301"/>
            <ac:grpSpMk id="59" creationId="{6C9199C7-9E8F-87D8-5B0D-213EBCB0BABD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2" creationId="{C8E36A41-226C-3052-0ADB-0BB617BAD256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29" creationId="{89124929-017B-F717-C116-73761B755524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0" creationId="{2B0E73FB-59F0-E7D2-0310-1FD156327979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1" creationId="{5EA6E0E4-6A72-08B5-0EB1-47721D704954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5" creationId="{A265201B-D5B5-EEB9-D592-E9EF89CB9301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6" creationId="{660071C4-AF1A-F11A-7193-C5071E39C7E7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7" creationId="{6ED48973-95E0-357D-AC36-20D3666319FF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8" creationId="{C1E8B024-5731-5476-C6B6-95AA4CAD3B03}"/>
          </ac:grpSpMkLst>
        </pc:grpChg>
        <pc:grpChg chg="add del mod">
          <ac:chgData name="Go" userId="b11a5121-062d-4360-8951-d081ad96d999" providerId="ADAL" clId="{A37B11FE-7E2B-4B71-9282-AB38B86228CA}" dt="2022-10-14T00:59:40.964" v="1240" actId="165"/>
          <ac:grpSpMkLst>
            <pc:docMk/>
            <pc:sldMk cId="3299870256" sldId="301"/>
            <ac:grpSpMk id="148" creationId="{DA943FAE-201F-B1F7-CF56-BE6899E04EDE}"/>
          </ac:grpSpMkLst>
        </pc:grpChg>
        <pc:grpChg chg="add del mod">
          <ac:chgData name="Go" userId="b11a5121-062d-4360-8951-d081ad96d999" providerId="ADAL" clId="{A37B11FE-7E2B-4B71-9282-AB38B86228CA}" dt="2022-10-13T19:29:13.781" v="260" actId="478"/>
          <ac:grpSpMkLst>
            <pc:docMk/>
            <pc:sldMk cId="3299870256" sldId="301"/>
            <ac:grpSpMk id="149" creationId="{D3A98D2F-2446-214B-B826-9BB044E14D15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50" creationId="{05F86C2F-640D-E1D5-36EB-E6E50B8C3F91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58" creationId="{20C4011F-06A5-AD21-717D-E7DCFB5938BD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59" creationId="{888587E8-F72F-7AE3-6E49-39A5F6F39D88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0" creationId="{2503A332-E3D4-87E9-47D4-A2C1195791C6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1" creationId="{81FB3C0B-C61C-C430-93FB-1E80A877F9F6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2" creationId="{BACCF2D1-C048-E0F7-D0DD-15E11C95356C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3" creationId="{4A37BA4A-52DE-625C-3261-8EE61324ED0F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6" creationId="{AF619EF9-F673-DAA6-00F8-12297E94F047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7" creationId="{D0DA96D6-88AB-3185-11D5-A333C067C9B4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8" creationId="{03B504D3-9D18-15FC-01FA-6B74980B0B97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9" creationId="{7A29E34A-835F-0AE1-F6A4-8483D9010DE9}"/>
          </ac:grpSpMkLst>
        </pc:grpChg>
        <pc:grpChg chg="add del 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193" creationId="{89CCBB04-7A77-C318-6C19-2E834C00AD68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03" creationId="{CA055B1A-29F7-78DE-2EA1-2873F4ABC67E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17" creationId="{00040F81-2DC4-3E38-9036-FC1F1F38BE7F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24" creationId="{71E7D225-FA66-432D-8FC6-B6242D429D47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25" creationId="{BD3B101C-4210-8AF9-1348-81B31A70C4A5}"/>
          </ac:grpSpMkLst>
        </pc:grpChg>
        <pc:grpChg chg="add del mod">
          <ac:chgData name="Go" userId="b11a5121-062d-4360-8951-d081ad96d999" providerId="ADAL" clId="{A37B11FE-7E2B-4B71-9282-AB38B86228CA}" dt="2022-10-14T02:29:48.593" v="1455" actId="165"/>
          <ac:grpSpMkLst>
            <pc:docMk/>
            <pc:sldMk cId="3299870256" sldId="301"/>
            <ac:grpSpMk id="240" creationId="{BED4C65C-1302-ADDD-5052-6C97109E5888}"/>
          </ac:grpSpMkLst>
        </pc:grpChg>
        <pc:grpChg chg="add del mod">
          <ac:chgData name="Go" userId="b11a5121-062d-4360-8951-d081ad96d999" providerId="ADAL" clId="{A37B11FE-7E2B-4B71-9282-AB38B86228CA}" dt="2022-10-13T20:37:40.069" v="1073" actId="21"/>
          <ac:grpSpMkLst>
            <pc:docMk/>
            <pc:sldMk cId="3299870256" sldId="301"/>
            <ac:grpSpMk id="259" creationId="{06052E30-B50E-1C14-3C48-1E6384204462}"/>
          </ac:grpSpMkLst>
        </pc:grpChg>
        <pc:grpChg chg="add del mod">
          <ac:chgData name="Go" userId="b11a5121-062d-4360-8951-d081ad96d999" providerId="ADAL" clId="{A37B11FE-7E2B-4B71-9282-AB38B86228CA}" dt="2022-10-13T20:37:40.069" v="1073" actId="21"/>
          <ac:grpSpMkLst>
            <pc:docMk/>
            <pc:sldMk cId="3299870256" sldId="301"/>
            <ac:grpSpMk id="260" creationId="{DB986CF1-E1A6-C8BC-4A2D-B9BF80A0EBDC}"/>
          </ac:grpSpMkLst>
        </pc:grpChg>
        <pc:grpChg chg="add del 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261" creationId="{BD2AFFE4-E983-4043-6794-C32D45ACD43C}"/>
          </ac:grpSpMkLst>
        </pc:grpChg>
        <pc:grpChg chg="add del 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62" creationId="{61B0BC72-812D-A231-D96A-F6087C5E3EE6}"/>
          </ac:grpSpMkLst>
        </pc:grpChg>
        <pc:grpChg chg="add del mod">
          <ac:chgData name="Go" userId="b11a5121-062d-4360-8951-d081ad96d999" providerId="ADAL" clId="{A37B11FE-7E2B-4B71-9282-AB38B86228CA}" dt="2022-10-14T01:01:34.453" v="1259" actId="478"/>
          <ac:grpSpMkLst>
            <pc:docMk/>
            <pc:sldMk cId="3299870256" sldId="301"/>
            <ac:grpSpMk id="263" creationId="{B0AC73BE-6F55-4723-14F2-ADCD102BA898}"/>
          </ac:grpSpMkLst>
        </pc:grpChg>
        <pc:grpChg chg="add del mod">
          <ac:chgData name="Go" userId="b11a5121-062d-4360-8951-d081ad96d999" providerId="ADAL" clId="{A37B11FE-7E2B-4B71-9282-AB38B86228CA}" dt="2022-10-14T01:01:29.443" v="1258" actId="478"/>
          <ac:grpSpMkLst>
            <pc:docMk/>
            <pc:sldMk cId="3299870256" sldId="301"/>
            <ac:grpSpMk id="264" creationId="{68282E87-717A-8666-E037-BFEC9228F9BE}"/>
          </ac:grpSpMkLst>
        </pc:grpChg>
        <pc:grpChg chg="mod topLvl">
          <ac:chgData name="Go" userId="b11a5121-062d-4360-8951-d081ad96d999" providerId="ADAL" clId="{A37B11FE-7E2B-4B71-9282-AB38B86228CA}" dt="2022-10-14T00:57:24.470" v="1194" actId="1038"/>
          <ac:grpSpMkLst>
            <pc:docMk/>
            <pc:sldMk cId="3299870256" sldId="301"/>
            <ac:grpSpMk id="265" creationId="{58D7A5F3-D98F-4285-EE18-1B7425AB048A}"/>
          </ac:grpSpMkLst>
        </pc:grpChg>
        <pc:grpChg chg="add del 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266" creationId="{FDD02D53-F9C4-E829-3548-2F53BFBEF7F5}"/>
          </ac:grpSpMkLst>
        </pc:grpChg>
        <pc:grpChg chg="add del mod">
          <ac:chgData name="Go" userId="b11a5121-062d-4360-8951-d081ad96d999" providerId="ADAL" clId="{A37B11FE-7E2B-4B71-9282-AB38B86228CA}" dt="2022-10-13T19:57:57.841" v="482" actId="165"/>
          <ac:grpSpMkLst>
            <pc:docMk/>
            <pc:sldMk cId="3299870256" sldId="301"/>
            <ac:grpSpMk id="267" creationId="{D4E4A787-B943-BF86-3346-2D6278942CFC}"/>
          </ac:grpSpMkLst>
        </pc:grpChg>
        <pc:grpChg chg="del mod topLvl">
          <ac:chgData name="Go" userId="b11a5121-062d-4360-8951-d081ad96d999" providerId="ADAL" clId="{A37B11FE-7E2B-4B71-9282-AB38B86228CA}" dt="2022-10-13T19:58:04.305" v="483" actId="165"/>
          <ac:grpSpMkLst>
            <pc:docMk/>
            <pc:sldMk cId="3299870256" sldId="301"/>
            <ac:grpSpMk id="274" creationId="{875AD099-F79F-5547-17A1-3CB1F0DE0D7D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5" creationId="{2158226A-2A85-E602-9A30-79BEBEA3D320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6" creationId="{114847D3-18A6-759B-AE6B-087468152E16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7" creationId="{11523D18-64A6-16B0-416E-2EAD11284048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8" creationId="{AB8DEA19-BAE1-4C09-BCA8-37C2A07CE1ED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9" creationId="{280A69EF-3FA3-42BF-A3BF-970EC68C35C7}"/>
          </ac:grpSpMkLst>
        </pc:grpChg>
        <pc:grpChg chg="add del mod">
          <ac:chgData name="Go" userId="b11a5121-062d-4360-8951-d081ad96d999" providerId="ADAL" clId="{A37B11FE-7E2B-4B71-9282-AB38B86228CA}" dt="2022-10-14T01:01:29.443" v="1258" actId="478"/>
          <ac:grpSpMkLst>
            <pc:docMk/>
            <pc:sldMk cId="3299870256" sldId="301"/>
            <ac:grpSpMk id="292" creationId="{A8D94023-2F40-FAB7-4B38-1E6FEAAB6C72}"/>
          </ac:grpSpMkLst>
        </pc:grpChg>
        <pc:grpChg chg="add del mod">
          <ac:chgData name="Go" userId="b11a5121-062d-4360-8951-d081ad96d999" providerId="ADAL" clId="{A37B11FE-7E2B-4B71-9282-AB38B86228CA}" dt="2022-10-13T20:09:47.735" v="627"/>
          <ac:grpSpMkLst>
            <pc:docMk/>
            <pc:sldMk cId="3299870256" sldId="301"/>
            <ac:grpSpMk id="293" creationId="{B1964AB4-0E69-E994-4026-A46804A76D72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6" creationId="{FC6F99FC-79C9-2209-7971-392B413549E2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7" creationId="{B0D4C18E-3363-8B56-22FE-A41267AA89FC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8" creationId="{1BB8B353-3D71-2B26-8968-183486501540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9" creationId="{52A52DF8-7456-73AB-62E4-82D75F8C0E88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300" creationId="{A5F6D758-F059-6A13-B942-EB95B8D109E7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301" creationId="{FC5468B3-7BDA-852D-9EB3-4C3821F961B5}"/>
          </ac:grpSpMkLst>
        </pc:grpChg>
        <pc:grpChg chg="add del mod">
          <ac:chgData name="Go" userId="b11a5121-062d-4360-8951-d081ad96d999" providerId="ADAL" clId="{A37B11FE-7E2B-4B71-9282-AB38B86228CA}" dt="2022-10-13T20:09:58.048" v="631" actId="165"/>
          <ac:grpSpMkLst>
            <pc:docMk/>
            <pc:sldMk cId="3299870256" sldId="301"/>
            <ac:grpSpMk id="314" creationId="{898D394D-672C-000D-342D-400772054CE8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5" creationId="{9DF2153F-54CF-41D9-92CA-304D9C0F4E19}"/>
          </ac:grpSpMkLst>
        </pc:grpChg>
        <pc:grpChg chg="mod topLvl">
          <ac:chgData name="Go" userId="b11a5121-062d-4360-8951-d081ad96d999" providerId="ADAL" clId="{A37B11FE-7E2B-4B71-9282-AB38B86228CA}" dt="2022-10-13T20:11:40.162" v="640" actId="164"/>
          <ac:grpSpMkLst>
            <pc:docMk/>
            <pc:sldMk cId="3299870256" sldId="301"/>
            <ac:grpSpMk id="316" creationId="{58532A4C-F9CD-9019-825E-0C65A6314E0C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7" creationId="{F03F37D9-D1DC-8D1E-1E1F-0E4F3AD1A154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8" creationId="{3A39B59E-48B3-8BE2-1987-B615FF746E62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9" creationId="{6E199C07-D00E-0C25-D136-995E9A39EAF9}"/>
          </ac:grpSpMkLst>
        </pc:grpChg>
        <pc:grpChg chg="add mod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36" creationId="{DCE78AD3-C711-3E16-3E7F-D857F61DDA9B}"/>
          </ac:grpSpMkLst>
        </pc:grpChg>
        <pc:grpChg chg="add mod topLvl">
          <ac:chgData name="Go" userId="b11a5121-062d-4360-8951-d081ad96d999" providerId="ADAL" clId="{A37B11FE-7E2B-4B71-9282-AB38B86228CA}" dt="2022-10-14T01:00:33.659" v="1248" actId="1076"/>
          <ac:grpSpMkLst>
            <pc:docMk/>
            <pc:sldMk cId="3299870256" sldId="301"/>
            <ac:grpSpMk id="337" creationId="{A592923E-902B-1B0D-72C1-7CA0B9A4BB1C}"/>
          </ac:grpSpMkLst>
        </pc:grpChg>
        <pc:grpChg chg="add del mod">
          <ac:chgData name="Go" userId="b11a5121-062d-4360-8951-d081ad96d999" providerId="ADAL" clId="{A37B11FE-7E2B-4B71-9282-AB38B86228CA}" dt="2022-10-13T20:37:11.999" v="1065" actId="478"/>
          <ac:grpSpMkLst>
            <pc:docMk/>
            <pc:sldMk cId="3299870256" sldId="301"/>
            <ac:grpSpMk id="339" creationId="{6676A960-59B6-7C0B-035C-8F4BE41BEDAA}"/>
          </ac:grpSpMkLst>
        </pc:grpChg>
        <pc:grpChg chg="add del mod">
          <ac:chgData name="Go" userId="b11a5121-062d-4360-8951-d081ad96d999" providerId="ADAL" clId="{A37B11FE-7E2B-4B71-9282-AB38B86228CA}" dt="2022-10-13T20:24:09.931" v="865" actId="165"/>
          <ac:grpSpMkLst>
            <pc:docMk/>
            <pc:sldMk cId="3299870256" sldId="301"/>
            <ac:grpSpMk id="340" creationId="{671D36F8-D555-942C-3E5D-AAA35E59A0A4}"/>
          </ac:grpSpMkLst>
        </pc:grpChg>
        <pc:grpChg chg="mod topLvl">
          <ac:chgData name="Go" userId="b11a5121-062d-4360-8951-d081ad96d999" providerId="ADAL" clId="{A37B11FE-7E2B-4B71-9282-AB38B86228CA}" dt="2022-10-13T20:27:28.335" v="982" actId="164"/>
          <ac:grpSpMkLst>
            <pc:docMk/>
            <pc:sldMk cId="3299870256" sldId="301"/>
            <ac:grpSpMk id="346" creationId="{E3EC0F57-23A8-8FFB-0A67-17581C852908}"/>
          </ac:grpSpMkLst>
        </pc:grpChg>
        <pc:grpChg chg="mod topLvl">
          <ac:chgData name="Go" userId="b11a5121-062d-4360-8951-d081ad96d999" providerId="ADAL" clId="{A37B11FE-7E2B-4B71-9282-AB38B86228CA}" dt="2022-10-13T20:27:28.335" v="982" actId="164"/>
          <ac:grpSpMkLst>
            <pc:docMk/>
            <pc:sldMk cId="3299870256" sldId="301"/>
            <ac:grpSpMk id="349" creationId="{2BA48B4E-73AD-40F9-7176-5EDE0323FA4B}"/>
          </ac:grpSpMkLst>
        </pc:grpChg>
        <pc:grpChg chg="mod topLvl">
          <ac:chgData name="Go" userId="b11a5121-062d-4360-8951-d081ad96d999" providerId="ADAL" clId="{A37B11FE-7E2B-4B71-9282-AB38B86228CA}" dt="2022-10-13T20:27:28.335" v="982" actId="164"/>
          <ac:grpSpMkLst>
            <pc:docMk/>
            <pc:sldMk cId="3299870256" sldId="301"/>
            <ac:grpSpMk id="350" creationId="{B1B0CBD4-0FAD-2780-2395-1FB3557AB250}"/>
          </ac:grpSpMkLst>
        </pc:grpChg>
        <pc:grpChg chg="del mod topLvl">
          <ac:chgData name="Go" userId="b11a5121-062d-4360-8951-d081ad96d999" providerId="ADAL" clId="{A37B11FE-7E2B-4B71-9282-AB38B86228CA}" dt="2022-10-13T20:27:13.878" v="979" actId="165"/>
          <ac:grpSpMkLst>
            <pc:docMk/>
            <pc:sldMk cId="3299870256" sldId="301"/>
            <ac:grpSpMk id="351" creationId="{47D789D8-FE9C-BF73-69A9-D6B8EA12AA0E}"/>
          </ac:grpSpMkLst>
        </pc:grpChg>
        <pc:grpChg chg="del mod topLvl">
          <ac:chgData name="Go" userId="b11a5121-062d-4360-8951-d081ad96d999" providerId="ADAL" clId="{A37B11FE-7E2B-4B71-9282-AB38B86228CA}" dt="2022-10-13T20:27:13.878" v="979" actId="165"/>
          <ac:grpSpMkLst>
            <pc:docMk/>
            <pc:sldMk cId="3299870256" sldId="301"/>
            <ac:grpSpMk id="352" creationId="{C52075DA-F236-C5A1-FFCF-53173DA2EF5D}"/>
          </ac:grpSpMkLst>
        </pc:grpChg>
        <pc:grpChg chg="add mod">
          <ac:chgData name="Go" userId="b11a5121-062d-4360-8951-d081ad96d999" providerId="ADAL" clId="{A37B11FE-7E2B-4B71-9282-AB38B86228CA}" dt="2022-10-14T00:58:24.463" v="1206" actId="1036"/>
          <ac:grpSpMkLst>
            <pc:docMk/>
            <pc:sldMk cId="3299870256" sldId="301"/>
            <ac:grpSpMk id="374" creationId="{AAF6BCB0-A71D-E66D-E543-E248480A65DC}"/>
          </ac:grpSpMkLst>
        </pc:grpChg>
        <pc:grpChg chg="add del mod">
          <ac:chgData name="Go" userId="b11a5121-062d-4360-8951-d081ad96d999" providerId="ADAL" clId="{A37B11FE-7E2B-4B71-9282-AB38B86228CA}" dt="2022-10-14T01:34:22.952" v="1296" actId="165"/>
          <ac:grpSpMkLst>
            <pc:docMk/>
            <pc:sldMk cId="3299870256" sldId="301"/>
            <ac:grpSpMk id="378" creationId="{5FFF24B6-C87F-CBE8-3E41-3B9ED19D81C8}"/>
          </ac:grpSpMkLst>
        </pc:grpChg>
        <pc:grpChg chg="add del mod">
          <ac:chgData name="Go" userId="b11a5121-062d-4360-8951-d081ad96d999" providerId="ADAL" clId="{A37B11FE-7E2B-4B71-9282-AB38B86228CA}" dt="2022-10-14T01:44:41.667" v="1318" actId="165"/>
          <ac:grpSpMkLst>
            <pc:docMk/>
            <pc:sldMk cId="3299870256" sldId="301"/>
            <ac:grpSpMk id="389" creationId="{25FC274A-B6D8-289C-446E-766DA1432518}"/>
          </ac:grpSpMkLst>
        </pc:grpChg>
        <pc:grpChg chg="add mod">
          <ac:chgData name="Go" userId="b11a5121-062d-4360-8951-d081ad96d999" providerId="ADAL" clId="{A37B11FE-7E2B-4B71-9282-AB38B86228CA}" dt="2022-10-14T01:36:05.499" v="1308" actId="164"/>
          <ac:grpSpMkLst>
            <pc:docMk/>
            <pc:sldMk cId="3299870256" sldId="301"/>
            <ac:grpSpMk id="390" creationId="{88B4357D-F221-0FB8-5451-F494353BCF01}"/>
          </ac:grpSpMkLst>
        </pc:grpChg>
        <pc:grpChg chg="add mod">
          <ac:chgData name="Go" userId="b11a5121-062d-4360-8951-d081ad96d999" providerId="ADAL" clId="{A37B11FE-7E2B-4B71-9282-AB38B86228CA}" dt="2022-10-14T01:36:06.800" v="1309" actId="164"/>
          <ac:grpSpMkLst>
            <pc:docMk/>
            <pc:sldMk cId="3299870256" sldId="301"/>
            <ac:grpSpMk id="391" creationId="{56F5E0E1-433B-E0CD-9B1A-609B3A9E497D}"/>
          </ac:grpSpMkLst>
        </pc:grpChg>
        <pc:grpChg chg="add mod">
          <ac:chgData name="Go" userId="b11a5121-062d-4360-8951-d081ad96d999" providerId="ADAL" clId="{A37B11FE-7E2B-4B71-9282-AB38B86228CA}" dt="2022-10-14T01:36:07.890" v="1310" actId="164"/>
          <ac:grpSpMkLst>
            <pc:docMk/>
            <pc:sldMk cId="3299870256" sldId="301"/>
            <ac:grpSpMk id="392" creationId="{F3D96FC1-C2D2-7B17-73F0-75EA30515C07}"/>
          </ac:grpSpMkLst>
        </pc:grpChg>
        <pc:grpChg chg="add del mod">
          <ac:chgData name="Go" userId="b11a5121-062d-4360-8951-d081ad96d999" providerId="ADAL" clId="{A37B11FE-7E2B-4B71-9282-AB38B86228CA}" dt="2022-10-14T01:44:41.667" v="1318" actId="165"/>
          <ac:grpSpMkLst>
            <pc:docMk/>
            <pc:sldMk cId="3299870256" sldId="301"/>
            <ac:grpSpMk id="393" creationId="{BB0A7282-2B13-93EF-0556-B0F550101E56}"/>
          </ac:grpSpMkLst>
        </pc:grpChg>
        <pc:grpChg chg="add mod">
          <ac:chgData name="Go" userId="b11a5121-062d-4360-8951-d081ad96d999" providerId="ADAL" clId="{A37B11FE-7E2B-4B71-9282-AB38B86228CA}" dt="2022-10-14T01:36:14.970" v="1314" actId="164"/>
          <ac:grpSpMkLst>
            <pc:docMk/>
            <pc:sldMk cId="3299870256" sldId="301"/>
            <ac:grpSpMk id="394" creationId="{ACAC60D1-21EC-ACB0-DEDE-C686500DE9BE}"/>
          </ac:grpSpMkLst>
        </pc:grpChg>
        <pc:grpChg chg="add mod">
          <ac:chgData name="Go" userId="b11a5121-062d-4360-8951-d081ad96d999" providerId="ADAL" clId="{A37B11FE-7E2B-4B71-9282-AB38B86228CA}" dt="2022-10-14T01:36:14.970" v="1314" actId="164"/>
          <ac:grpSpMkLst>
            <pc:docMk/>
            <pc:sldMk cId="3299870256" sldId="301"/>
            <ac:grpSpMk id="395" creationId="{1D1AE8C7-A0B7-49C4-EA03-8B8AC06968C1}"/>
          </ac:grpSpMkLst>
        </pc:grpChg>
        <pc:grpChg chg="add mod">
          <ac:chgData name="Go" userId="b11a5121-062d-4360-8951-d081ad96d999" providerId="ADAL" clId="{A37B11FE-7E2B-4B71-9282-AB38B86228CA}" dt="2022-10-14T01:36:20.178" v="1315" actId="164"/>
          <ac:grpSpMkLst>
            <pc:docMk/>
            <pc:sldMk cId="3299870256" sldId="301"/>
            <ac:grpSpMk id="396" creationId="{DB5C0BBC-03F2-39E0-1842-A4556752C54E}"/>
          </ac:grpSpMkLst>
        </pc:grpChg>
        <pc:grpChg chg="add mod">
          <ac:chgData name="Go" userId="b11a5121-062d-4360-8951-d081ad96d999" providerId="ADAL" clId="{A37B11FE-7E2B-4B71-9282-AB38B86228CA}" dt="2022-10-14T01:36:21.436" v="1316" actId="164"/>
          <ac:grpSpMkLst>
            <pc:docMk/>
            <pc:sldMk cId="3299870256" sldId="301"/>
            <ac:grpSpMk id="397" creationId="{B646B08F-FD34-C549-D704-3078D9996104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53" creationId="{5BAB4F1C-9B77-0EE4-3B0E-C89DF28CDA19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54" creationId="{9A5D5962-E869-7093-4002-36410AA5D696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464" creationId="{17C21720-62CF-2EB6-2C65-7D0429926D99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494" creationId="{5541D77E-146B-9CA5-ABC1-585250266CB6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68" creationId="{706C3840-D8CA-33D8-4500-9CF9E3C9CD63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73" creationId="{FBA6C53D-B473-F3A3-9284-0CA75D11F752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74" creationId="{09B9E57B-C211-879A-4E02-D57C8D7370D5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81" creationId="{4E21338A-FC59-5D0F-6590-E5BBA4062FCA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82" creationId="{8285CAB0-3863-6BEB-31C1-2CA27C7772CF}"/>
          </ac:grpSpMkLst>
        </pc:grpChg>
        <pc:grpChg chg="del mod topLvl">
          <ac:chgData name="Go" userId="b11a5121-062d-4360-8951-d081ad96d999" providerId="ADAL" clId="{A37B11FE-7E2B-4B71-9282-AB38B86228CA}" dt="2022-10-13T19:25:23.053" v="204" actId="165"/>
          <ac:grpSpMkLst>
            <pc:docMk/>
            <pc:sldMk cId="3299870256" sldId="301"/>
            <ac:grpSpMk id="583" creationId="{C172713A-54D7-22D0-035B-9E05CBD66C13}"/>
          </ac:grpSpMkLst>
        </pc:grpChg>
        <pc:grpChg chg="del mod topLvl">
          <ac:chgData name="Go" userId="b11a5121-062d-4360-8951-d081ad96d999" providerId="ADAL" clId="{A37B11FE-7E2B-4B71-9282-AB38B86228CA}" dt="2022-10-13T19:25:34.478" v="211" actId="165"/>
          <ac:grpSpMkLst>
            <pc:docMk/>
            <pc:sldMk cId="3299870256" sldId="301"/>
            <ac:grpSpMk id="605" creationId="{A1356258-CE95-6898-7C17-5897EA0D9115}"/>
          </ac:grpSpMkLst>
        </pc:grpChg>
        <pc:grpChg chg="del mod topLvl">
          <ac:chgData name="Go" userId="b11a5121-062d-4360-8951-d081ad96d999" providerId="ADAL" clId="{A37B11FE-7E2B-4B71-9282-AB38B86228CA}" dt="2022-10-13T19:25:34.478" v="211" actId="165"/>
          <ac:grpSpMkLst>
            <pc:docMk/>
            <pc:sldMk cId="3299870256" sldId="301"/>
            <ac:grpSpMk id="606" creationId="{20C45F35-C86C-5E72-B540-C0B86CD2C27F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09" creationId="{5933C05E-F357-C1AA-C0E5-AB0366B3323F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0" creationId="{9E51DE33-5F23-372E-E897-B37F4B9D38B7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1" creationId="{B5383931-008B-27A4-8551-928741CA87C8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2" creationId="{AA7BD866-A642-E072-CB03-E6EC90E03463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3" creationId="{384C9D67-922B-5FE4-F5BE-2EDEE970B4F6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4" creationId="{2A68A7DF-F9C9-5046-85AB-EC2E5E9C691E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5" creationId="{B51C6E7A-1939-D71C-0980-ADDC1E6F759A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6" creationId="{A235A10B-0046-850D-E367-6FAB78643C13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7" creationId="{479189AC-07BA-8F0E-3FB2-7C45473B6F09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8" creationId="{E1536666-8D1C-1255-C1E9-4C42CCAEDEF8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639" creationId="{1DE898C2-E809-2B55-CF57-DE7A01B03F65}"/>
          </ac:grpSpMkLst>
        </pc:grpChg>
        <pc:graphicFrameChg chg="mod">
          <ac:chgData name="Go" userId="b11a5121-062d-4360-8951-d081ad96d999" providerId="ADAL" clId="{A37B11FE-7E2B-4B71-9282-AB38B86228CA}" dt="2022-10-13T19:39:15.377" v="292" actId="164"/>
          <ac:graphicFrameMkLst>
            <pc:docMk/>
            <pc:sldMk cId="3299870256" sldId="301"/>
            <ac:graphicFrameMk id="2" creationId="{1AD00D3D-FBDC-C399-AE11-A003C5D2BB23}"/>
          </ac:graphicFrameMkLst>
        </pc:graphicFrameChg>
        <pc:graphicFrameChg chg="mod">
          <ac:chgData name="Go" userId="b11a5121-062d-4360-8951-d081ad96d999" providerId="ADAL" clId="{A37B11FE-7E2B-4B71-9282-AB38B86228CA}" dt="2022-10-14T00:57:07.779" v="1192" actId="165"/>
          <ac:graphicFrameMkLst>
            <pc:docMk/>
            <pc:sldMk cId="3299870256" sldId="301"/>
            <ac:graphicFrameMk id="7" creationId="{29619FA3-5320-80AE-05A1-1DFE07FA76AF}"/>
          </ac:graphicFrameMkLst>
        </pc:graphicFrameChg>
        <pc:graphicFrameChg chg="mod">
          <ac:chgData name="Go" userId="b11a5121-062d-4360-8951-d081ad96d999" providerId="ADAL" clId="{A37B11FE-7E2B-4B71-9282-AB38B86228CA}" dt="2022-10-13T19:37:44.577" v="276" actId="164"/>
          <ac:graphicFrameMkLst>
            <pc:docMk/>
            <pc:sldMk cId="3299870256" sldId="301"/>
            <ac:graphicFrameMk id="39" creationId="{A19956A4-38A4-0919-E076-3ECBAC5CB58A}"/>
          </ac:graphicFrameMkLst>
        </pc:graphicFrameChg>
        <pc:graphicFrameChg chg="mod topLvl">
          <ac:chgData name="Go" userId="b11a5121-062d-4360-8951-d081ad96d999" providerId="ADAL" clId="{A37B11FE-7E2B-4B71-9282-AB38B86228CA}" dt="2022-10-13T20:27:28.335" v="982" actId="164"/>
          <ac:graphicFrameMkLst>
            <pc:docMk/>
            <pc:sldMk cId="3299870256" sldId="301"/>
            <ac:graphicFrameMk id="341" creationId="{D64BF4A6-E3DC-8AAE-CAC2-318CE7EFEC5C}"/>
          </ac:graphicFrameMkLst>
        </pc:graphicFrameChg>
        <pc:picChg chg="mod topLvl">
          <ac:chgData name="Go" userId="b11a5121-062d-4360-8951-d081ad96d999" providerId="ADAL" clId="{A37B11FE-7E2B-4B71-9282-AB38B86228CA}" dt="2022-10-14T01:36:14.970" v="1314" actId="164"/>
          <ac:picMkLst>
            <pc:docMk/>
            <pc:sldMk cId="3299870256" sldId="301"/>
            <ac:picMk id="32" creationId="{2175B2CF-25CD-A072-BE64-BA372B9244D8}"/>
          </ac:picMkLst>
        </pc:picChg>
        <pc:picChg chg="mod topLvl">
          <ac:chgData name="Go" userId="b11a5121-062d-4360-8951-d081ad96d999" providerId="ADAL" clId="{A37B11FE-7E2B-4B71-9282-AB38B86228CA}" dt="2022-10-14T01:36:20.178" v="1315" actId="164"/>
          <ac:picMkLst>
            <pc:docMk/>
            <pc:sldMk cId="3299870256" sldId="301"/>
            <ac:picMk id="33" creationId="{86A53033-86F9-389C-04D5-9CD2C9AD01C7}"/>
          </ac:picMkLst>
        </pc:picChg>
        <pc:picChg chg="mod modCrop">
          <ac:chgData name="Go" userId="b11a5121-062d-4360-8951-d081ad96d999" providerId="ADAL" clId="{A37B11FE-7E2B-4B71-9282-AB38B86228CA}" dt="2022-10-13T20:31:51.861" v="1028" actId="732"/>
          <ac:picMkLst>
            <pc:docMk/>
            <pc:sldMk cId="3299870256" sldId="301"/>
            <ac:picMk id="57" creationId="{E1D85ABA-4B6A-4782-B82E-435A15947D01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1" creationId="{A560FC92-4919-4B14-889D-8C2914B72130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2" creationId="{9740845C-8279-4BED-92E8-8A0979FDFD33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3" creationId="{AE457A15-1519-464E-A3CE-71E3E325892C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7" creationId="{B94AD668-0A32-446F-BE51-E1497543E9EE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8" creationId="{A5F75C6C-B398-4E7A-812C-C7FBBC62310F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9" creationId="{75A60953-8AA9-4F02-B89B-EF8574966FFF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72" creationId="{FE95AE74-DC2E-9C0A-30F0-56061665B389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0" creationId="{599237E0-A6BA-B535-F78D-0455DD124D02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2" creationId="{E18B8620-6E4C-5622-6580-0071CB265FF6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4" creationId="{F9AD6C7D-96E2-2720-C7FF-986551E1E6EA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6" creationId="{37539F2F-9ABF-6C7B-B760-5A27B78D95CC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8" creationId="{FD7407D0-35C7-7024-0B01-1C8BD7630444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92" creationId="{F8D28C29-6038-2007-FEAB-6EE40969F86D}"/>
          </ac:picMkLst>
        </pc:picChg>
        <pc:picChg chg="mod topLvl">
          <ac:chgData name="Go" userId="b11a5121-062d-4360-8951-d081ad96d999" providerId="ADAL" clId="{A37B11FE-7E2B-4B71-9282-AB38B86228CA}" dt="2022-10-14T02:30:26.872" v="1461" actId="14100"/>
          <ac:picMkLst>
            <pc:docMk/>
            <pc:sldMk cId="3299870256" sldId="301"/>
            <ac:picMk id="195" creationId="{786CCD50-E8F9-E81C-0AAB-7EF8B6F3918F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05" creationId="{8E4A55A6-943E-0E63-1E18-354FD95B363A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07" creationId="{DEB24383-22A9-2F3E-6C00-9C29A0BCD65F}"/>
          </ac:picMkLst>
        </pc:picChg>
        <pc:picChg chg="mod topLvl">
          <ac:chgData name="Go" userId="b11a5121-062d-4360-8951-d081ad96d999" providerId="ADAL" clId="{A37B11FE-7E2B-4B71-9282-AB38B86228CA}" dt="2022-10-14T02:30:31.387" v="1462" actId="14100"/>
          <ac:picMkLst>
            <pc:docMk/>
            <pc:sldMk cId="3299870256" sldId="301"/>
            <ac:picMk id="209" creationId="{10C6B6B0-2782-E2D0-9480-48DD6CA69FB6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11" creationId="{3D276DC3-F7EE-8569-6F10-9547D39EEA9A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13" creationId="{8A301B36-7C95-FC89-871D-2FC646B973C1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27" creationId="{66CB2C0A-997F-312D-14F9-BB43C1C08538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1" creationId="{6225382C-CEA2-8A07-48CD-77F6215A93A1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4" creationId="{D28A80E1-93DF-7A66-672F-928AF1D25836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6" creationId="{36F5ED06-1E8C-AE34-A972-C9583CAC8862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8" creationId="{7D80C03B-9C9D-84CF-DC28-048A337FAFC3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0" creationId="{587F0235-90D0-252A-5423-E5932CB64E65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2" creationId="{A5809071-133E-E097-D812-5A37CE8B3451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4" creationId="{CFE60308-241A-5B01-3D08-548074367263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6" creationId="{AFCE8761-4598-82BE-E608-94FFCDAFE026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8" creationId="{FA1EF86B-68DA-C21E-D921-80FF67C57DD5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2" creationId="{87F1EA15-F692-1978-7957-6C6030F0498E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4" creationId="{1D4D6272-457D-FE94-E6ED-36CDD0772A4A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6" creationId="{9C796707-8624-499A-3CD4-02B4748A8439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8" creationId="{C2DEF756-D200-98E0-7B7E-8C3F707BD047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90" creationId="{30D2A285-EC12-EDAC-1CB7-BF966DCA26A2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04" creationId="{A5C76721-20CE-E278-3628-37B247E667C8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06" creationId="{DD9A4FDD-EAC9-697D-851C-564C4ECEF525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08" creationId="{4C2DB0C2-9CBE-8800-69E1-C9546D4CACA2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10" creationId="{C0752B75-EC16-5B4F-C37B-1BB57DAF4526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12" creationId="{2C0B7C10-41CD-6AF9-3FEF-6B44B3CCA843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2" creationId="{64E61B9D-ABF2-DE7F-925C-92920B46FACF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4" creationId="{4FDEBCD0-7D59-A5F4-FAD9-BA6DE364DDD8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6" creationId="{CA49994B-E184-710F-F726-327CBE43296C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8" creationId="{C814B21F-8DC9-978F-83D8-F85C32A134A7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30" creationId="{50AD55B5-1E68-D51D-B42E-75DC66E83D02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379" creationId="{D4146D48-93B6-2FF3-81E7-9C112A4B30F0}"/>
          </ac:picMkLst>
        </pc:picChg>
        <pc:picChg chg="add mod topLvl modCrop">
          <ac:chgData name="Go" userId="b11a5121-062d-4360-8951-d081ad96d999" providerId="ADAL" clId="{A37B11FE-7E2B-4B71-9282-AB38B86228CA}" dt="2022-10-14T01:44:56.252" v="1320" actId="14100"/>
          <ac:picMkLst>
            <pc:docMk/>
            <pc:sldMk cId="3299870256" sldId="301"/>
            <ac:picMk id="380" creationId="{52F0F89B-193D-9C05-F8CD-D3CE67ED10CC}"/>
          </ac:picMkLst>
        </pc:picChg>
        <pc:picChg chg="add del mod">
          <ac:chgData name="Go" userId="b11a5121-062d-4360-8951-d081ad96d999" providerId="ADAL" clId="{A37B11FE-7E2B-4B71-9282-AB38B86228CA}" dt="2022-10-14T01:32:09.215" v="1267" actId="478"/>
          <ac:picMkLst>
            <pc:docMk/>
            <pc:sldMk cId="3299870256" sldId="301"/>
            <ac:picMk id="384" creationId="{8F844B30-6FC6-CCC8-550D-FBE282D07090}"/>
          </ac:picMkLst>
        </pc:picChg>
        <pc:picChg chg="add del mod">
          <ac:chgData name="Go" userId="b11a5121-062d-4360-8951-d081ad96d999" providerId="ADAL" clId="{A37B11FE-7E2B-4B71-9282-AB38B86228CA}" dt="2022-10-14T01:33:20.994" v="1286" actId="478"/>
          <ac:picMkLst>
            <pc:docMk/>
            <pc:sldMk cId="3299870256" sldId="301"/>
            <ac:picMk id="385" creationId="{F44476F1-1B01-3154-6B83-BFD8E9F47CD8}"/>
          </ac:picMkLst>
        </pc:picChg>
        <pc:picChg chg="add mod modCrop">
          <ac:chgData name="Go" userId="b11a5121-062d-4360-8951-d081ad96d999" providerId="ADAL" clId="{A37B11FE-7E2B-4B71-9282-AB38B86228CA}" dt="2022-10-14T02:30:45.589" v="1464" actId="1076"/>
          <ac:picMkLst>
            <pc:docMk/>
            <pc:sldMk cId="3299870256" sldId="301"/>
            <ac:picMk id="399" creationId="{F9E2993B-1F21-94E2-522E-705FFE1F3AC0}"/>
          </ac:picMkLst>
        </pc:picChg>
        <pc:picChg chg="mod topLvl">
          <ac:chgData name="Go" userId="b11a5121-062d-4360-8951-d081ad96d999" providerId="ADAL" clId="{A37B11FE-7E2B-4B71-9282-AB38B86228CA}" dt="2022-10-14T01:36:07.890" v="1310" actId="164"/>
          <ac:picMkLst>
            <pc:docMk/>
            <pc:sldMk cId="3299870256" sldId="301"/>
            <ac:picMk id="575" creationId="{6BEBEA05-1D4B-5D31-DB0F-1C7C69F0773F}"/>
          </ac:picMkLst>
        </pc:picChg>
        <pc:picChg chg="mod topLvl">
          <ac:chgData name="Go" userId="b11a5121-062d-4360-8951-d081ad96d999" providerId="ADAL" clId="{A37B11FE-7E2B-4B71-9282-AB38B86228CA}" dt="2022-10-14T01:36:06.800" v="1309" actId="164"/>
          <ac:picMkLst>
            <pc:docMk/>
            <pc:sldMk cId="3299870256" sldId="301"/>
            <ac:picMk id="584" creationId="{65E099EC-DF37-0FB7-4855-75B080ABBDCC}"/>
          </ac:picMkLst>
        </pc:picChg>
        <pc:picChg chg="mod topLvl modCrop">
          <ac:chgData name="Go" userId="b11a5121-062d-4360-8951-d081ad96d999" providerId="ADAL" clId="{A37B11FE-7E2B-4B71-9282-AB38B86228CA}" dt="2022-10-14T01:36:21.436" v="1316" actId="164"/>
          <ac:picMkLst>
            <pc:docMk/>
            <pc:sldMk cId="3299870256" sldId="301"/>
            <ac:picMk id="587" creationId="{7D6F430A-1C5C-3112-B7CF-1E2590BBA0CB}"/>
          </ac:picMkLst>
        </pc:picChg>
        <pc:picChg chg="del mod topLvl">
          <ac:chgData name="Go" userId="b11a5121-062d-4360-8951-d081ad96d999" providerId="ADAL" clId="{A37B11FE-7E2B-4B71-9282-AB38B86228CA}" dt="2022-10-13T20:44:49.183" v="1173" actId="478"/>
          <ac:picMkLst>
            <pc:docMk/>
            <pc:sldMk cId="3299870256" sldId="301"/>
            <ac:picMk id="589" creationId="{2ABF06E6-EEAE-48EA-B11A-625F8C9B6298}"/>
          </ac:picMkLst>
        </pc:picChg>
        <pc:picChg chg="mod ord topLvl">
          <ac:chgData name="Go" userId="b11a5121-062d-4360-8951-d081ad96d999" providerId="ADAL" clId="{A37B11FE-7E2B-4B71-9282-AB38B86228CA}" dt="2022-10-14T01:44:51.858" v="1319" actId="553"/>
          <ac:picMkLst>
            <pc:docMk/>
            <pc:sldMk cId="3299870256" sldId="301"/>
            <ac:picMk id="598" creationId="{CEED833A-E64F-B880-BB0C-53F165B34A39}"/>
          </ac:picMkLst>
        </pc:picChg>
        <pc:picChg chg="mod topLvl">
          <ac:chgData name="Go" userId="b11a5121-062d-4360-8951-d081ad96d999" providerId="ADAL" clId="{A37B11FE-7E2B-4B71-9282-AB38B86228CA}" dt="2022-10-14T01:36:05.499" v="1308" actId="164"/>
          <ac:picMkLst>
            <pc:docMk/>
            <pc:sldMk cId="3299870256" sldId="301"/>
            <ac:picMk id="602" creationId="{9D32713A-E1E1-E4ED-0C5F-FDD66A6BC6DF}"/>
          </ac:picMkLst>
        </pc:pic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74" creationId="{DCDE6181-4EE4-4CE9-B87D-C2F223928381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75" creationId="{0B4D26CA-7184-4164-A7A0-395716A8AF08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0" creationId="{38A7C430-3563-4774-A34C-6F184920A4E0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1" creationId="{24ED3403-A14E-478B-B263-3A63A5EBF908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2" creationId="{FF7C67B4-2C73-4E59-8E93-1234143CAE77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3" creationId="{981C2F62-03F3-4054-A706-F5CF44248249}"/>
          </ac:cxnSpMkLst>
        </pc:cxnChg>
        <pc:cxnChg chg="mod topLvl">
          <ac:chgData name="Go" userId="b11a5121-062d-4360-8951-d081ad96d999" providerId="ADAL" clId="{A37B11FE-7E2B-4B71-9282-AB38B86228CA}" dt="2022-10-14T01:34:22.952" v="1296" actId="165"/>
          <ac:cxnSpMkLst>
            <pc:docMk/>
            <pc:sldMk cId="3299870256" sldId="301"/>
            <ac:cxnSpMk id="146" creationId="{E5A01E2F-D923-7B8A-4376-3E5510F5BDFB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74" creationId="{7B096F60-44C9-25BE-9B07-BA1E416D8E0F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75" creationId="{E1108CE8-330C-441F-3887-76B03A1F171A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78" creationId="{350D44BE-6AAA-F538-1181-644E2C63FC39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90" creationId="{6E185FA5-7462-299C-A473-2C31C4A61910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29" creationId="{3AFDC835-E16C-64C7-E36F-6D452494FB8A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30" creationId="{0B05E7E3-BC15-0A5C-DFA2-1FC65FB7D022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33" creationId="{8074A64F-CF67-37F1-DFDA-55A586A11E2F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38" creationId="{BF540BCA-E2DD-B7DC-1BE2-7963F369D77A}"/>
          </ac:cxnSpMkLst>
        </pc:cxnChg>
        <pc:cxnChg chg="mod topLvl">
          <ac:chgData name="Go" userId="b11a5121-062d-4360-8951-d081ad96d999" providerId="ADAL" clId="{A37B11FE-7E2B-4B71-9282-AB38B86228CA}" dt="2022-10-13T19:59:05.306" v="496" actId="164"/>
          <ac:cxnSpMkLst>
            <pc:docMk/>
            <pc:sldMk cId="3299870256" sldId="301"/>
            <ac:cxnSpMk id="280" creationId="{71483C28-169B-5E49-FB08-F99A8867EA06}"/>
          </ac:cxnSpMkLst>
        </pc:cxnChg>
        <pc:cxnChg chg="mod">
          <ac:chgData name="Go" userId="b11a5121-062d-4360-8951-d081ad96d999" providerId="ADAL" clId="{A37B11FE-7E2B-4B71-9282-AB38B86228CA}" dt="2022-10-13T20:09:45.203" v="626"/>
          <ac:cxnSpMkLst>
            <pc:docMk/>
            <pc:sldMk cId="3299870256" sldId="301"/>
            <ac:cxnSpMk id="302" creationId="{71E0DB69-8833-F8B1-EA78-2DD037215BB5}"/>
          </ac:cxnSpMkLst>
        </pc:cxnChg>
        <pc:cxnChg chg="mod topLvl">
          <ac:chgData name="Go" userId="b11a5121-062d-4360-8951-d081ad96d999" providerId="ADAL" clId="{A37B11FE-7E2B-4B71-9282-AB38B86228CA}" dt="2022-10-13T20:11:40.162" v="640" actId="164"/>
          <ac:cxnSpMkLst>
            <pc:docMk/>
            <pc:sldMk cId="3299870256" sldId="301"/>
            <ac:cxnSpMk id="320" creationId="{6B53738C-27BF-CB34-A15A-246E1FE637F0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1" creationId="{B69216E1-6575-1489-2D44-322046CBC33E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2" creationId="{9DF3C598-777D-BD61-9BD4-03BEBD85A8E2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4" creationId="{AA9A303D-7650-CB52-AC81-F0A6C13F7B6D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5" creationId="{9669EB3B-99E7-D90C-92BE-9B049A8DB7AA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5" creationId="{77F25675-7B55-4E09-01E1-94D6922AF568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6" creationId="{BEA321F4-F52F-6980-814F-CE03E2BD8E99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7" creationId="{7BADAB79-F454-2B66-6A91-7858FEAB433C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8" creationId="{6D1A51C3-C35B-30B8-E518-25E26BC7DB78}"/>
          </ac:cxnSpMkLst>
        </pc:cxnChg>
        <pc:cxnChg chg="mod topLvl">
          <ac:chgData name="Go" userId="b11a5121-062d-4360-8951-d081ad96d999" providerId="ADAL" clId="{A37B11FE-7E2B-4B71-9282-AB38B86228CA}" dt="2022-10-14T01:34:22.952" v="1296" actId="165"/>
          <ac:cxnSpMkLst>
            <pc:docMk/>
            <pc:sldMk cId="3299870256" sldId="301"/>
            <ac:cxnSpMk id="632" creationId="{9CF49B4E-790A-93D5-9972-4C45B0E7B7D5}"/>
          </ac:cxnSpMkLst>
        </pc:cxnChg>
      </pc:sldChg>
      <pc:sldChg chg="addSp delSp modSp new mod">
        <pc:chgData name="Go" userId="b11a5121-062d-4360-8951-d081ad96d999" providerId="ADAL" clId="{A37B11FE-7E2B-4B71-9282-AB38B86228CA}" dt="2022-10-14T02:00:56.036" v="1429" actId="164"/>
        <pc:sldMkLst>
          <pc:docMk/>
          <pc:sldMk cId="2069005311" sldId="302"/>
        </pc:sldMkLst>
        <pc:spChg chg="del">
          <ac:chgData name="Go" userId="b11a5121-062d-4360-8951-d081ad96d999" providerId="ADAL" clId="{A37B11FE-7E2B-4B71-9282-AB38B86228CA}" dt="2022-10-14T01:00:46.363" v="1251" actId="478"/>
          <ac:spMkLst>
            <pc:docMk/>
            <pc:sldMk cId="2069005311" sldId="302"/>
            <ac:spMk id="2" creationId="{F5B0F420-CC21-AA5A-9C72-9B1A9F298217}"/>
          </ac:spMkLst>
        </pc:spChg>
        <pc:spChg chg="del">
          <ac:chgData name="Go" userId="b11a5121-062d-4360-8951-d081ad96d999" providerId="ADAL" clId="{A37B11FE-7E2B-4B71-9282-AB38B86228CA}" dt="2022-10-14T01:00:43.390" v="1250" actId="478"/>
          <ac:spMkLst>
            <pc:docMk/>
            <pc:sldMk cId="2069005311" sldId="302"/>
            <ac:spMk id="3" creationId="{6F6B9B75-AA43-B4DE-F78A-7A92AB44B191}"/>
          </ac:spMkLst>
        </pc:spChg>
        <pc:spChg chg="mod topLvl">
          <ac:chgData name="Go" userId="b11a5121-062d-4360-8951-d081ad96d999" providerId="ADAL" clId="{A37B11FE-7E2B-4B71-9282-AB38B86228CA}" dt="2022-10-14T02:00:56.036" v="1429" actId="164"/>
          <ac:spMkLst>
            <pc:docMk/>
            <pc:sldMk cId="2069005311" sldId="302"/>
            <ac:spMk id="6" creationId="{7201332A-CE8F-EA78-8E01-D352071260EA}"/>
          </ac:spMkLst>
        </pc:spChg>
        <pc:spChg chg="mod">
          <ac:chgData name="Go" userId="b11a5121-062d-4360-8951-d081ad96d999" providerId="ADAL" clId="{A37B11FE-7E2B-4B71-9282-AB38B86228CA}" dt="2022-10-14T02:00:42.402" v="1423" actId="165"/>
          <ac:spMkLst>
            <pc:docMk/>
            <pc:sldMk cId="2069005311" sldId="302"/>
            <ac:spMk id="8" creationId="{6E80E716-1388-DECF-371E-1E392B8503AB}"/>
          </ac:spMkLst>
        </pc:spChg>
        <pc:spChg chg="mod">
          <ac:chgData name="Go" userId="b11a5121-062d-4360-8951-d081ad96d999" providerId="ADAL" clId="{A37B11FE-7E2B-4B71-9282-AB38B86228CA}" dt="2022-10-14T02:00:42.402" v="1423" actId="165"/>
          <ac:spMkLst>
            <pc:docMk/>
            <pc:sldMk cId="2069005311" sldId="302"/>
            <ac:spMk id="13" creationId="{BC5672E3-3BA2-B802-B7F1-90B4FB27945A}"/>
          </ac:spMkLst>
        </pc:spChg>
        <pc:spChg chg="mod">
          <ac:chgData name="Go" userId="b11a5121-062d-4360-8951-d081ad96d999" providerId="ADAL" clId="{A37B11FE-7E2B-4B71-9282-AB38B86228CA}" dt="2022-10-14T02:00:42.402" v="1423" actId="165"/>
          <ac:spMkLst>
            <pc:docMk/>
            <pc:sldMk cId="2069005311" sldId="302"/>
            <ac:spMk id="14" creationId="{C2994E3F-B475-77BB-DBB3-2C19C32EA91C}"/>
          </ac:spMkLst>
        </pc:spChg>
        <pc:spChg chg="mod topLvl">
          <ac:chgData name="Go" userId="b11a5121-062d-4360-8951-d081ad96d999" providerId="ADAL" clId="{A37B11FE-7E2B-4B71-9282-AB38B86228CA}" dt="2022-10-14T02:00:56.036" v="1429" actId="164"/>
          <ac:spMkLst>
            <pc:docMk/>
            <pc:sldMk cId="2069005311" sldId="302"/>
            <ac:spMk id="16" creationId="{962959EC-F6B9-E811-2B9D-A1CB077C647C}"/>
          </ac:spMkLst>
        </pc:spChg>
        <pc:spChg chg="mod topLvl">
          <ac:chgData name="Go" userId="b11a5121-062d-4360-8951-d081ad96d999" providerId="ADAL" clId="{A37B11FE-7E2B-4B71-9282-AB38B86228CA}" dt="2022-10-14T02:00:14.628" v="1412" actId="164"/>
          <ac:spMkLst>
            <pc:docMk/>
            <pc:sldMk cId="2069005311" sldId="302"/>
            <ac:spMk id="19" creationId="{85CDD789-3BE1-362E-4568-93BA3716E071}"/>
          </ac:spMkLst>
        </pc:spChg>
        <pc:spChg chg="mod topLvl">
          <ac:chgData name="Go" userId="b11a5121-062d-4360-8951-d081ad96d999" providerId="ADAL" clId="{A37B11FE-7E2B-4B71-9282-AB38B86228CA}" dt="2022-10-14T01:57:27.303" v="1356" actId="164"/>
          <ac:spMkLst>
            <pc:docMk/>
            <pc:sldMk cId="2069005311" sldId="302"/>
            <ac:spMk id="21" creationId="{3A3DFD42-FE4F-DC52-19DB-CA29A22880F9}"/>
          </ac:spMkLst>
        </pc:spChg>
        <pc:spChg chg="mod topLvl">
          <ac:chgData name="Go" userId="b11a5121-062d-4360-8951-d081ad96d999" providerId="ADAL" clId="{A37B11FE-7E2B-4B71-9282-AB38B86228CA}" dt="2022-10-14T01:57:27.303" v="1356" actId="164"/>
          <ac:spMkLst>
            <pc:docMk/>
            <pc:sldMk cId="2069005311" sldId="302"/>
            <ac:spMk id="22" creationId="{3257A8D9-033C-AED0-D1F9-500BCDFA786C}"/>
          </ac:spMkLst>
        </pc:spChg>
        <pc:spChg chg="mod topLvl">
          <ac:chgData name="Go" userId="b11a5121-062d-4360-8951-d081ad96d999" providerId="ADAL" clId="{A37B11FE-7E2B-4B71-9282-AB38B86228CA}" dt="2022-10-14T01:57:48.729" v="1367" actId="164"/>
          <ac:spMkLst>
            <pc:docMk/>
            <pc:sldMk cId="2069005311" sldId="302"/>
            <ac:spMk id="25" creationId="{5ADBB3AB-5C13-C5BE-B1A0-5A1EEF2BEFD4}"/>
          </ac:spMkLst>
        </pc:spChg>
        <pc:spChg chg="mod topLvl">
          <ac:chgData name="Go" userId="b11a5121-062d-4360-8951-d081ad96d999" providerId="ADAL" clId="{A37B11FE-7E2B-4B71-9282-AB38B86228CA}" dt="2022-10-14T01:57:48.729" v="1367" actId="164"/>
          <ac:spMkLst>
            <pc:docMk/>
            <pc:sldMk cId="2069005311" sldId="302"/>
            <ac:spMk id="26" creationId="{D96734F8-7CF1-631D-EEA1-981B62643BD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5" creationId="{990E21BF-643A-FE04-7F24-DBEDF1AA0CE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6" creationId="{D085FA2B-7379-A06A-D3A7-BA7A4A01617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7" creationId="{E30FEDBC-F209-55FC-778A-62D805167E0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8" creationId="{DF0470C2-60E4-D51E-8465-F38B205F6C6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9" creationId="{CD906AC6-3905-2824-E358-1E4D36142C1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0" creationId="{85BE65DA-0172-A046-B3A3-B5CEC8D5DCD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2" creationId="{A1D8E731-A41D-E180-AB69-9ECC77E2C6B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3" creationId="{3486CAEF-F6AF-E62D-FFF8-E1C327F3EDB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4" creationId="{5D30EA5C-AD57-474C-A22F-F5AF1758EED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5" creationId="{66471B26-CE17-0F2D-086B-5F2111ABB1D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6" creationId="{AD3955E4-6EF6-C950-CE16-996185F2FC3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7" creationId="{450AC69B-3CA4-9D10-5236-5D79AC52A68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8" creationId="{489B0A1C-2B10-01EB-C7FD-C6C68F719DE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9" creationId="{D335B55C-D172-A17B-786C-B9C1A79C0D0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1" creationId="{D01F265F-7FA6-B3B7-6E4D-9237581EB86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2" creationId="{3D6D1C42-0510-CE8D-BFEE-A6D06F835B90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3" creationId="{C6034425-8B38-65C5-5B72-1F10F325EB1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4" creationId="{D6752323-53E9-C894-1419-64E4EC9FEE4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5" creationId="{A4A883A5-A35F-773E-A346-59F2C8B30ABA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6" creationId="{8329FDA3-6515-FE52-68A5-41EBF455CF50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8" creationId="{54B3961D-901F-D9B1-7E5A-0AA991923ED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9" creationId="{3E7F6FE1-7A7E-AFD2-DB0D-35A8FD4C0C3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0" creationId="{CC878395-538B-7D90-96CD-B5E8243335B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1" creationId="{DA072248-5DB0-BBB1-8D19-CEEE979BB3B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2" creationId="{2F00770D-E276-E49E-6F6C-C0247F738D7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3" creationId="{CA763550-89D3-AC2A-1F98-69B3C8BCAE6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5" creationId="{754CD4D9-DFD0-437F-D36F-4B5B6A667DD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6" creationId="{D1C4BD5B-3085-977D-B1B4-7D1FA6FE0D9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7" creationId="{6DA05AB2-AD48-C63B-A9E2-68AB67ED941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8" creationId="{9359E7F3-2980-0BE4-CDE5-FAFBBCC4959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9" creationId="{D02B7B17-A300-614A-7083-C43DFC94761F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0" creationId="{6B37E447-A62F-8A61-370E-08D171850B5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2" creationId="{3CD7D238-4606-A32D-0119-56C3E96DB18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3" creationId="{AEAF8A22-51E8-FBA0-7F25-B82302684AD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4" creationId="{7A30CEC7-F23A-624F-C204-CB2684297EC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5" creationId="{E36C9280-06B0-7BAE-2C23-C45EFE46E9E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6" creationId="{67F8F2EF-DBB8-BADE-B4B4-EF285298B0B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7" creationId="{F786F93A-241C-4B79-A49E-B81760D2DDD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9" creationId="{695B351B-56E7-9F0B-544D-666A38F4D1E9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0" creationId="{563B0552-675D-47C2-509A-69C4FD63559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1" creationId="{B39F3217-B036-CCE3-65EC-EF2A32AC2A19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2" creationId="{1094859F-7BA8-FBAE-0D20-F39ED965238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3" creationId="{3796D51C-34A9-D375-3315-911CF8BEB65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4" creationId="{2C4D0FCE-D400-0B8F-3920-EBD2F4A1712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5" creationId="{2E8E5CB3-C8BC-CE4B-ABD9-1E17BAED0FD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6" creationId="{45721C41-34FA-8890-9B55-630B95D43CAD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7" creationId="{E6821FDF-FE3E-B109-B7AD-5AD5FA59522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8" creationId="{B83E925D-4F73-D5EC-CBBE-04D5905384C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9" creationId="{CC84A8AC-7B60-0300-BE57-74415D4793F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0" creationId="{DEF632F5-1469-EA83-BA38-34A37EE2955F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2" creationId="{8657E0E6-9449-8149-1174-5F1A8090710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3" creationId="{771D689C-E772-D6A0-8875-56A5EDBAA52A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4" creationId="{157D474E-1990-92AB-766A-01677A3BB2C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5" creationId="{6F963894-C4E9-BDBE-42F7-B092E5CCF30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6" creationId="{4510D476-D187-4342-750F-0E613A0D5B90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7" creationId="{BDDE968E-775E-67FF-1FBD-DFF9D69308E9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8" creationId="{247E4D9D-7EB0-25B0-806A-E6774F4A0C1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9" creationId="{589927D1-050A-E38B-438F-9BD492E3363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0" creationId="{535C0306-F684-C4C3-07BA-1257E02DA86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1" creationId="{B9274B0D-A7C2-9865-A478-C37C5D04CC5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2" creationId="{343C84E6-E602-12B9-C9F4-E16819C0F5B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3" creationId="{FCB4D65B-6EFB-AEFD-6951-23765D5265B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6" creationId="{1437D720-A9F5-08B9-E445-301CB5A5809D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8" creationId="{4DF76A7C-4BF2-9F69-EFDA-789588C9BB1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14" creationId="{4FA7B592-DC9E-6A8B-BFDF-D378238ADE62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16" creationId="{30E7A49A-DFB1-0E00-A6D6-0BFB7B883B0C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18" creationId="{B41C5022-BF0F-0D95-3304-07B520EADA78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0" creationId="{E262D6C8-1DD9-CBEA-EB09-51B4CD7C705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1" creationId="{E7A7D6E1-C9E1-0D34-BAA1-9395985EE62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2" creationId="{46FBC6D1-03DF-8AF3-28F1-9D7FF671AD8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3" creationId="{B5098512-E7FA-7D63-0092-517CCFA9D2B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4" creationId="{0821E1FA-4FD1-C4B9-DF91-DFD34EA6E71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5" creationId="{4B5B55CA-62E4-EDB3-CFF4-81C4E29C728C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26" creationId="{CF2A0B3F-4EC3-3A0B-F6C9-19237171F97D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27" creationId="{80475976-F4A4-6322-AFBA-DE5CFC5D0767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0" creationId="{EE0FB00B-48D6-68A9-2954-80AE065AE68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1" creationId="{7E122340-3C67-713D-7BFF-A56EAA119FB8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2" creationId="{B28F7F8D-10F4-54CF-CA11-4E53A4D2078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3" creationId="{CBCCE842-5339-4946-FF45-B19E588DE36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4" creationId="{56299C0F-3983-3E2B-619A-DB9275293644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5" creationId="{8B22EE08-C08E-C88A-4A69-E39506A390E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7" creationId="{B19613A5-CC54-74F7-302E-CBC0BD1373F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8" creationId="{859B2DB3-399D-9460-D440-BF52F0A9A76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9" creationId="{DA50130C-B28A-1C20-606E-B7CA547E447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0" creationId="{24ADBB4F-4607-9821-0D3A-92816655EBE1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1" creationId="{2A91B6C1-FA2A-8E6E-A9CB-C7F6BBA80F50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42" creationId="{B4CDD664-F9D3-9035-66DB-449EA6919B4E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43" creationId="{1B376F4B-8B0C-4DEB-C6A3-14E3ECD77294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6" creationId="{912F7C55-E987-09F1-BAF9-36EF5130E98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7" creationId="{55D9929E-0AAC-B682-84B3-C58E9431DA1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8" creationId="{F120EE07-D48B-EA4D-077C-2D70280AAD4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9" creationId="{33B352AA-3AD7-BEC6-0E28-6BAD300488B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0" creationId="{2AF75B7B-135C-1119-62FC-30D67A90975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1" creationId="{657A2EC8-689B-8520-1323-C61C120B727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2" creationId="{3B6E4C18-7944-96BE-E7A6-9CBC6D8FB9C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5" creationId="{7023C2A0-744D-C8A8-D64F-B76D8A57A7B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6" creationId="{5029A15A-7712-DB1E-2ADD-2F4F089063B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7" creationId="{7E6907D6-BE47-8954-7DA4-428CE8A9BD5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8" creationId="{7178E0A6-7898-EF17-F27C-5CCC0CE46D7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9" creationId="{DD46448E-E289-D2F2-A21F-76AA38B61DD7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0" creationId="{0D216BA3-AFA3-02A8-D15B-1FD5698E4F8A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3" creationId="{56B14904-4730-1337-B317-DB93EEECAD0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4" creationId="{50B3BBFC-1FF5-026C-914B-439EDDB55D6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5" creationId="{75E826F8-7110-7734-47B1-386FE54D4B8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6" creationId="{57C8B1EE-8DBC-D792-1BD6-6A830446FE34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7" creationId="{3B3283CC-4FEB-57D8-BC0E-F3E2DF1B95D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8" creationId="{221FE9DC-1A0B-2833-D190-E97D6284C77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1" creationId="{073232C0-2BA2-23E7-060A-A0CC73585A8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2" creationId="{D7C1B412-33BD-1377-DFE2-5E1CDA17B12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3" creationId="{8622AD26-67FD-53E4-6230-960A1C526C5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4" creationId="{78AEF689-D798-61B4-6A93-27EBF5FD062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5" creationId="{0E763800-7189-9A3E-9C7B-178AD446B8C3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6" creationId="{9366B754-B59E-7137-11B5-8F9A431CE0D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9" creationId="{D2A01D62-EAE0-8278-FCB3-3CB4EE9B9AFA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0" creationId="{18947320-E5FB-26D2-6AFA-C4A41C34CAD1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1" creationId="{009CBB73-663D-6433-C04E-5331179488D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2" creationId="{9FF40825-3CD6-E345-64C7-D4292F45128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3" creationId="{6B6A32A5-E6F3-B267-DE3C-1F5C7AB721D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4" creationId="{618CD8A1-2D46-7F9E-B650-F172B6CBC5BA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7" creationId="{40243990-F929-8991-4A00-AB38535DDF2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8" creationId="{27F888B5-289A-ACD8-28BD-875AB20D2F2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9" creationId="{11AFBFE8-2AEF-3D21-6418-FFEC890FADB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0" creationId="{F1C971F6-A71C-14A5-1A8C-DC33E9E828A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1" creationId="{98FB049C-8B13-28C7-B2D2-3BF8E5196893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2" creationId="{FCCAE40E-9AB7-D86A-6A5F-34083FCE96E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3" creationId="{6BE0124E-12A2-9B52-D357-BE6C1ED3A94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4" creationId="{B1621662-1A7C-76D7-01D6-0913EA3F6601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7" creationId="{8C254A4F-7533-A5F9-5666-ABE4C1798E50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8" creationId="{FE3A19C0-0477-B81F-137B-E87280379E1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9" creationId="{523C51D0-C8A5-625E-59FD-C3BD23968F92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200" creationId="{3519AF80-15AF-3A6E-13F6-58A45AD46962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201" creationId="{B7570C76-ECE1-8AF6-E835-BB491EB7D7C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202" creationId="{AF94A8A6-0493-9F07-082F-0CBBB01310A5}"/>
          </ac:spMkLst>
        </pc:spChg>
        <pc:grpChg chg="add del mod">
          <ac:chgData name="Go" userId="b11a5121-062d-4360-8951-d081ad96d999" providerId="ADAL" clId="{A37B11FE-7E2B-4B71-9282-AB38B86228CA}" dt="2022-10-14T02:00:42.402" v="1423" actId="165"/>
          <ac:grpSpMkLst>
            <pc:docMk/>
            <pc:sldMk cId="2069005311" sldId="302"/>
            <ac:grpSpMk id="4" creationId="{C3849621-DD9F-0DB9-5825-2507AAFE7B5D}"/>
          </ac:grpSpMkLst>
        </pc:grpChg>
        <pc:grpChg chg="mod topLvl">
          <ac:chgData name="Go" userId="b11a5121-062d-4360-8951-d081ad96d999" providerId="ADAL" clId="{A37B11FE-7E2B-4B71-9282-AB38B86228CA}" dt="2022-10-14T02:00:56.036" v="1429" actId="164"/>
          <ac:grpSpMkLst>
            <pc:docMk/>
            <pc:sldMk cId="2069005311" sldId="302"/>
            <ac:grpSpMk id="5" creationId="{0EC23BB4-87EB-1AD7-BA76-3269B16E747F}"/>
          </ac:grpSpMkLst>
        </pc:grpChg>
        <pc:grpChg chg="mod">
          <ac:chgData name="Go" userId="b11a5121-062d-4360-8951-d081ad96d999" providerId="ADAL" clId="{A37B11FE-7E2B-4B71-9282-AB38B86228CA}" dt="2022-10-14T02:00:42.402" v="1423" actId="165"/>
          <ac:grpSpMkLst>
            <pc:docMk/>
            <pc:sldMk cId="2069005311" sldId="302"/>
            <ac:grpSpMk id="7" creationId="{67B8ECF3-A538-66E8-630B-03C836938949}"/>
          </ac:grpSpMkLst>
        </pc:grpChg>
        <pc:grpChg chg="add del 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15" creationId="{7AEE8FC5-55C4-F5B1-63AB-CCE15B0FF694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18" creationId="{AF41BC5C-DA99-EFB9-8A21-81E15F68E70B}"/>
          </ac:grpSpMkLst>
        </pc:grpChg>
        <pc:grpChg chg="mod topLvl">
          <ac:chgData name="Go" userId="b11a5121-062d-4360-8951-d081ad96d999" providerId="ADAL" clId="{A37B11FE-7E2B-4B71-9282-AB38B86228CA}" dt="2022-10-14T01:57:27.303" v="1356" actId="164"/>
          <ac:grpSpMkLst>
            <pc:docMk/>
            <pc:sldMk cId="2069005311" sldId="302"/>
            <ac:grpSpMk id="20" creationId="{8F6E9110-7CDD-27C6-B975-00903B1ADEFE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3" creationId="{FCB647DD-AF09-F9BD-BDA8-CB3C91BFFD45}"/>
          </ac:grpSpMkLst>
        </pc:grpChg>
        <pc:grpChg chg="mod topLvl">
          <ac:chgData name="Go" userId="b11a5121-062d-4360-8951-d081ad96d999" providerId="ADAL" clId="{A37B11FE-7E2B-4B71-9282-AB38B86228CA}" dt="2022-10-14T01:57:48.729" v="1367" actId="164"/>
          <ac:grpSpMkLst>
            <pc:docMk/>
            <pc:sldMk cId="2069005311" sldId="302"/>
            <ac:grpSpMk id="24" creationId="{A213AD11-B9D4-BAB6-6E36-CD4F6A539C4F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7" creationId="{EDC85F66-A07E-088A-90C6-6900DCC67206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8" creationId="{417E5F6C-8E0D-FF8D-2808-899F3170F1DE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9" creationId="{F1255727-C642-9DE2-60CB-C19030A5C721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0" creationId="{278DD3FC-FB74-194D-F710-A51F619A067D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1" creationId="{4EEF8E52-F6C0-408B-4485-1531AC633B68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2" creationId="{85E9B832-6CD4-D44D-66C6-84A23CF5AE9C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3" creationId="{B9D88745-0902-F72C-A7AE-C656A8EC3A81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34" creationId="{7EF258CF-409D-98B0-97EC-A615C184C8CB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41" creationId="{9761E88E-A145-EEB2-48F9-8164E52551D0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50" creationId="{1C28B119-F2D4-72EB-BE0C-74B6FB0D4450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57" creationId="{ED3FFD80-C963-A86F-0769-5D33DE543839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64" creationId="{20DF0136-A542-DF51-303E-A959FBEE4A01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71" creationId="{6E6F0B05-BAF0-E896-A86F-83DE1E68EC0B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78" creationId="{DF1F77A6-AAA3-5F16-1DDD-FC2C592268C9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91" creationId="{7BDB70FA-6C97-55D8-7653-4C5C762C4165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104" creationId="{D0527D6C-87BC-97CD-B5EC-AC8475FA6D7F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105" creationId="{6DF74160-508F-DE47-AC28-BBDFE42CFC86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11" creationId="{F81B2595-D2C7-0A8C-8552-B24F1B115B47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12" creationId="{6AA53046-45BB-BCA9-15AE-EA0CD4A2B560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13" creationId="{6FFF429B-8A6C-086D-EAD6-D2A2791CD877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19" creationId="{612A3924-990A-8BF2-BE9B-973DE32EF8D6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28" creationId="{FC312000-D161-DA87-4459-DE20FBB61403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29" creationId="{73DBCFCA-69D7-9649-D63D-ABCB774A42F5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36" creationId="{96E51CB4-047C-B979-CA7B-DC083C4AF75A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44" creationId="{55D84FE4-4F29-2C39-8725-A9FE38B09155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45" creationId="{82699D60-E13F-83B9-2447-35793F5A6FFC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53" creationId="{A7CCE16A-5D32-86E3-9784-6B7EE2303126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54" creationId="{341B43BC-D7D9-5F13-208E-2AA53E059157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61" creationId="{4C3C5DFD-809A-3481-1924-A934C9897448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62" creationId="{11D8DF77-424B-C1C6-9839-A23B5DAC35C0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69" creationId="{F4A8060A-870A-19E5-0352-9660E4DFE2C6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70" creationId="{130A6559-6EB2-DBB8-2749-24C753F1F51C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77" creationId="{3A24F3D6-5245-C241-9FCB-2755DBA4592D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78" creationId="{AE9CBF8C-0F00-49E2-E2E8-D017B8088DFB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85" creationId="{BCBBADD2-863B-600A-129D-B7B746E85F37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86" creationId="{3A8A2F8A-F114-B539-528B-32E2C15A4E71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95" creationId="{DC346F9D-77BB-CA20-D95E-FF116420FEB5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96" creationId="{3E5D6C8C-61CC-5750-35DE-2C11D3AD8CFA}"/>
          </ac:grpSpMkLst>
        </pc:grpChg>
        <pc:grpChg chg="add mod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03" creationId="{AFCD7569-C5C4-93D2-6BD0-BA8EF33FDC28}"/>
          </ac:grpSpMkLst>
        </pc:grpChg>
        <pc:grpChg chg="add mod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04" creationId="{4B5E5729-03DE-3FEF-8B47-D7D87BC7B5ED}"/>
          </ac:grpSpMkLst>
        </pc:grpChg>
        <pc:grpChg chg="add mod">
          <ac:chgData name="Go" userId="b11a5121-062d-4360-8951-d081ad96d999" providerId="ADAL" clId="{A37B11FE-7E2B-4B71-9282-AB38B86228CA}" dt="2022-10-14T02:00:56.036" v="1429" actId="164"/>
          <ac:grpSpMkLst>
            <pc:docMk/>
            <pc:sldMk cId="2069005311" sldId="302"/>
            <ac:grpSpMk id="205" creationId="{6206298C-51E2-0754-767A-59D1994CECE4}"/>
          </ac:grpSpMkLst>
        </pc:grpChg>
        <pc:grpChg chg="add mod">
          <ac:chgData name="Go" userId="b11a5121-062d-4360-8951-d081ad96d999" providerId="ADAL" clId="{A37B11FE-7E2B-4B71-9282-AB38B86228CA}" dt="2022-10-14T02:00:56.036" v="1429" actId="164"/>
          <ac:grpSpMkLst>
            <pc:docMk/>
            <pc:sldMk cId="2069005311" sldId="302"/>
            <ac:grpSpMk id="206" creationId="{808F4ADD-1290-A296-D5A7-6A3A95FB60BD}"/>
          </ac:grpSpMkLst>
        </pc:grpChg>
        <pc:graphicFrameChg chg="mod topLvl">
          <ac:chgData name="Go" userId="b11a5121-062d-4360-8951-d081ad96d999" providerId="ADAL" clId="{A37B11FE-7E2B-4B71-9282-AB38B86228CA}" dt="2022-10-14T02:00:14.628" v="1412" actId="164"/>
          <ac:graphicFrameMkLst>
            <pc:docMk/>
            <pc:sldMk cId="2069005311" sldId="302"/>
            <ac:graphicFrameMk id="17" creationId="{BB7F2A5C-42B8-54BA-B27C-AEC1D83E16F1}"/>
          </ac:graphicFrameMkLst>
        </pc:graphicFrameChg>
        <pc:graphicFrameChg chg="add del mod">
          <ac:chgData name="Go" userId="b11a5121-062d-4360-8951-d081ad96d999" providerId="ADAL" clId="{A37B11FE-7E2B-4B71-9282-AB38B86228CA}" dt="2022-10-14T02:00:28.341" v="1418" actId="478"/>
          <ac:graphicFrameMkLst>
            <pc:docMk/>
            <pc:sldMk cId="2069005311" sldId="302"/>
            <ac:graphicFrameMk id="110" creationId="{0F721F0E-B92A-84E7-000F-5019C3A93A01}"/>
          </ac:graphicFrameMkLst>
        </pc:graphicFrameChg>
        <pc:picChg chg="mod">
          <ac:chgData name="Go" userId="b11a5121-062d-4360-8951-d081ad96d999" providerId="ADAL" clId="{A37B11FE-7E2B-4B71-9282-AB38B86228CA}" dt="2022-10-14T02:00:42.402" v="1423" actId="165"/>
          <ac:picMkLst>
            <pc:docMk/>
            <pc:sldMk cId="2069005311" sldId="302"/>
            <ac:picMk id="9" creationId="{22DFC33F-2FDB-A6EC-9D74-D956F1D3C8A4}"/>
          </ac:picMkLst>
        </pc:picChg>
        <pc:picChg chg="mod">
          <ac:chgData name="Go" userId="b11a5121-062d-4360-8951-d081ad96d999" providerId="ADAL" clId="{A37B11FE-7E2B-4B71-9282-AB38B86228CA}" dt="2022-10-14T02:00:42.402" v="1423" actId="165"/>
          <ac:picMkLst>
            <pc:docMk/>
            <pc:sldMk cId="2069005311" sldId="302"/>
            <ac:picMk id="11" creationId="{AB2EEDC1-E87B-7A6A-6355-8C52B4B045BB}"/>
          </ac:picMkLst>
        </pc:picChg>
        <pc:picChg chg="mod">
          <ac:chgData name="Go" userId="b11a5121-062d-4360-8951-d081ad96d999" providerId="ADAL" clId="{A37B11FE-7E2B-4B71-9282-AB38B86228CA}" dt="2022-10-14T01:54:53.790" v="1350" actId="165"/>
          <ac:picMkLst>
            <pc:docMk/>
            <pc:sldMk cId="2069005311" sldId="302"/>
            <ac:picMk id="107" creationId="{962758D2-FE5B-66E4-6B4E-ED1CBD8BD1D2}"/>
          </ac:picMkLst>
        </pc:picChg>
        <pc:picChg chg="mod">
          <ac:chgData name="Go" userId="b11a5121-062d-4360-8951-d081ad96d999" providerId="ADAL" clId="{A37B11FE-7E2B-4B71-9282-AB38B86228CA}" dt="2022-10-14T01:54:53.790" v="1350" actId="165"/>
          <ac:picMkLst>
            <pc:docMk/>
            <pc:sldMk cId="2069005311" sldId="302"/>
            <ac:picMk id="109" creationId="{CEF6DDD1-7EB7-B8ED-90D8-535831AA95FC}"/>
          </ac:picMkLst>
        </pc:picChg>
        <pc:picChg chg="mod">
          <ac:chgData name="Go" userId="b11a5121-062d-4360-8951-d081ad96d999" providerId="ADAL" clId="{A37B11FE-7E2B-4B71-9282-AB38B86228CA}" dt="2022-10-14T01:54:57.578" v="1351"/>
          <ac:picMkLst>
            <pc:docMk/>
            <pc:sldMk cId="2069005311" sldId="302"/>
            <ac:picMk id="115" creationId="{341854E8-53F7-0362-A7A9-1A8B79CC8B34}"/>
          </ac:picMkLst>
        </pc:picChg>
        <pc:picChg chg="mod">
          <ac:chgData name="Go" userId="b11a5121-062d-4360-8951-d081ad96d999" providerId="ADAL" clId="{A37B11FE-7E2B-4B71-9282-AB38B86228CA}" dt="2022-10-14T01:54:57.578" v="1351"/>
          <ac:picMkLst>
            <pc:docMk/>
            <pc:sldMk cId="2069005311" sldId="302"/>
            <ac:picMk id="117" creationId="{4DE979B2-73B5-43B8-6F8D-9F1D04723FC7}"/>
          </ac:picMkLst>
        </pc:picChg>
        <pc:cxnChg chg="mod">
          <ac:chgData name="Go" userId="b11a5121-062d-4360-8951-d081ad96d999" providerId="ADAL" clId="{A37B11FE-7E2B-4B71-9282-AB38B86228CA}" dt="2022-10-14T02:00:42.402" v="1423" actId="165"/>
          <ac:cxnSpMkLst>
            <pc:docMk/>
            <pc:sldMk cId="2069005311" sldId="302"/>
            <ac:cxnSpMk id="10" creationId="{B55FE84F-E429-1A1A-6E65-62BCD8CCD83E}"/>
          </ac:cxnSpMkLst>
        </pc:cxnChg>
        <pc:cxnChg chg="mod">
          <ac:chgData name="Go" userId="b11a5121-062d-4360-8951-d081ad96d999" providerId="ADAL" clId="{A37B11FE-7E2B-4B71-9282-AB38B86228CA}" dt="2022-10-14T02:00:42.402" v="1423" actId="165"/>
          <ac:cxnSpMkLst>
            <pc:docMk/>
            <pc:sldMk cId="2069005311" sldId="302"/>
            <ac:cxnSpMk id="12" creationId="{8066251B-B99C-AE74-6E40-D4549950E730}"/>
          </ac:cxnSpMkLst>
        </pc:cxnChg>
      </pc:sldChg>
      <pc:sldChg chg="addSp delSp modSp add mod ord">
        <pc:chgData name="Go" userId="b11a5121-062d-4360-8951-d081ad96d999" providerId="ADAL" clId="{A37B11FE-7E2B-4B71-9282-AB38B86228CA}" dt="2022-10-15T01:47:19.882" v="1511" actId="20577"/>
        <pc:sldMkLst>
          <pc:docMk/>
          <pc:sldMk cId="1909606739" sldId="303"/>
        </pc:sldMkLst>
        <pc:spChg chg="add mod">
          <ac:chgData name="Go" userId="b11a5121-062d-4360-8951-d081ad96d999" providerId="ADAL" clId="{A37B11FE-7E2B-4B71-9282-AB38B86228CA}" dt="2022-10-14T01:53:19.704" v="1343" actId="1076"/>
          <ac:spMkLst>
            <pc:docMk/>
            <pc:sldMk cId="1909606739" sldId="303"/>
            <ac:spMk id="8" creationId="{35991093-AFCF-2F1A-6BD6-85DAEAF37A4A}"/>
          </ac:spMkLst>
        </pc:spChg>
        <pc:spChg chg="mod">
          <ac:chgData name="Go" userId="b11a5121-062d-4360-8951-d081ad96d999" providerId="ADAL" clId="{A37B11FE-7E2B-4B71-9282-AB38B86228CA}" dt="2022-10-14T01:53:15.884" v="1342" actId="553"/>
          <ac:spMkLst>
            <pc:docMk/>
            <pc:sldMk cId="1909606739" sldId="303"/>
            <ac:spMk id="20" creationId="{1E5638A1-D88D-1784-8C3B-1B8361927869}"/>
          </ac:spMkLst>
        </pc:spChg>
        <pc:spChg chg="mod">
          <ac:chgData name="Go" userId="b11a5121-062d-4360-8951-d081ad96d999" providerId="ADAL" clId="{A37B11FE-7E2B-4B71-9282-AB38B86228CA}" dt="2022-10-15T01:47:19.882" v="1511" actId="20577"/>
          <ac:spMkLst>
            <pc:docMk/>
            <pc:sldMk cId="1909606739" sldId="303"/>
            <ac:spMk id="33" creationId="{2C118948-231F-1F9D-09C3-4B4F5BA9B6A0}"/>
          </ac:spMkLst>
        </pc:spChg>
        <pc:spChg chg="mod">
          <ac:chgData name="Go" userId="b11a5121-062d-4360-8951-d081ad96d999" providerId="ADAL" clId="{A37B11FE-7E2B-4B71-9282-AB38B86228CA}" dt="2022-10-15T01:47:17.279" v="1508" actId="20577"/>
          <ac:spMkLst>
            <pc:docMk/>
            <pc:sldMk cId="1909606739" sldId="303"/>
            <ac:spMk id="36" creationId="{7FF9410D-73F7-EB65-E0FF-E2112266A595}"/>
          </ac:spMkLst>
        </pc:spChg>
        <pc:spChg chg="mod">
          <ac:chgData name="Go" userId="b11a5121-062d-4360-8951-d081ad96d999" providerId="ADAL" clId="{A37B11FE-7E2B-4B71-9282-AB38B86228CA}" dt="2022-10-13T20:38:27.550" v="1083" actId="20577"/>
          <ac:spMkLst>
            <pc:docMk/>
            <pc:sldMk cId="1909606739" sldId="303"/>
            <ac:spMk id="44" creationId="{4EBA0680-77E2-2ABD-9B13-E3E33B2FEBA0}"/>
          </ac:spMkLst>
        </pc:spChg>
        <pc:spChg chg="del">
          <ac:chgData name="Go" userId="b11a5121-062d-4360-8951-d081ad96d999" providerId="ADAL" clId="{A37B11FE-7E2B-4B71-9282-AB38B86228CA}" dt="2022-10-14T01:45:54.813" v="1325" actId="478"/>
          <ac:spMkLst>
            <pc:docMk/>
            <pc:sldMk cId="1909606739" sldId="303"/>
            <ac:spMk id="59" creationId="{638D4131-CD65-E2A2-5377-7594633FFA79}"/>
          </ac:spMkLst>
        </pc:spChg>
        <pc:grpChg chg="del">
          <ac:chgData name="Go" userId="b11a5121-062d-4360-8951-d081ad96d999" providerId="ADAL" clId="{A37B11FE-7E2B-4B71-9282-AB38B86228CA}" dt="2022-10-13T20:38:22.428" v="1079" actId="478"/>
          <ac:grpSpMkLst>
            <pc:docMk/>
            <pc:sldMk cId="1909606739" sldId="303"/>
            <ac:grpSpMk id="2" creationId="{B2FD1FFB-4E78-0C3D-A641-8046DE08B520}"/>
          </ac:grpSpMkLst>
        </pc:grpChg>
        <pc:picChg chg="add mod modCrop">
          <ac:chgData name="Go" userId="b11a5121-062d-4360-8951-d081ad96d999" providerId="ADAL" clId="{A37B11FE-7E2B-4B71-9282-AB38B86228CA}" dt="2022-10-14T01:52:48.015" v="1338" actId="1076"/>
          <ac:picMkLst>
            <pc:docMk/>
            <pc:sldMk cId="1909606739" sldId="303"/>
            <ac:picMk id="3" creationId="{A16858AB-8E93-7BAF-8E79-AE98E8A5C72A}"/>
          </ac:picMkLst>
        </pc:picChg>
        <pc:picChg chg="mod">
          <ac:chgData name="Go" userId="b11a5121-062d-4360-8951-d081ad96d999" providerId="ADAL" clId="{A37B11FE-7E2B-4B71-9282-AB38B86228CA}" dt="2022-10-13T20:39:14.173" v="1121"/>
          <ac:picMkLst>
            <pc:docMk/>
            <pc:sldMk cId="1909606739" sldId="303"/>
            <ac:picMk id="13" creationId="{6384335C-79AE-8172-D5DF-7529DDE9B744}"/>
          </ac:picMkLst>
        </pc:picChg>
        <pc:picChg chg="mod">
          <ac:chgData name="Go" userId="b11a5121-062d-4360-8951-d081ad96d999" providerId="ADAL" clId="{A37B11FE-7E2B-4B71-9282-AB38B86228CA}" dt="2022-10-14T01:52:43.067" v="1337" actId="552"/>
          <ac:picMkLst>
            <pc:docMk/>
            <pc:sldMk cId="1909606739" sldId="303"/>
            <ac:picMk id="17" creationId="{C2F012C9-F323-36DA-07F4-CEA68E0FBAF6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0DD7FB43-A9C4-4FF1-B87C-61A7EFB972BB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68538" y="720725"/>
            <a:ext cx="2778125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6661" tIns="48331" rIns="96661" bIns="48331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AD29BE89-A6B3-40AF-AC57-A963D4802BE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55697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966" y="2613223"/>
            <a:ext cx="5518944" cy="18031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3931" y="4766892"/>
            <a:ext cx="4545013" cy="214977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07334" y="336877"/>
            <a:ext cx="1460897" cy="71776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4644" y="336877"/>
            <a:ext cx="4274476" cy="71776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2892" y="5405594"/>
            <a:ext cx="5518944" cy="1670749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2892" y="3565434"/>
            <a:ext cx="5518944" cy="184016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4644" y="1962839"/>
            <a:ext cx="2867686" cy="55516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00545" y="1962839"/>
            <a:ext cx="2867686" cy="55516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4644" y="1883001"/>
            <a:ext cx="2868814" cy="78474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644" y="2667746"/>
            <a:ext cx="2868814" cy="484673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98291" y="1883001"/>
            <a:ext cx="2869941" cy="78474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98291" y="2667746"/>
            <a:ext cx="2869941" cy="484673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4644" y="334929"/>
            <a:ext cx="2136111" cy="142539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38534" y="334929"/>
            <a:ext cx="3629697" cy="717954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4644" y="1760323"/>
            <a:ext cx="2136111" cy="575415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72649" y="5888514"/>
            <a:ext cx="3895725" cy="69517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72649" y="751642"/>
            <a:ext cx="3895725" cy="504729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72649" y="6583687"/>
            <a:ext cx="3895725" cy="98726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4644" y="336877"/>
            <a:ext cx="5843588" cy="14020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4644" y="1962839"/>
            <a:ext cx="5843588" cy="55516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4644" y="7796829"/>
            <a:ext cx="1515004" cy="4478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592D2A-DFEB-487D-A069-FA11464F9913}" type="datetimeFigureOut">
              <a:rPr lang="en-US" smtClean="0"/>
              <a:pPr/>
              <a:t>12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18399" y="7796829"/>
            <a:ext cx="2056077" cy="4478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653227" y="7796829"/>
            <a:ext cx="1515004" cy="4478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9.tif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12" Type="http://schemas.openxmlformats.org/officeDocument/2006/relationships/image" Target="../media/image8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11" Type="http://schemas.openxmlformats.org/officeDocument/2006/relationships/image" Target="../media/image7.tif"/><Relationship Id="rId5" Type="http://schemas.openxmlformats.org/officeDocument/2006/relationships/image" Target="../media/image4.png"/><Relationship Id="rId10" Type="http://schemas.microsoft.com/office/2007/relationships/hdphoto" Target="../media/hdphoto3.wdp"/><Relationship Id="rId4" Type="http://schemas.openxmlformats.org/officeDocument/2006/relationships/image" Target="../media/image3.tif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Box 247">
            <a:extLst>
              <a:ext uri="{FF2B5EF4-FFF2-40B4-BE49-F238E27FC236}">
                <a16:creationId xmlns:a16="http://schemas.microsoft.com/office/drawing/2014/main" id="{4EBA0680-77E2-2ABD-9B13-E3E33B2FEBA0}"/>
              </a:ext>
            </a:extLst>
          </p:cNvPr>
          <p:cNvSpPr txBox="1"/>
          <p:nvPr/>
        </p:nvSpPr>
        <p:spPr>
          <a:xfrm>
            <a:off x="51275" y="0"/>
            <a:ext cx="26875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itchFamily="34" charset="0"/>
              </a:rPr>
              <a:t>Figure S6</a:t>
            </a:r>
          </a:p>
        </p:txBody>
      </p:sp>
      <p:pic>
        <p:nvPicPr>
          <p:cNvPr id="4" name="Picture 198">
            <a:extLst>
              <a:ext uri="{FF2B5EF4-FFF2-40B4-BE49-F238E27FC236}">
                <a16:creationId xmlns:a16="http://schemas.microsoft.com/office/drawing/2014/main" id="{C61A9ACD-A35E-CABF-DC0F-DFC3FE911A68}"/>
              </a:ext>
            </a:extLst>
          </p:cNvPr>
          <p:cNvPicPr>
            <a:picLocks/>
          </p:cNvPicPr>
          <p:nvPr/>
        </p:nvPicPr>
        <p:blipFill rotWithShape="1">
          <a:blip r:embed="rId2"/>
          <a:srcRect l="34006" t="38212" r="40192" b="58594"/>
          <a:stretch/>
        </p:blipFill>
        <p:spPr>
          <a:xfrm>
            <a:off x="959665" y="1523522"/>
            <a:ext cx="1042416" cy="15544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5" name="Picture 199">
            <a:extLst>
              <a:ext uri="{FF2B5EF4-FFF2-40B4-BE49-F238E27FC236}">
                <a16:creationId xmlns:a16="http://schemas.microsoft.com/office/drawing/2014/main" id="{D529FFCD-96DD-2085-D658-05BE8822553F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l="36910" t="30917" r="43047" b="62823"/>
          <a:stretch/>
        </p:blipFill>
        <p:spPr>
          <a:xfrm>
            <a:off x="959665" y="1345399"/>
            <a:ext cx="1042416" cy="15544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6" name="TextBox 83">
            <a:extLst>
              <a:ext uri="{FF2B5EF4-FFF2-40B4-BE49-F238E27FC236}">
                <a16:creationId xmlns:a16="http://schemas.microsoft.com/office/drawing/2014/main" id="{1371575E-03FE-EE70-76FF-FA71A80DCB10}"/>
              </a:ext>
            </a:extLst>
          </p:cNvPr>
          <p:cNvSpPr txBox="1"/>
          <p:nvPr/>
        </p:nvSpPr>
        <p:spPr>
          <a:xfrm>
            <a:off x="328415" y="1656259"/>
            <a:ext cx="681598" cy="246221"/>
          </a:xfrm>
          <a:prstGeom prst="rect">
            <a:avLst/>
          </a:prstGeom>
          <a:noFill/>
        </p:spPr>
        <p:txBody>
          <a:bodyPr wrap="none" rtlCol="0" anchor="ctr" anchorCtr="0">
            <a:spAutoFit/>
          </a:bodyPr>
          <a:lstStyle/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YP3A4</a:t>
            </a:r>
          </a:p>
        </p:txBody>
      </p:sp>
      <p:pic>
        <p:nvPicPr>
          <p:cNvPr id="7" name="Picture 206" descr="A picture containing light&#10;&#10;Description automatically generated">
            <a:extLst>
              <a:ext uri="{FF2B5EF4-FFF2-40B4-BE49-F238E27FC236}">
                <a16:creationId xmlns:a16="http://schemas.microsoft.com/office/drawing/2014/main" id="{570C03D4-9885-1DE9-A161-07890068A4F9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72" t="37073" r="33129" b="57637"/>
          <a:stretch/>
        </p:blipFill>
        <p:spPr>
          <a:xfrm>
            <a:off x="959665" y="1701645"/>
            <a:ext cx="1042416" cy="15544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grpSp>
        <p:nvGrpSpPr>
          <p:cNvPr id="27" name="Group 224">
            <a:extLst>
              <a:ext uri="{FF2B5EF4-FFF2-40B4-BE49-F238E27FC236}">
                <a16:creationId xmlns:a16="http://schemas.microsoft.com/office/drawing/2014/main" id="{075889E4-E48A-F0E3-C5D2-CEC000F97771}"/>
              </a:ext>
            </a:extLst>
          </p:cNvPr>
          <p:cNvGrpSpPr/>
          <p:nvPr/>
        </p:nvGrpSpPr>
        <p:grpSpPr>
          <a:xfrm>
            <a:off x="923075" y="543474"/>
            <a:ext cx="597930" cy="693230"/>
            <a:chOff x="968453" y="2351897"/>
            <a:chExt cx="700594" cy="543080"/>
          </a:xfrm>
        </p:grpSpPr>
        <p:sp>
          <p:nvSpPr>
            <p:cNvPr id="34" name="TextBox 51">
              <a:extLst>
                <a:ext uri="{FF2B5EF4-FFF2-40B4-BE49-F238E27FC236}">
                  <a16:creationId xmlns:a16="http://schemas.microsoft.com/office/drawing/2014/main" id="{830A266A-048F-1F68-B3E0-F65F808C7741}"/>
                </a:ext>
              </a:extLst>
            </p:cNvPr>
            <p:cNvSpPr txBox="1"/>
            <p:nvPr/>
          </p:nvSpPr>
          <p:spPr>
            <a:xfrm rot="16200000">
              <a:off x="1086905" y="2502855"/>
              <a:ext cx="487364" cy="2884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35" name="TextBox 51">
              <a:extLst>
                <a:ext uri="{FF2B5EF4-FFF2-40B4-BE49-F238E27FC236}">
                  <a16:creationId xmlns:a16="http://schemas.microsoft.com/office/drawing/2014/main" id="{5400C05B-D17B-E886-3BA9-7F75EDADED5E}"/>
                </a:ext>
              </a:extLst>
            </p:cNvPr>
            <p:cNvSpPr txBox="1"/>
            <p:nvPr/>
          </p:nvSpPr>
          <p:spPr>
            <a:xfrm rot="16200000">
              <a:off x="1263824" y="2485563"/>
              <a:ext cx="521949" cy="2884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MSO2</a:t>
              </a:r>
            </a:p>
          </p:txBody>
        </p:sp>
        <p:sp>
          <p:nvSpPr>
            <p:cNvPr id="36" name="TextBox 232">
              <a:extLst>
                <a:ext uri="{FF2B5EF4-FFF2-40B4-BE49-F238E27FC236}">
                  <a16:creationId xmlns:a16="http://schemas.microsoft.com/office/drawing/2014/main" id="{7FF9410D-73F7-EB65-E0FF-E2112266A595}"/>
                </a:ext>
              </a:extLst>
            </p:cNvPr>
            <p:cNvSpPr txBox="1"/>
            <p:nvPr/>
          </p:nvSpPr>
          <p:spPr>
            <a:xfrm rot="16200000">
              <a:off x="841162" y="2479188"/>
              <a:ext cx="543080" cy="2884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</p:grpSp>
      <p:grpSp>
        <p:nvGrpSpPr>
          <p:cNvPr id="28" name="Group 225">
            <a:extLst>
              <a:ext uri="{FF2B5EF4-FFF2-40B4-BE49-F238E27FC236}">
                <a16:creationId xmlns:a16="http://schemas.microsoft.com/office/drawing/2014/main" id="{B2BC3338-3EEF-6A44-68D8-885DD23C1818}"/>
              </a:ext>
            </a:extLst>
          </p:cNvPr>
          <p:cNvGrpSpPr/>
          <p:nvPr/>
        </p:nvGrpSpPr>
        <p:grpSpPr>
          <a:xfrm>
            <a:off x="1443361" y="472279"/>
            <a:ext cx="597931" cy="764421"/>
            <a:chOff x="968454" y="2296125"/>
            <a:chExt cx="700595" cy="598851"/>
          </a:xfrm>
        </p:grpSpPr>
        <p:sp>
          <p:nvSpPr>
            <p:cNvPr id="30" name="TextBox 51">
              <a:extLst>
                <a:ext uri="{FF2B5EF4-FFF2-40B4-BE49-F238E27FC236}">
                  <a16:creationId xmlns:a16="http://schemas.microsoft.com/office/drawing/2014/main" id="{FC148F42-5523-6278-2C5F-3B069D4677E0}"/>
                </a:ext>
              </a:extLst>
            </p:cNvPr>
            <p:cNvSpPr txBox="1"/>
            <p:nvPr/>
          </p:nvSpPr>
          <p:spPr>
            <a:xfrm rot="16200000">
              <a:off x="1069611" y="2485563"/>
              <a:ext cx="521951" cy="2884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</a:p>
          </p:txBody>
        </p:sp>
        <p:sp>
          <p:nvSpPr>
            <p:cNvPr id="31" name="TextBox 51">
              <a:extLst>
                <a:ext uri="{FF2B5EF4-FFF2-40B4-BE49-F238E27FC236}">
                  <a16:creationId xmlns:a16="http://schemas.microsoft.com/office/drawing/2014/main" id="{4B0C0D4E-C485-800D-136E-3B5190E9C0AF}"/>
                </a:ext>
              </a:extLst>
            </p:cNvPr>
            <p:cNvSpPr txBox="1"/>
            <p:nvPr/>
          </p:nvSpPr>
          <p:spPr>
            <a:xfrm rot="16200000">
              <a:off x="1227471" y="2449206"/>
              <a:ext cx="594659" cy="2884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MSO2</a:t>
              </a:r>
            </a:p>
          </p:txBody>
        </p:sp>
        <p:sp>
          <p:nvSpPr>
            <p:cNvPr id="33" name="TextBox 229">
              <a:extLst>
                <a:ext uri="{FF2B5EF4-FFF2-40B4-BE49-F238E27FC236}">
                  <a16:creationId xmlns:a16="http://schemas.microsoft.com/office/drawing/2014/main" id="{2C118948-231F-1F9D-09C3-4B4F5BA9B6A0}"/>
                </a:ext>
              </a:extLst>
            </p:cNvPr>
            <p:cNvSpPr txBox="1"/>
            <p:nvPr/>
          </p:nvSpPr>
          <p:spPr>
            <a:xfrm rot="16200000">
              <a:off x="841163" y="2479187"/>
              <a:ext cx="543080" cy="2884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</a:p>
          </p:txBody>
        </p:sp>
      </p:grpSp>
      <p:pic>
        <p:nvPicPr>
          <p:cNvPr id="10" name="Picture 235" descr="A black and white photo of a cell phone&#10;&#10;Description automatically generated with low confidence">
            <a:extLst>
              <a:ext uri="{FF2B5EF4-FFF2-40B4-BE49-F238E27FC236}">
                <a16:creationId xmlns:a16="http://schemas.microsoft.com/office/drawing/2014/main" id="{47239B5B-AE66-30F7-4FE8-F032BB78F5AE}"/>
              </a:ext>
            </a:extLst>
          </p:cNvPr>
          <p:cNvPicPr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407" t="34898" r="35780" b="62492"/>
          <a:stretch/>
        </p:blipFill>
        <p:spPr>
          <a:xfrm>
            <a:off x="959665" y="1879768"/>
            <a:ext cx="1042416" cy="15544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2" name="TextBox 83">
            <a:extLst>
              <a:ext uri="{FF2B5EF4-FFF2-40B4-BE49-F238E27FC236}">
                <a16:creationId xmlns:a16="http://schemas.microsoft.com/office/drawing/2014/main" id="{862C96C3-B678-4FDB-79C7-BD9FF90DBB5B}"/>
              </a:ext>
            </a:extLst>
          </p:cNvPr>
          <p:cNvSpPr txBox="1"/>
          <p:nvPr/>
        </p:nvSpPr>
        <p:spPr>
          <a:xfrm>
            <a:off x="336431" y="1834382"/>
            <a:ext cx="673582" cy="246221"/>
          </a:xfrm>
          <a:prstGeom prst="rect">
            <a:avLst/>
          </a:prstGeom>
          <a:noFill/>
        </p:spPr>
        <p:txBody>
          <a:bodyPr wrap="none" rtlCol="0" anchor="ctr" anchorCtr="0">
            <a:spAutoFit/>
          </a:bodyPr>
          <a:lstStyle/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YP2E1</a:t>
            </a:r>
          </a:p>
        </p:txBody>
      </p:sp>
      <p:pic>
        <p:nvPicPr>
          <p:cNvPr id="13" name="Picture 240" descr="A picture containing text, white&#10;&#10;Description automatically generated">
            <a:extLst>
              <a:ext uri="{FF2B5EF4-FFF2-40B4-BE49-F238E27FC236}">
                <a16:creationId xmlns:a16="http://schemas.microsoft.com/office/drawing/2014/main" id="{6384335C-79AE-8172-D5DF-7529DDE9B744}"/>
              </a:ext>
            </a:extLst>
          </p:cNvPr>
          <p:cNvPicPr>
            <a:picLocks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594" t="28489" r="42083" b="67268"/>
          <a:stretch/>
        </p:blipFill>
        <p:spPr>
          <a:xfrm>
            <a:off x="959665" y="1167276"/>
            <a:ext cx="1042416" cy="15544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4" name="TextBox 83">
            <a:extLst>
              <a:ext uri="{FF2B5EF4-FFF2-40B4-BE49-F238E27FC236}">
                <a16:creationId xmlns:a16="http://schemas.microsoft.com/office/drawing/2014/main" id="{46907438-93BD-1BB7-73D0-42587FA78A56}"/>
              </a:ext>
            </a:extLst>
          </p:cNvPr>
          <p:cNvSpPr txBox="1"/>
          <p:nvPr/>
        </p:nvSpPr>
        <p:spPr>
          <a:xfrm>
            <a:off x="312385" y="1121890"/>
            <a:ext cx="697628" cy="246221"/>
          </a:xfrm>
          <a:prstGeom prst="rect">
            <a:avLst/>
          </a:prstGeom>
          <a:noFill/>
        </p:spPr>
        <p:txBody>
          <a:bodyPr wrap="none" rtlCol="0" anchor="ctr" anchorCtr="0">
            <a:spAutoFit/>
          </a:bodyPr>
          <a:lstStyle/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lbumin</a:t>
            </a:r>
          </a:p>
        </p:txBody>
      </p:sp>
      <p:sp>
        <p:nvSpPr>
          <p:cNvPr id="15" name="TextBox 83">
            <a:extLst>
              <a:ext uri="{FF2B5EF4-FFF2-40B4-BE49-F238E27FC236}">
                <a16:creationId xmlns:a16="http://schemas.microsoft.com/office/drawing/2014/main" id="{330CE62C-3F93-475E-1991-04687F7380DF}"/>
              </a:ext>
            </a:extLst>
          </p:cNvPr>
          <p:cNvSpPr txBox="1"/>
          <p:nvPr/>
        </p:nvSpPr>
        <p:spPr>
          <a:xfrm>
            <a:off x="320401" y="2190628"/>
            <a:ext cx="689612" cy="246221"/>
          </a:xfrm>
          <a:prstGeom prst="rect">
            <a:avLst/>
          </a:prstGeom>
          <a:noFill/>
        </p:spPr>
        <p:txBody>
          <a:bodyPr wrap="none" rtlCol="0" anchor="ctr" anchorCtr="0">
            <a:spAutoFit/>
          </a:bodyPr>
          <a:lstStyle/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UGT1A1</a:t>
            </a:r>
          </a:p>
        </p:txBody>
      </p:sp>
      <p:pic>
        <p:nvPicPr>
          <p:cNvPr id="16" name="Picture 247">
            <a:extLst>
              <a:ext uri="{FF2B5EF4-FFF2-40B4-BE49-F238E27FC236}">
                <a16:creationId xmlns:a16="http://schemas.microsoft.com/office/drawing/2014/main" id="{4A4092D2-96F2-FA8F-E9AB-2569B80AAA70}"/>
              </a:ext>
            </a:extLst>
          </p:cNvPr>
          <p:cNvPicPr>
            <a:picLocks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37657" t="31967" r="42656" b="61641"/>
          <a:stretch/>
        </p:blipFill>
        <p:spPr>
          <a:xfrm>
            <a:off x="959665" y="2236014"/>
            <a:ext cx="1042416" cy="15544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7" name="Picture 250">
            <a:extLst>
              <a:ext uri="{FF2B5EF4-FFF2-40B4-BE49-F238E27FC236}">
                <a16:creationId xmlns:a16="http://schemas.microsoft.com/office/drawing/2014/main" id="{C2F012C9-F323-36DA-07F4-CEA68E0FBAF6}"/>
              </a:ext>
            </a:extLst>
          </p:cNvPr>
          <p:cNvPicPr>
            <a:picLocks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76" t="48111" r="36253" b="45198"/>
          <a:stretch/>
        </p:blipFill>
        <p:spPr>
          <a:xfrm>
            <a:off x="959665" y="2414135"/>
            <a:ext cx="1042416" cy="15544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0" name="TextBox 83">
            <a:extLst>
              <a:ext uri="{FF2B5EF4-FFF2-40B4-BE49-F238E27FC236}">
                <a16:creationId xmlns:a16="http://schemas.microsoft.com/office/drawing/2014/main" id="{1E5638A1-D88D-1784-8C3B-1B8361927869}"/>
              </a:ext>
            </a:extLst>
          </p:cNvPr>
          <p:cNvSpPr txBox="1"/>
          <p:nvPr/>
        </p:nvSpPr>
        <p:spPr>
          <a:xfrm>
            <a:off x="256281" y="2368749"/>
            <a:ext cx="753732" cy="246221"/>
          </a:xfrm>
          <a:prstGeom prst="rect">
            <a:avLst/>
          </a:prstGeom>
          <a:noFill/>
        </p:spPr>
        <p:txBody>
          <a:bodyPr wrap="none" rtlCol="0" anchor="ctr" anchorCtr="0">
            <a:spAutoFit/>
          </a:bodyPr>
          <a:lstStyle/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LUT1A1</a:t>
            </a:r>
          </a:p>
        </p:txBody>
      </p:sp>
      <p:sp>
        <p:nvSpPr>
          <p:cNvPr id="22" name="TextBox 83">
            <a:extLst>
              <a:ext uri="{FF2B5EF4-FFF2-40B4-BE49-F238E27FC236}">
                <a16:creationId xmlns:a16="http://schemas.microsoft.com/office/drawing/2014/main" id="{36E91FB9-4892-1F8E-353E-FF9EB925FD47}"/>
              </a:ext>
            </a:extLst>
          </p:cNvPr>
          <p:cNvSpPr txBox="1"/>
          <p:nvPr/>
        </p:nvSpPr>
        <p:spPr>
          <a:xfrm>
            <a:off x="560851" y="1300013"/>
            <a:ext cx="449162" cy="246221"/>
          </a:xfrm>
          <a:prstGeom prst="rect">
            <a:avLst/>
          </a:prstGeom>
          <a:noFill/>
        </p:spPr>
        <p:txBody>
          <a:bodyPr wrap="none" rtlCol="0" anchor="ctr" anchorCtr="0">
            <a:spAutoFit/>
          </a:bodyPr>
          <a:lstStyle/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AT</a:t>
            </a:r>
          </a:p>
        </p:txBody>
      </p:sp>
      <p:sp>
        <p:nvSpPr>
          <p:cNvPr id="23" name="TextBox 83">
            <a:extLst>
              <a:ext uri="{FF2B5EF4-FFF2-40B4-BE49-F238E27FC236}">
                <a16:creationId xmlns:a16="http://schemas.microsoft.com/office/drawing/2014/main" id="{8F56171D-F7BE-E561-DC43-A9B6735F84A4}"/>
              </a:ext>
            </a:extLst>
          </p:cNvPr>
          <p:cNvSpPr txBox="1"/>
          <p:nvPr/>
        </p:nvSpPr>
        <p:spPr>
          <a:xfrm>
            <a:off x="458259" y="2012505"/>
            <a:ext cx="551754" cy="246221"/>
          </a:xfrm>
          <a:prstGeom prst="rect">
            <a:avLst/>
          </a:prstGeom>
          <a:noFill/>
        </p:spPr>
        <p:txBody>
          <a:bodyPr wrap="none" rtlCol="0" anchor="ctr" anchorCtr="0">
            <a:spAutoFit/>
          </a:bodyPr>
          <a:lstStyle/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DH</a:t>
            </a:r>
            <a:r>
              <a:rPr lang="en-US" altLang="ja-JP" sz="1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Picture 258" descr="A picture containing chart&#10;&#10;Description automatically generated">
            <a:extLst>
              <a:ext uri="{FF2B5EF4-FFF2-40B4-BE49-F238E27FC236}">
                <a16:creationId xmlns:a16="http://schemas.microsoft.com/office/drawing/2014/main" id="{7158A9C9-E5E3-F9F3-6597-D9E12877E31C}"/>
              </a:ext>
            </a:extLst>
          </p:cNvPr>
          <p:cNvPicPr>
            <a:picLocks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94" t="36558" r="38742" b="56104"/>
          <a:stretch/>
        </p:blipFill>
        <p:spPr>
          <a:xfrm>
            <a:off x="959665" y="2057891"/>
            <a:ext cx="1042416" cy="15544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5" name="TextBox 83">
            <a:extLst>
              <a:ext uri="{FF2B5EF4-FFF2-40B4-BE49-F238E27FC236}">
                <a16:creationId xmlns:a16="http://schemas.microsoft.com/office/drawing/2014/main" id="{68F4F58B-8832-9843-D9CE-23AFF4B8F241}"/>
              </a:ext>
            </a:extLst>
          </p:cNvPr>
          <p:cNvSpPr txBox="1"/>
          <p:nvPr/>
        </p:nvSpPr>
        <p:spPr>
          <a:xfrm>
            <a:off x="554439" y="1478136"/>
            <a:ext cx="455574" cy="246221"/>
          </a:xfrm>
          <a:prstGeom prst="rect">
            <a:avLst/>
          </a:prstGeom>
          <a:noFill/>
        </p:spPr>
        <p:txBody>
          <a:bodyPr wrap="none" rtlCol="0" anchor="ctr" anchorCtr="0">
            <a:spAutoFit/>
          </a:bodyPr>
          <a:lstStyle/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TC</a:t>
            </a:r>
          </a:p>
        </p:txBody>
      </p:sp>
      <p:grpSp>
        <p:nvGrpSpPr>
          <p:cNvPr id="45" name="グループ化 44">
            <a:extLst>
              <a:ext uri="{FF2B5EF4-FFF2-40B4-BE49-F238E27FC236}">
                <a16:creationId xmlns:a16="http://schemas.microsoft.com/office/drawing/2014/main" id="{2DFEA9BC-4E4D-469F-F722-637BB01AF58C}"/>
              </a:ext>
            </a:extLst>
          </p:cNvPr>
          <p:cNvGrpSpPr/>
          <p:nvPr/>
        </p:nvGrpSpPr>
        <p:grpSpPr>
          <a:xfrm>
            <a:off x="1407659" y="390659"/>
            <a:ext cx="719624" cy="246221"/>
            <a:chOff x="1407659" y="390659"/>
            <a:chExt cx="719624" cy="246221"/>
          </a:xfrm>
        </p:grpSpPr>
        <p:sp>
          <p:nvSpPr>
            <p:cNvPr id="29" name="TextBox 51">
              <a:extLst>
                <a:ext uri="{FF2B5EF4-FFF2-40B4-BE49-F238E27FC236}">
                  <a16:creationId xmlns:a16="http://schemas.microsoft.com/office/drawing/2014/main" id="{0859BD14-4FA4-0795-E0EB-5AAE01B9CCD5}"/>
                </a:ext>
              </a:extLst>
            </p:cNvPr>
            <p:cNvSpPr txBox="1"/>
            <p:nvPr/>
          </p:nvSpPr>
          <p:spPr>
            <a:xfrm>
              <a:off x="1407659" y="390659"/>
              <a:ext cx="7196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Donor 2</a:t>
              </a:r>
              <a:endParaRPr lang="en-US" sz="1000" b="1" baseline="30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8" name="Straight Connector 51">
              <a:extLst>
                <a:ext uri="{FF2B5EF4-FFF2-40B4-BE49-F238E27FC236}">
                  <a16:creationId xmlns:a16="http://schemas.microsoft.com/office/drawing/2014/main" id="{5BD417B4-8375-6009-ED5A-2BFA8E28E7E7}"/>
                </a:ext>
              </a:extLst>
            </p:cNvPr>
            <p:cNvCxnSpPr>
              <a:cxnSpLocks/>
            </p:cNvCxnSpPr>
            <p:nvPr/>
          </p:nvCxnSpPr>
          <p:spPr>
            <a:xfrm>
              <a:off x="1532540" y="636880"/>
              <a:ext cx="46986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5" name="グループ化 54">
            <a:extLst>
              <a:ext uri="{FF2B5EF4-FFF2-40B4-BE49-F238E27FC236}">
                <a16:creationId xmlns:a16="http://schemas.microsoft.com/office/drawing/2014/main" id="{26809872-AEDA-55C9-D4EF-8B78CEE05A9F}"/>
              </a:ext>
            </a:extLst>
          </p:cNvPr>
          <p:cNvGrpSpPr/>
          <p:nvPr/>
        </p:nvGrpSpPr>
        <p:grpSpPr>
          <a:xfrm>
            <a:off x="826430" y="390659"/>
            <a:ext cx="719624" cy="246221"/>
            <a:chOff x="1407659" y="390659"/>
            <a:chExt cx="719624" cy="246221"/>
          </a:xfrm>
        </p:grpSpPr>
        <p:sp>
          <p:nvSpPr>
            <p:cNvPr id="56" name="TextBox 51">
              <a:extLst>
                <a:ext uri="{FF2B5EF4-FFF2-40B4-BE49-F238E27FC236}">
                  <a16:creationId xmlns:a16="http://schemas.microsoft.com/office/drawing/2014/main" id="{591B5E2C-071D-1FA3-516C-A23252F4EAE0}"/>
                </a:ext>
              </a:extLst>
            </p:cNvPr>
            <p:cNvSpPr txBox="1"/>
            <p:nvPr/>
          </p:nvSpPr>
          <p:spPr>
            <a:xfrm>
              <a:off x="1407659" y="390659"/>
              <a:ext cx="7196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Donor </a:t>
              </a:r>
              <a:r>
                <a:rPr lang="en-US" altLang="ja-JP" sz="1000" b="1" dirty="0">
                  <a:latin typeface="Arial" pitchFamily="34" charset="0"/>
                  <a:cs typeface="Arial" pitchFamily="34" charset="0"/>
                </a:rPr>
                <a:t>1</a:t>
              </a:r>
              <a:endParaRPr lang="en-US" sz="1000" b="1" baseline="30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8" name="Straight Connector 51">
              <a:extLst>
                <a:ext uri="{FF2B5EF4-FFF2-40B4-BE49-F238E27FC236}">
                  <a16:creationId xmlns:a16="http://schemas.microsoft.com/office/drawing/2014/main" id="{1E81D1DD-D381-72F3-3ABE-D9D10DA53938}"/>
                </a:ext>
              </a:extLst>
            </p:cNvPr>
            <p:cNvCxnSpPr>
              <a:cxnSpLocks/>
            </p:cNvCxnSpPr>
            <p:nvPr/>
          </p:nvCxnSpPr>
          <p:spPr>
            <a:xfrm>
              <a:off x="1532540" y="636880"/>
              <a:ext cx="46986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" name="Picture 2" descr="A black and white photo of a building&#10;&#10;Description automatically generated with low confidence">
            <a:extLst>
              <a:ext uri="{FF2B5EF4-FFF2-40B4-BE49-F238E27FC236}">
                <a16:creationId xmlns:a16="http://schemas.microsoft.com/office/drawing/2014/main" id="{A16858AB-8E93-7BAF-8E79-AE98E8A5C72A}"/>
              </a:ext>
            </a:extLst>
          </p:cNvPr>
          <p:cNvPicPr>
            <a:picLocks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552" t="16837" r="9693" b="63904"/>
          <a:stretch/>
        </p:blipFill>
        <p:spPr>
          <a:xfrm>
            <a:off x="959665" y="2592256"/>
            <a:ext cx="1042416" cy="15544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8" name="TextBox 79">
            <a:extLst>
              <a:ext uri="{FF2B5EF4-FFF2-40B4-BE49-F238E27FC236}">
                <a16:creationId xmlns:a16="http://schemas.microsoft.com/office/drawing/2014/main" id="{35991093-AFCF-2F1A-6BD6-85DAEAF37A4A}"/>
              </a:ext>
            </a:extLst>
          </p:cNvPr>
          <p:cNvSpPr txBox="1"/>
          <p:nvPr/>
        </p:nvSpPr>
        <p:spPr>
          <a:xfrm>
            <a:off x="503762" y="2546869"/>
            <a:ext cx="5062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BB</a:t>
            </a:r>
          </a:p>
        </p:txBody>
      </p:sp>
    </p:spTree>
    <p:extLst>
      <p:ext uri="{BB962C8B-B14F-4D97-AF65-F5344CB8AC3E}">
        <p14:creationId xmlns:p14="http://schemas.microsoft.com/office/powerpoint/2010/main" val="19096067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rgbClr val="868686"/>
        </a:solidFill>
        <a:ln w="12700" cap="flat">
          <a:solidFill>
            <a:schemeClr val="tx1"/>
          </a:solidFill>
          <a:prstDash val="solid"/>
          <a:bevel/>
          <a:headEnd/>
          <a:tailEnd/>
        </a:ln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>
          <a:defRPr sz="800">
            <a:latin typeface="Arial" pitchFamily="34" charset="0"/>
            <a:cs typeface="Arial" pitchFamily="34" charset="0"/>
          </a:defRPr>
        </a:defPPr>
      </a:lstStyle>
    </a:spDef>
    <a:lnDef>
      <a:spPr>
        <a:ln w="127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rtlCol="0">
        <a:spAutoFit/>
      </a:bodyPr>
      <a:lstStyle>
        <a:defPPr>
          <a:defRPr sz="1200" dirty="0">
            <a:latin typeface="Arial" pitchFamily="34" charset="0"/>
            <a:cs typeface="Arial" pitchFamily="34" charset="0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245</TotalTime>
  <Words>21</Words>
  <Application>Microsoft Office PowerPoint</Application>
  <PresentationFormat>ユーザー設定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プレゼンテーショ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akeshi Saito</dc:creator>
  <cp:lastModifiedBy>Sugahara Go</cp:lastModifiedBy>
  <cp:revision>135</cp:revision>
  <cp:lastPrinted>2013-07-30T20:19:09Z</cp:lastPrinted>
  <dcterms:created xsi:type="dcterms:W3CDTF">2013-05-03T19:48:35Z</dcterms:created>
  <dcterms:modified xsi:type="dcterms:W3CDTF">2022-12-09T06:05:39Z</dcterms:modified>
</cp:coreProperties>
</file>